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8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9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notesSlides/notesSlide1.xml" ContentType="application/vnd.openxmlformats-officedocument.presentationml.notesSlide+xml"/>
  <Override PartName="/ppt/charts/chart10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11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12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notesSlides/notesSlide2.xml" ContentType="application/vnd.openxmlformats-officedocument.presentationml.notesSlide+xml"/>
  <Override PartName="/ppt/charts/chart13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14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15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5" r:id="rId2"/>
    <p:sldId id="264" r:id="rId3"/>
    <p:sldId id="260" r:id="rId4"/>
    <p:sldId id="261" r:id="rId5"/>
    <p:sldId id="266" r:id="rId6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  <p15:guide id="3" pos="411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196" autoAdjust="0"/>
    <p:restoredTop sz="93441" autoAdjust="0"/>
  </p:normalViewPr>
  <p:slideViewPr>
    <p:cSldViewPr snapToGrid="0">
      <p:cViewPr varScale="1">
        <p:scale>
          <a:sx n="109" d="100"/>
          <a:sy n="109" d="100"/>
        </p:scale>
        <p:origin x="600" y="96"/>
      </p:cViewPr>
      <p:guideLst>
        <p:guide orient="horz" pos="2160"/>
        <p:guide pos="3840"/>
        <p:guide pos="411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Natalia\Desktop\MILTON\Gols2%20paper\Marker%20gene%20expression%252c2017Feb.xlsx" TargetMode="Externa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D:\dropbox\Dropbox\PLATFORMT%20BIOTECHNOLOGY\SHARED\Curinga%20GOLS2%20grphs%20for%20paper\TE%20trial\Aqua%20&amp;%20Meter\AquaPro%20Santa%20Rosa%202014-2015.xls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dropbox\Dropbox\PLATFORMT%20BIOTECHNOLOGY\SHARED\Curinga%20GOLS2%20grphs%20for%20paper\TE%20trial\Aqua%20&amp;%20Meter\AquaPro%20Santa%20Rosa%202013-%202014.xls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dropbox\Dropbox\PLATFORMT%20BIOTECHNOLOGY\SHARED\Curinga%20GOLS2%20grphs%20for%20paper\TE%20trial\Aqua%20&amp;%20Meter\AquaPro%20Santa%20Rosa%202012-2013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dropbox\Dropbox\PLATFORMT%20BIOTECHNOLOGY\SHARED\Curinga%20GOLS2%20grphs%20for%20paper\TE%20trial\Aqua%20&amp;%20Meter\AquaPro%20Santa%20Rosa%202013-%202014.xls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dropbox\Dropbox\PLATFORMT%20BIOTECHNOLOGY\SHARED\Curinga%20GOLS2%20grphs%20for%20paper\TE%20trial\Aqua%20&amp;%20Meter\AquaPro%20Santa%20Rosa%202014-2015.xls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ishizakitakuma:Desktop:GolS%20paper%20correlation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Natalia\Desktop\MILTON\Gols2%20paper\Marker%20gene%20expression%252c2017Feb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Natalia\Desktop\MILTON\Gols2%20paper\Marker%20gene%20expression%252c2017Feb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Natalia\Desktop\MILTON\Gols2%20paper\Marker%20gene%20expression%252c2017Feb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Natalia\Desktop\MILTON\Gols2%20paper\Marker%20gene%20expression%252c2017Feb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Natalia\Desktop\MILTON\Gols2%20paper\Marker%20gene%20expression%252c2017Feb.xlsx" TargetMode="Externa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D:\dropbox\Dropbox\PLATFORMT%20BIOTECHNOLOGY\SHARED\Curinga%20GOLS2%20grphs%20for%20paper\MDSE%20Trial\NRS%202014%20FEB-JUNE\NRS%202014%20FEB%20-%20Figure.xls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D:\dropbox\Dropbox\PLATFORMT%20BIOTECHNOLOGY\SHARED\Curinga%20GOLS2%20grphs%20for%20paper\MDSE%20Trial\NRS%20August%20-December,2012\NRS%20August%202012%20Drought%20experiment%20.xls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D:\dropbox\Dropbox\PLATFORMT%20BIOTECHNOLOGY\SHARED\Curinga%20GOLS2%20grphs%20for%20paper\MDSE%20Trial\NRS%20March-July%202012\SoilMoistureGraph%20(2).xls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layout>
        <c:manualLayout>
          <c:xMode val="edge"/>
          <c:yMode val="edge"/>
          <c:x val="0.17066046711361699"/>
          <c:y val="4.8073210128309299E-2"/>
        </c:manualLayout>
      </c:layout>
      <c:overlay val="0"/>
      <c:txPr>
        <a:bodyPr/>
        <a:lstStyle/>
        <a:p>
          <a:pPr>
            <a:defRPr lang="ja-JP" sz="1100"/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6784415513902001"/>
          <c:y val="4.9171218656312098E-2"/>
          <c:w val="0.80489848263426"/>
          <c:h val="0.455033440053562"/>
        </c:manualLayout>
      </c:layout>
      <c:barChart>
        <c:barDir val="col"/>
        <c:grouping val="clustered"/>
        <c:varyColors val="0"/>
        <c:ser>
          <c:idx val="0"/>
          <c:order val="0"/>
          <c:tx>
            <c:v>LEA3</c:v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>
                  <a:alpha val="50000"/>
                </a:schemeClr>
              </a:solidFill>
            </a:ln>
          </c:spPr>
          <c:invertIfNegative val="0"/>
          <c:dLbls>
            <c:dLbl>
              <c:idx val="6"/>
              <c:layout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wrap="square" lIns="38100" tIns="19050" rIns="38100" bIns="19050" anchor="ctr">
                <a:spAutoFit/>
              </a:bodyPr>
              <a:lstStyle/>
              <a:p>
                <a:pPr>
                  <a:defRPr lang="ja-JP"/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[Marker gene expression%2c2017Feb.xlsx]Results2'!$F$8:$F$21</c:f>
                <c:numCache>
                  <c:formatCode>General</c:formatCode>
                  <c:ptCount val="14"/>
                  <c:pt idx="0">
                    <c:v>0</c:v>
                  </c:pt>
                  <c:pt idx="1">
                    <c:v>2.204205640611784</c:v>
                  </c:pt>
                  <c:pt idx="2">
                    <c:v>0</c:v>
                  </c:pt>
                  <c:pt idx="3">
                    <c:v>3.2209436323449849</c:v>
                  </c:pt>
                  <c:pt idx="4">
                    <c:v>0</c:v>
                  </c:pt>
                  <c:pt idx="5">
                    <c:v>0</c:v>
                  </c:pt>
                  <c:pt idx="6">
                    <c:v>1.7320508075688781</c:v>
                  </c:pt>
                  <c:pt idx="7">
                    <c:v>0</c:v>
                  </c:pt>
                  <c:pt idx="8">
                    <c:v>2.3592203290066118</c:v>
                  </c:pt>
                  <c:pt idx="9">
                    <c:v>2.21422259043938</c:v>
                  </c:pt>
                  <c:pt idx="10">
                    <c:v>3.3181551040274742</c:v>
                  </c:pt>
                  <c:pt idx="11">
                    <c:v>0</c:v>
                  </c:pt>
                  <c:pt idx="12">
                    <c:v>0</c:v>
                  </c:pt>
                  <c:pt idx="13">
                    <c:v>1.262040985905988</c:v>
                  </c:pt>
                </c:numCache>
              </c:numRef>
            </c:plus>
            <c:minus>
              <c:numRef>
                <c:f>'[Marker gene expression%2c2017Feb.xlsx]Results2'!$F$8:$F$21</c:f>
                <c:numCache>
                  <c:formatCode>General</c:formatCode>
                  <c:ptCount val="14"/>
                  <c:pt idx="0">
                    <c:v>0</c:v>
                  </c:pt>
                  <c:pt idx="1">
                    <c:v>2.204205640611784</c:v>
                  </c:pt>
                  <c:pt idx="2">
                    <c:v>0</c:v>
                  </c:pt>
                  <c:pt idx="3">
                    <c:v>3.2209436323449849</c:v>
                  </c:pt>
                  <c:pt idx="4">
                    <c:v>0</c:v>
                  </c:pt>
                  <c:pt idx="5">
                    <c:v>0</c:v>
                  </c:pt>
                  <c:pt idx="6">
                    <c:v>1.7320508075688781</c:v>
                  </c:pt>
                  <c:pt idx="7">
                    <c:v>0</c:v>
                  </c:pt>
                  <c:pt idx="8">
                    <c:v>2.3592203290066118</c:v>
                  </c:pt>
                  <c:pt idx="9">
                    <c:v>2.21422259043938</c:v>
                  </c:pt>
                  <c:pt idx="10">
                    <c:v>3.3181551040274742</c:v>
                  </c:pt>
                  <c:pt idx="11">
                    <c:v>0</c:v>
                  </c:pt>
                  <c:pt idx="12">
                    <c:v>0</c:v>
                  </c:pt>
                  <c:pt idx="13">
                    <c:v>1.262040985905988</c:v>
                  </c:pt>
                </c:numCache>
              </c:numRef>
            </c:minus>
          </c:errBars>
          <c:cat>
            <c:multiLvlStrRef>
              <c:f>'[Marker gene expression%2c2017Feb.xlsx]Results2'!$B$8:$D$21</c:f>
              <c:multiLvlStrCache>
                <c:ptCount val="14"/>
                <c:lvl>
                  <c:pt idx="0">
                    <c:v>2580</c:v>
                  </c:pt>
                  <c:pt idx="1">
                    <c:v>2590</c:v>
                  </c:pt>
                  <c:pt idx="2">
                    <c:v>2783</c:v>
                  </c:pt>
                  <c:pt idx="3">
                    <c:v>3020</c:v>
                  </c:pt>
                  <c:pt idx="4">
                    <c:v>3025</c:v>
                  </c:pt>
                  <c:pt idx="5">
                    <c:v>3214</c:v>
                  </c:pt>
                  <c:pt idx="6">
                    <c:v>NT</c:v>
                  </c:pt>
                  <c:pt idx="7">
                    <c:v>1575</c:v>
                  </c:pt>
                  <c:pt idx="8">
                    <c:v>1577</c:v>
                  </c:pt>
                  <c:pt idx="9">
                    <c:v>2054</c:v>
                  </c:pt>
                  <c:pt idx="10">
                    <c:v>2344</c:v>
                  </c:pt>
                  <c:pt idx="11">
                    <c:v>2361</c:v>
                  </c:pt>
                  <c:pt idx="12">
                    <c:v>2362</c:v>
                  </c:pt>
                  <c:pt idx="13">
                    <c:v>NT</c:v>
                  </c:pt>
                </c:lvl>
                <c:lvl>
                  <c:pt idx="0">
                    <c:v>Curinga</c:v>
                  </c:pt>
                  <c:pt idx="7">
                    <c:v>NERICA4</c:v>
                  </c:pt>
                </c:lvl>
                <c:lvl>
                  <c:pt idx="0">
                    <c:v>Well-watered</c:v>
                  </c:pt>
                </c:lvl>
              </c:multiLvlStrCache>
            </c:multiLvlStrRef>
          </c:cat>
          <c:val>
            <c:numRef>
              <c:f>'[Marker gene expression%2c2017Feb.xlsx]Results2'!$E$8:$E$21</c:f>
              <c:numCache>
                <c:formatCode>#,#00</c:formatCode>
                <c:ptCount val="14"/>
                <c:pt idx="0">
                  <c:v>0</c:v>
                </c:pt>
                <c:pt idx="1">
                  <c:v>1.272598719956505</c:v>
                </c:pt>
                <c:pt idx="2">
                  <c:v>0</c:v>
                </c:pt>
                <c:pt idx="3">
                  <c:v>1.8596126731789879</c:v>
                </c:pt>
                <c:pt idx="4">
                  <c:v>0</c:v>
                </c:pt>
                <c:pt idx="5">
                  <c:v>0</c:v>
                </c:pt>
                <c:pt idx="6">
                  <c:v>1</c:v>
                </c:pt>
                <c:pt idx="7">
                  <c:v>0</c:v>
                </c:pt>
                <c:pt idx="8">
                  <c:v>2.3361344539689788</c:v>
                </c:pt>
                <c:pt idx="9">
                  <c:v>2.408568805119994</c:v>
                </c:pt>
                <c:pt idx="10">
                  <c:v>3.7089729352223162</c:v>
                </c:pt>
                <c:pt idx="11">
                  <c:v>0</c:v>
                </c:pt>
                <c:pt idx="12">
                  <c:v>0</c:v>
                </c:pt>
                <c:pt idx="13">
                  <c:v>1.345695608343858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16929152"/>
        <c:axId val="316933632"/>
      </c:barChart>
      <c:catAx>
        <c:axId val="31692915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en-US"/>
          </a:p>
        </c:txPr>
        <c:crossAx val="316933632"/>
        <c:crossesAt val="0"/>
        <c:auto val="1"/>
        <c:lblAlgn val="ctr"/>
        <c:lblOffset val="100"/>
        <c:noMultiLvlLbl val="0"/>
      </c:catAx>
      <c:valAx>
        <c:axId val="316933632"/>
        <c:scaling>
          <c:orientation val="minMax"/>
          <c:max val="120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ja-JP"/>
                </a:pPr>
                <a:r>
                  <a:rPr lang="en-US"/>
                  <a:t>Relative mRNA level</a:t>
                </a:r>
                <a:endParaRPr lang="ja-JP"/>
              </a:p>
            </c:rich>
          </c:tx>
          <c:layout>
            <c:manualLayout>
              <c:xMode val="edge"/>
              <c:yMode val="edge"/>
              <c:x val="3.6205657705597603E-2"/>
              <c:y val="2.4840072326225301E-2"/>
            </c:manualLayout>
          </c:layout>
          <c:overlay val="0"/>
        </c:title>
        <c:numFmt formatCode="#,##0_);[Red]\(#,##0\)" sourceLinked="0"/>
        <c:majorTickMark val="out"/>
        <c:minorTickMark val="none"/>
        <c:tickLblPos val="nextTo"/>
        <c:txPr>
          <a:bodyPr/>
          <a:lstStyle/>
          <a:p>
            <a:pPr>
              <a:defRPr lang="ja-JP" sz="1000"/>
            </a:pPr>
            <a:endParaRPr lang="en-US"/>
          </a:p>
        </c:txPr>
        <c:crossAx val="316929152"/>
        <c:crosses val="autoZero"/>
        <c:crossBetween val="between"/>
        <c:majorUnit val="200"/>
        <c:minorUnit val="40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txPr>
    <a:bodyPr/>
    <a:lstStyle/>
    <a:p>
      <a:pPr>
        <a:defRPr sz="1050" b="1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9195581208260896E-2"/>
          <c:y val="4.1984177131558498E-2"/>
          <c:w val="0.77692354884706305"/>
          <c:h val="0.73246063446718601"/>
        </c:manualLayout>
      </c:layout>
      <c:lineChart>
        <c:grouping val="standard"/>
        <c:varyColors val="0"/>
        <c:ser>
          <c:idx val="1"/>
          <c:order val="0"/>
          <c:tx>
            <c:strRef>
              <c:f>CURINGA!$D$279</c:f>
              <c:strCache>
                <c:ptCount val="1"/>
                <c:pt idx="0">
                  <c:v>20 cm</c:v>
                </c:pt>
              </c:strCache>
            </c:strRef>
          </c:tx>
          <c:spPr>
            <a:ln w="12700" cap="rnd" cmpd="sng" algn="ctr">
              <a:solidFill>
                <a:schemeClr val="tx1"/>
              </a:solidFill>
              <a:prstDash val="lgDashDot"/>
              <a:round/>
            </a:ln>
            <a:effectLst/>
          </c:spPr>
          <c:marker>
            <c:symbol val="none"/>
          </c:marker>
          <c:cat>
            <c:numRef>
              <c:f>CURINGA!$C$280:$C$307</c:f>
              <c:numCache>
                <c:formatCode>General</c:formatCode>
                <c:ptCount val="28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 formatCode="0">
                  <c:v>58.464236111110949</c:v>
                </c:pt>
                <c:pt idx="12" formatCode="0">
                  <c:v>63.396203703705403</c:v>
                </c:pt>
                <c:pt idx="13" formatCode="0">
                  <c:v>66.389687499999113</c:v>
                </c:pt>
                <c:pt idx="14" formatCode="0">
                  <c:v>70.406145833330811</c:v>
                </c:pt>
                <c:pt idx="15" formatCode="0">
                  <c:v>73.392314814816899</c:v>
                </c:pt>
                <c:pt idx="16" formatCode="0">
                  <c:v>77.362638888887858</c:v>
                </c:pt>
                <c:pt idx="17" formatCode="0">
                  <c:v>80.365902777775744</c:v>
                </c:pt>
                <c:pt idx="18" formatCode="0">
                  <c:v>83.35519675925751</c:v>
                </c:pt>
                <c:pt idx="19" formatCode="0">
                  <c:v>86.37549768518511</c:v>
                </c:pt>
                <c:pt idx="20" formatCode="0">
                  <c:v>90.375092592592353</c:v>
                </c:pt>
                <c:pt idx="21" formatCode="0">
                  <c:v>93.365335648144509</c:v>
                </c:pt>
                <c:pt idx="22">
                  <c:v>100</c:v>
                </c:pt>
                <c:pt idx="23">
                  <c:v>105</c:v>
                </c:pt>
                <c:pt idx="24">
                  <c:v>110</c:v>
                </c:pt>
                <c:pt idx="25">
                  <c:v>115</c:v>
                </c:pt>
                <c:pt idx="26">
                  <c:v>120</c:v>
                </c:pt>
                <c:pt idx="27">
                  <c:v>125</c:v>
                </c:pt>
              </c:numCache>
            </c:numRef>
          </c:cat>
          <c:val>
            <c:numRef>
              <c:f>CURINGA!$D$280:$D$307</c:f>
              <c:numCache>
                <c:formatCode>General</c:formatCode>
                <c:ptCount val="28"/>
                <c:pt idx="11">
                  <c:v>74.61904761904762</c:v>
                </c:pt>
                <c:pt idx="12">
                  <c:v>59.619047619047592</c:v>
                </c:pt>
                <c:pt idx="13">
                  <c:v>50.38095238095238</c:v>
                </c:pt>
                <c:pt idx="14">
                  <c:v>66.523809523809504</c:v>
                </c:pt>
                <c:pt idx="15">
                  <c:v>53.714285714285722</c:v>
                </c:pt>
                <c:pt idx="16">
                  <c:v>44.428571428571431</c:v>
                </c:pt>
                <c:pt idx="17">
                  <c:v>43.142857142857153</c:v>
                </c:pt>
                <c:pt idx="18">
                  <c:v>45.80952380952381</c:v>
                </c:pt>
                <c:pt idx="19">
                  <c:v>33.80952380952381</c:v>
                </c:pt>
                <c:pt idx="20">
                  <c:v>26.61904761904762</c:v>
                </c:pt>
                <c:pt idx="21">
                  <c:v>28.76190476190477</c:v>
                </c:pt>
              </c:numCache>
            </c:numRef>
          </c:val>
          <c:smooth val="0"/>
        </c:ser>
        <c:ser>
          <c:idx val="2"/>
          <c:order val="1"/>
          <c:tx>
            <c:strRef>
              <c:f>CURINGA!$E$279</c:f>
              <c:strCache>
                <c:ptCount val="1"/>
                <c:pt idx="0">
                  <c:v>40 cm</c:v>
                </c:pt>
              </c:strCache>
            </c:strRef>
          </c:tx>
          <c:spPr>
            <a:ln w="12700" cap="rnd" cmpd="sng" algn="ctr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none"/>
          </c:marker>
          <c:cat>
            <c:numRef>
              <c:f>CURINGA!$C$280:$C$307</c:f>
              <c:numCache>
                <c:formatCode>General</c:formatCode>
                <c:ptCount val="28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 formatCode="0">
                  <c:v>58.464236111110949</c:v>
                </c:pt>
                <c:pt idx="12" formatCode="0">
                  <c:v>63.396203703705403</c:v>
                </c:pt>
                <c:pt idx="13" formatCode="0">
                  <c:v>66.389687499999113</c:v>
                </c:pt>
                <c:pt idx="14" formatCode="0">
                  <c:v>70.406145833330811</c:v>
                </c:pt>
                <c:pt idx="15" formatCode="0">
                  <c:v>73.392314814816899</c:v>
                </c:pt>
                <c:pt idx="16" formatCode="0">
                  <c:v>77.362638888887858</c:v>
                </c:pt>
                <c:pt idx="17" formatCode="0">
                  <c:v>80.365902777775744</c:v>
                </c:pt>
                <c:pt idx="18" formatCode="0">
                  <c:v>83.35519675925751</c:v>
                </c:pt>
                <c:pt idx="19" formatCode="0">
                  <c:v>86.37549768518511</c:v>
                </c:pt>
                <c:pt idx="20" formatCode="0">
                  <c:v>90.375092592592353</c:v>
                </c:pt>
                <c:pt idx="21" formatCode="0">
                  <c:v>93.365335648144509</c:v>
                </c:pt>
                <c:pt idx="22">
                  <c:v>100</c:v>
                </c:pt>
                <c:pt idx="23">
                  <c:v>105</c:v>
                </c:pt>
                <c:pt idx="24">
                  <c:v>110</c:v>
                </c:pt>
                <c:pt idx="25">
                  <c:v>115</c:v>
                </c:pt>
                <c:pt idx="26">
                  <c:v>120</c:v>
                </c:pt>
                <c:pt idx="27">
                  <c:v>125</c:v>
                </c:pt>
              </c:numCache>
            </c:numRef>
          </c:cat>
          <c:val>
            <c:numRef>
              <c:f>CURINGA!$E$280:$E$307</c:f>
              <c:numCache>
                <c:formatCode>General</c:formatCode>
                <c:ptCount val="28"/>
                <c:pt idx="11">
                  <c:v>81</c:v>
                </c:pt>
                <c:pt idx="12">
                  <c:v>74.095238095238102</c:v>
                </c:pt>
                <c:pt idx="13">
                  <c:v>72.047619047619094</c:v>
                </c:pt>
                <c:pt idx="14">
                  <c:v>74.80952380952381</c:v>
                </c:pt>
                <c:pt idx="15">
                  <c:v>67.523809523809504</c:v>
                </c:pt>
                <c:pt idx="16">
                  <c:v>67.095238095238102</c:v>
                </c:pt>
                <c:pt idx="17">
                  <c:v>71.3333333333333</c:v>
                </c:pt>
                <c:pt idx="18">
                  <c:v>71.61904761904762</c:v>
                </c:pt>
                <c:pt idx="19">
                  <c:v>63.38095238095238</c:v>
                </c:pt>
                <c:pt idx="20">
                  <c:v>59.333333333333343</c:v>
                </c:pt>
                <c:pt idx="21">
                  <c:v>57.523809523809533</c:v>
                </c:pt>
              </c:numCache>
            </c:numRef>
          </c:val>
          <c:smooth val="0"/>
        </c:ser>
        <c:ser>
          <c:idx val="3"/>
          <c:order val="2"/>
          <c:tx>
            <c:strRef>
              <c:f>CURINGA!$F$279</c:f>
              <c:strCache>
                <c:ptCount val="1"/>
                <c:pt idx="0">
                  <c:v>60 cm</c:v>
                </c:pt>
              </c:strCache>
            </c:strRef>
          </c:tx>
          <c:spPr>
            <a:ln w="12700" cap="rnd" cmpd="sng" algn="ctr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CURINGA!$C$280:$C$307</c:f>
              <c:numCache>
                <c:formatCode>General</c:formatCode>
                <c:ptCount val="28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 formatCode="0">
                  <c:v>58.464236111110949</c:v>
                </c:pt>
                <c:pt idx="12" formatCode="0">
                  <c:v>63.396203703705403</c:v>
                </c:pt>
                <c:pt idx="13" formatCode="0">
                  <c:v>66.389687499999113</c:v>
                </c:pt>
                <c:pt idx="14" formatCode="0">
                  <c:v>70.406145833330811</c:v>
                </c:pt>
                <c:pt idx="15" formatCode="0">
                  <c:v>73.392314814816899</c:v>
                </c:pt>
                <c:pt idx="16" formatCode="0">
                  <c:v>77.362638888887858</c:v>
                </c:pt>
                <c:pt idx="17" formatCode="0">
                  <c:v>80.365902777775744</c:v>
                </c:pt>
                <c:pt idx="18" formatCode="0">
                  <c:v>83.35519675925751</c:v>
                </c:pt>
                <c:pt idx="19" formatCode="0">
                  <c:v>86.37549768518511</c:v>
                </c:pt>
                <c:pt idx="20" formatCode="0">
                  <c:v>90.375092592592353</c:v>
                </c:pt>
                <c:pt idx="21" formatCode="0">
                  <c:v>93.365335648144509</c:v>
                </c:pt>
                <c:pt idx="22">
                  <c:v>100</c:v>
                </c:pt>
                <c:pt idx="23">
                  <c:v>105</c:v>
                </c:pt>
                <c:pt idx="24">
                  <c:v>110</c:v>
                </c:pt>
                <c:pt idx="25">
                  <c:v>115</c:v>
                </c:pt>
                <c:pt idx="26">
                  <c:v>120</c:v>
                </c:pt>
                <c:pt idx="27">
                  <c:v>125</c:v>
                </c:pt>
              </c:numCache>
            </c:numRef>
          </c:cat>
          <c:val>
            <c:numRef>
              <c:f>CURINGA!$F$280:$F$307</c:f>
              <c:numCache>
                <c:formatCode>General</c:formatCode>
                <c:ptCount val="28"/>
                <c:pt idx="11">
                  <c:v>80.571428571428541</c:v>
                </c:pt>
                <c:pt idx="12">
                  <c:v>77.190476190476133</c:v>
                </c:pt>
                <c:pt idx="13">
                  <c:v>78.190476190476133</c:v>
                </c:pt>
                <c:pt idx="14">
                  <c:v>77.857142857142847</c:v>
                </c:pt>
                <c:pt idx="15">
                  <c:v>77.904761904761898</c:v>
                </c:pt>
                <c:pt idx="16">
                  <c:v>75.095238095238102</c:v>
                </c:pt>
                <c:pt idx="17">
                  <c:v>76.3333333333333</c:v>
                </c:pt>
                <c:pt idx="18">
                  <c:v>77.38095238095238</c:v>
                </c:pt>
                <c:pt idx="19">
                  <c:v>69.142857142857096</c:v>
                </c:pt>
                <c:pt idx="20">
                  <c:v>67.761904761904802</c:v>
                </c:pt>
                <c:pt idx="21">
                  <c:v>68.904761904761898</c:v>
                </c:pt>
              </c:numCache>
            </c:numRef>
          </c:val>
          <c:smooth val="0"/>
        </c:ser>
        <c:ser>
          <c:idx val="4"/>
          <c:order val="3"/>
          <c:tx>
            <c:strRef>
              <c:f>CURINGA!$G$279</c:f>
              <c:strCache>
                <c:ptCount val="1"/>
                <c:pt idx="0">
                  <c:v>80 cm</c:v>
                </c:pt>
              </c:strCache>
            </c:strRef>
          </c:tx>
          <c:spPr>
            <a:ln w="12700" cap="rnd" cmpd="sng" algn="ctr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none"/>
          </c:marker>
          <c:cat>
            <c:numRef>
              <c:f>CURINGA!$C$280:$C$307</c:f>
              <c:numCache>
                <c:formatCode>General</c:formatCode>
                <c:ptCount val="28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 formatCode="0">
                  <c:v>58.464236111110949</c:v>
                </c:pt>
                <c:pt idx="12" formatCode="0">
                  <c:v>63.396203703705403</c:v>
                </c:pt>
                <c:pt idx="13" formatCode="0">
                  <c:v>66.389687499999113</c:v>
                </c:pt>
                <c:pt idx="14" formatCode="0">
                  <c:v>70.406145833330811</c:v>
                </c:pt>
                <c:pt idx="15" formatCode="0">
                  <c:v>73.392314814816899</c:v>
                </c:pt>
                <c:pt idx="16" formatCode="0">
                  <c:v>77.362638888887858</c:v>
                </c:pt>
                <c:pt idx="17" formatCode="0">
                  <c:v>80.365902777775744</c:v>
                </c:pt>
                <c:pt idx="18" formatCode="0">
                  <c:v>83.35519675925751</c:v>
                </c:pt>
                <c:pt idx="19" formatCode="0">
                  <c:v>86.37549768518511</c:v>
                </c:pt>
                <c:pt idx="20" formatCode="0">
                  <c:v>90.375092592592353</c:v>
                </c:pt>
                <c:pt idx="21" formatCode="0">
                  <c:v>93.365335648144509</c:v>
                </c:pt>
                <c:pt idx="22">
                  <c:v>100</c:v>
                </c:pt>
                <c:pt idx="23">
                  <c:v>105</c:v>
                </c:pt>
                <c:pt idx="24">
                  <c:v>110</c:v>
                </c:pt>
                <c:pt idx="25">
                  <c:v>115</c:v>
                </c:pt>
                <c:pt idx="26">
                  <c:v>120</c:v>
                </c:pt>
                <c:pt idx="27">
                  <c:v>125</c:v>
                </c:pt>
              </c:numCache>
            </c:numRef>
          </c:cat>
          <c:val>
            <c:numRef>
              <c:f>CURINGA!$G$280:$G$307</c:f>
              <c:numCache>
                <c:formatCode>General</c:formatCode>
                <c:ptCount val="28"/>
                <c:pt idx="11">
                  <c:v>79.599999999999994</c:v>
                </c:pt>
                <c:pt idx="12">
                  <c:v>76.25</c:v>
                </c:pt>
                <c:pt idx="13">
                  <c:v>77.8</c:v>
                </c:pt>
                <c:pt idx="14">
                  <c:v>77</c:v>
                </c:pt>
                <c:pt idx="15">
                  <c:v>76.75</c:v>
                </c:pt>
                <c:pt idx="16">
                  <c:v>76</c:v>
                </c:pt>
                <c:pt idx="17">
                  <c:v>77.099999999999994</c:v>
                </c:pt>
                <c:pt idx="18">
                  <c:v>76.05</c:v>
                </c:pt>
                <c:pt idx="19">
                  <c:v>70.05</c:v>
                </c:pt>
                <c:pt idx="20">
                  <c:v>67.05</c:v>
                </c:pt>
                <c:pt idx="21">
                  <c:v>67.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dropLines>
          <c:spPr>
            <a:ln w="12700" cap="flat" cmpd="sng" algn="ctr">
              <a:solidFill>
                <a:schemeClr val="tx1">
                  <a:alpha val="33000"/>
                </a:schemeClr>
              </a:solidFill>
              <a:prstDash val="sysDot"/>
              <a:round/>
            </a:ln>
            <a:effectLst/>
          </c:spPr>
        </c:dropLines>
        <c:smooth val="0"/>
        <c:axId val="325978544"/>
        <c:axId val="325978936"/>
      </c:lineChart>
      <c:dateAx>
        <c:axId val="325978544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1100" b="1" i="0" u="none" strike="noStrike" kern="1200" cap="all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CO" sz="1100" dirty="0" err="1" smtClean="0"/>
                  <a:t>Days</a:t>
                </a:r>
                <a:r>
                  <a:rPr lang="es-CO" sz="1100" dirty="0" smtClean="0"/>
                  <a:t> </a:t>
                </a:r>
                <a:r>
                  <a:rPr lang="es-CO" sz="1100" dirty="0" err="1" smtClean="0"/>
                  <a:t>After</a:t>
                </a:r>
                <a:r>
                  <a:rPr lang="es-CO" sz="1100" dirty="0" smtClean="0"/>
                  <a:t> </a:t>
                </a:r>
                <a:r>
                  <a:rPr lang="es-CO" sz="1100" dirty="0" err="1" smtClean="0"/>
                  <a:t>Sowing</a:t>
                </a:r>
                <a:endParaRPr lang="es-CO" sz="1100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1100" b="1" i="0" u="none" strike="noStrike" kern="1200" cap="all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1" i="0" u="none" strike="noStrike" kern="1200" spc="2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25978936"/>
        <c:crosses val="autoZero"/>
        <c:auto val="0"/>
        <c:lblOffset val="100"/>
        <c:baseTimeUnit val="days"/>
        <c:majorUnit val="10"/>
        <c:majorTimeUnit val="days"/>
      </c:dateAx>
      <c:valAx>
        <c:axId val="32597893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197" b="1" i="0" u="none" strike="noStrike" kern="1200" cap="all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CO" dirty="0" err="1" smtClean="0"/>
                  <a:t>Moisture</a:t>
                </a:r>
                <a:r>
                  <a:rPr lang="es-CO" dirty="0" smtClean="0"/>
                  <a:t> (%)</a:t>
                </a:r>
                <a:endParaRPr lang="es-CO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197" b="1" i="0" u="none" strike="noStrike" kern="1200" cap="all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1" i="0" u="none" strike="noStrike" kern="1200" spc="2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25978544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85612605668157205"/>
          <c:y val="0.117226314452629"/>
          <c:w val="0.12972878300166299"/>
          <c:h val="0.56825755651511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197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lt1"/>
    </a:solidFill>
    <a:ln>
      <a:noFill/>
    </a:ln>
    <a:effectLst/>
  </c:spPr>
  <c:txPr>
    <a:bodyPr/>
    <a:lstStyle/>
    <a:p>
      <a:pPr>
        <a:defRPr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7001606317263502E-2"/>
          <c:y val="0.138022540983607"/>
          <c:w val="0.76167647258428695"/>
          <c:h val="0.671925047288777"/>
        </c:manualLayout>
      </c:layout>
      <c:lineChart>
        <c:grouping val="standard"/>
        <c:varyColors val="0"/>
        <c:ser>
          <c:idx val="1"/>
          <c:order val="0"/>
          <c:tx>
            <c:strRef>
              <c:f>Curinga!$B$50</c:f>
              <c:strCache>
                <c:ptCount val="1"/>
                <c:pt idx="0">
                  <c:v>20 cm </c:v>
                </c:pt>
              </c:strCache>
            </c:strRef>
          </c:tx>
          <c:spPr>
            <a:ln w="12700" cap="rnd" cmpd="sng" algn="ctr">
              <a:solidFill>
                <a:schemeClr val="tx1"/>
              </a:solidFill>
              <a:prstDash val="lgDashDot"/>
              <a:round/>
            </a:ln>
            <a:effectLst/>
          </c:spPr>
          <c:marker>
            <c:symbol val="none"/>
          </c:marker>
          <c:cat>
            <c:numRef>
              <c:f>Curinga!$A$51:$A$78</c:f>
              <c:numCache>
                <c:formatCode>General</c:formatCode>
                <c:ptCount val="28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 formatCode="0">
                  <c:v>59.382060185183953</c:v>
                </c:pt>
                <c:pt idx="11" formatCode="0">
                  <c:v>62.40296296296583</c:v>
                </c:pt>
                <c:pt idx="12" formatCode="0">
                  <c:v>66.360243055554719</c:v>
                </c:pt>
                <c:pt idx="13" formatCode="0">
                  <c:v>70.352581018516446</c:v>
                </c:pt>
                <c:pt idx="14" formatCode="0">
                  <c:v>73.360300925924079</c:v>
                </c:pt>
                <c:pt idx="15" formatCode="0">
                  <c:v>77.350682870368445</c:v>
                </c:pt>
                <c:pt idx="16" formatCode="0">
                  <c:v>80.341898148144509</c:v>
                </c:pt>
                <c:pt idx="17" formatCode="0">
                  <c:v>84.353344907409294</c:v>
                </c:pt>
                <c:pt idx="18" formatCode="0">
                  <c:v>87.344131944446417</c:v>
                </c:pt>
                <c:pt idx="19" formatCode="0">
                  <c:v>91.352627314816317</c:v>
                </c:pt>
                <c:pt idx="20" formatCode="0">
                  <c:v>94.367372685184804</c:v>
                </c:pt>
                <c:pt idx="21" formatCode="0">
                  <c:v>97.844282407408173</c:v>
                </c:pt>
                <c:pt idx="22" formatCode="0">
                  <c:v>100</c:v>
                </c:pt>
                <c:pt idx="23" formatCode="0">
                  <c:v>105</c:v>
                </c:pt>
                <c:pt idx="24" formatCode="0">
                  <c:v>110</c:v>
                </c:pt>
                <c:pt idx="25" formatCode="0">
                  <c:v>115</c:v>
                </c:pt>
                <c:pt idx="26" formatCode="0">
                  <c:v>120</c:v>
                </c:pt>
                <c:pt idx="27" formatCode="0">
                  <c:v>125</c:v>
                </c:pt>
              </c:numCache>
            </c:numRef>
          </c:cat>
          <c:val>
            <c:numRef>
              <c:f>Curinga!$B$51:$B$78</c:f>
              <c:numCache>
                <c:formatCode>General</c:formatCode>
                <c:ptCount val="28"/>
                <c:pt idx="10">
                  <c:v>60</c:v>
                </c:pt>
                <c:pt idx="11">
                  <c:v>53.083333333333343</c:v>
                </c:pt>
                <c:pt idx="12">
                  <c:v>44</c:v>
                </c:pt>
                <c:pt idx="13">
                  <c:v>37.333333333333343</c:v>
                </c:pt>
                <c:pt idx="14">
                  <c:v>34.666666666666643</c:v>
                </c:pt>
                <c:pt idx="15">
                  <c:v>30.791666666666671</c:v>
                </c:pt>
                <c:pt idx="16">
                  <c:v>26.333333333333311</c:v>
                </c:pt>
                <c:pt idx="17">
                  <c:v>24.75</c:v>
                </c:pt>
                <c:pt idx="18">
                  <c:v>22.791666666666671</c:v>
                </c:pt>
                <c:pt idx="19">
                  <c:v>22.125</c:v>
                </c:pt>
                <c:pt idx="20">
                  <c:v>68.0416666666667</c:v>
                </c:pt>
                <c:pt idx="21">
                  <c:v>60</c:v>
                </c:pt>
                <c:pt idx="22">
                  <c:v>55</c:v>
                </c:pt>
              </c:numCache>
            </c:numRef>
          </c:val>
          <c:smooth val="0"/>
        </c:ser>
        <c:ser>
          <c:idx val="2"/>
          <c:order val="1"/>
          <c:tx>
            <c:strRef>
              <c:f>Curinga!$C$50</c:f>
              <c:strCache>
                <c:ptCount val="1"/>
                <c:pt idx="0">
                  <c:v>40 cm </c:v>
                </c:pt>
              </c:strCache>
            </c:strRef>
          </c:tx>
          <c:spPr>
            <a:ln w="12700" cap="rnd" cmpd="sng" algn="ctr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none"/>
          </c:marker>
          <c:cat>
            <c:numRef>
              <c:f>Curinga!$A$51:$A$78</c:f>
              <c:numCache>
                <c:formatCode>General</c:formatCode>
                <c:ptCount val="28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 formatCode="0">
                  <c:v>59.382060185183953</c:v>
                </c:pt>
                <c:pt idx="11" formatCode="0">
                  <c:v>62.40296296296583</c:v>
                </c:pt>
                <c:pt idx="12" formatCode="0">
                  <c:v>66.360243055554719</c:v>
                </c:pt>
                <c:pt idx="13" formatCode="0">
                  <c:v>70.352581018516446</c:v>
                </c:pt>
                <c:pt idx="14" formatCode="0">
                  <c:v>73.360300925924079</c:v>
                </c:pt>
                <c:pt idx="15" formatCode="0">
                  <c:v>77.350682870368445</c:v>
                </c:pt>
                <c:pt idx="16" formatCode="0">
                  <c:v>80.341898148144509</c:v>
                </c:pt>
                <c:pt idx="17" formatCode="0">
                  <c:v>84.353344907409294</c:v>
                </c:pt>
                <c:pt idx="18" formatCode="0">
                  <c:v>87.344131944446417</c:v>
                </c:pt>
                <c:pt idx="19" formatCode="0">
                  <c:v>91.352627314816317</c:v>
                </c:pt>
                <c:pt idx="20" formatCode="0">
                  <c:v>94.367372685184804</c:v>
                </c:pt>
                <c:pt idx="21" formatCode="0">
                  <c:v>97.844282407408173</c:v>
                </c:pt>
                <c:pt idx="22" formatCode="0">
                  <c:v>100</c:v>
                </c:pt>
                <c:pt idx="23" formatCode="0">
                  <c:v>105</c:v>
                </c:pt>
                <c:pt idx="24" formatCode="0">
                  <c:v>110</c:v>
                </c:pt>
                <c:pt idx="25" formatCode="0">
                  <c:v>115</c:v>
                </c:pt>
                <c:pt idx="26" formatCode="0">
                  <c:v>120</c:v>
                </c:pt>
                <c:pt idx="27" formatCode="0">
                  <c:v>125</c:v>
                </c:pt>
              </c:numCache>
            </c:numRef>
          </c:cat>
          <c:val>
            <c:numRef>
              <c:f>Curinga!$C$51:$C$78</c:f>
              <c:numCache>
                <c:formatCode>General</c:formatCode>
                <c:ptCount val="28"/>
                <c:pt idx="10">
                  <c:v>74.7083333333333</c:v>
                </c:pt>
                <c:pt idx="11">
                  <c:v>71.124999999999986</c:v>
                </c:pt>
                <c:pt idx="12">
                  <c:v>67.666666666666671</c:v>
                </c:pt>
                <c:pt idx="13">
                  <c:v>63.875</c:v>
                </c:pt>
                <c:pt idx="14">
                  <c:v>60.583333333333343</c:v>
                </c:pt>
                <c:pt idx="15">
                  <c:v>59.041666666666622</c:v>
                </c:pt>
                <c:pt idx="16">
                  <c:v>56.583333333333343</c:v>
                </c:pt>
                <c:pt idx="17">
                  <c:v>53.416666666666622</c:v>
                </c:pt>
                <c:pt idx="18">
                  <c:v>53.416666666666622</c:v>
                </c:pt>
                <c:pt idx="19">
                  <c:v>53.833333333333343</c:v>
                </c:pt>
                <c:pt idx="20">
                  <c:v>72.75</c:v>
                </c:pt>
                <c:pt idx="21">
                  <c:v>74.0416666666667</c:v>
                </c:pt>
                <c:pt idx="22">
                  <c:v>68.0416666666667</c:v>
                </c:pt>
              </c:numCache>
            </c:numRef>
          </c:val>
          <c:smooth val="0"/>
        </c:ser>
        <c:ser>
          <c:idx val="3"/>
          <c:order val="2"/>
          <c:tx>
            <c:strRef>
              <c:f>Curinga!$D$50</c:f>
              <c:strCache>
                <c:ptCount val="1"/>
                <c:pt idx="0">
                  <c:v>60 cm </c:v>
                </c:pt>
              </c:strCache>
            </c:strRef>
          </c:tx>
          <c:spPr>
            <a:ln w="12700" cap="rnd" cmpd="sng" algn="ctr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Curinga!$A$51:$A$78</c:f>
              <c:numCache>
                <c:formatCode>General</c:formatCode>
                <c:ptCount val="28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 formatCode="0">
                  <c:v>59.382060185183953</c:v>
                </c:pt>
                <c:pt idx="11" formatCode="0">
                  <c:v>62.40296296296583</c:v>
                </c:pt>
                <c:pt idx="12" formatCode="0">
                  <c:v>66.360243055554719</c:v>
                </c:pt>
                <c:pt idx="13" formatCode="0">
                  <c:v>70.352581018516446</c:v>
                </c:pt>
                <c:pt idx="14" formatCode="0">
                  <c:v>73.360300925924079</c:v>
                </c:pt>
                <c:pt idx="15" formatCode="0">
                  <c:v>77.350682870368445</c:v>
                </c:pt>
                <c:pt idx="16" formatCode="0">
                  <c:v>80.341898148144509</c:v>
                </c:pt>
                <c:pt idx="17" formatCode="0">
                  <c:v>84.353344907409294</c:v>
                </c:pt>
                <c:pt idx="18" formatCode="0">
                  <c:v>87.344131944446417</c:v>
                </c:pt>
                <c:pt idx="19" formatCode="0">
                  <c:v>91.352627314816317</c:v>
                </c:pt>
                <c:pt idx="20" formatCode="0">
                  <c:v>94.367372685184804</c:v>
                </c:pt>
                <c:pt idx="21" formatCode="0">
                  <c:v>97.844282407408173</c:v>
                </c:pt>
                <c:pt idx="22" formatCode="0">
                  <c:v>100</c:v>
                </c:pt>
                <c:pt idx="23" formatCode="0">
                  <c:v>105</c:v>
                </c:pt>
                <c:pt idx="24" formatCode="0">
                  <c:v>110</c:v>
                </c:pt>
                <c:pt idx="25" formatCode="0">
                  <c:v>115</c:v>
                </c:pt>
                <c:pt idx="26" formatCode="0">
                  <c:v>120</c:v>
                </c:pt>
                <c:pt idx="27" formatCode="0">
                  <c:v>125</c:v>
                </c:pt>
              </c:numCache>
            </c:numRef>
          </c:cat>
          <c:val>
            <c:numRef>
              <c:f>Curinga!$D$51:$D$78</c:f>
              <c:numCache>
                <c:formatCode>General</c:formatCode>
                <c:ptCount val="28"/>
                <c:pt idx="10">
                  <c:v>78.75</c:v>
                </c:pt>
                <c:pt idx="11">
                  <c:v>80.5</c:v>
                </c:pt>
                <c:pt idx="12">
                  <c:v>74.2083333333333</c:v>
                </c:pt>
                <c:pt idx="13">
                  <c:v>73.5</c:v>
                </c:pt>
                <c:pt idx="14">
                  <c:v>70.624999999999986</c:v>
                </c:pt>
                <c:pt idx="15">
                  <c:v>71.374999999999986</c:v>
                </c:pt>
                <c:pt idx="16">
                  <c:v>67.5416666666667</c:v>
                </c:pt>
                <c:pt idx="17">
                  <c:v>65.3333333333333</c:v>
                </c:pt>
                <c:pt idx="18">
                  <c:v>66.4166666666667</c:v>
                </c:pt>
                <c:pt idx="19">
                  <c:v>65.0416666666667</c:v>
                </c:pt>
                <c:pt idx="20">
                  <c:v>71</c:v>
                </c:pt>
                <c:pt idx="21">
                  <c:v>74.374999999999986</c:v>
                </c:pt>
                <c:pt idx="22">
                  <c:v>71.5833333333333</c:v>
                </c:pt>
              </c:numCache>
            </c:numRef>
          </c:val>
          <c:smooth val="0"/>
        </c:ser>
        <c:ser>
          <c:idx val="4"/>
          <c:order val="3"/>
          <c:tx>
            <c:strRef>
              <c:f>Curinga!$E$50</c:f>
              <c:strCache>
                <c:ptCount val="1"/>
                <c:pt idx="0">
                  <c:v>80 cm </c:v>
                </c:pt>
              </c:strCache>
            </c:strRef>
          </c:tx>
          <c:spPr>
            <a:ln w="12700" cap="rnd" cmpd="sng" algn="ctr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none"/>
          </c:marker>
          <c:cat>
            <c:numRef>
              <c:f>Curinga!$A$51:$A$78</c:f>
              <c:numCache>
                <c:formatCode>General</c:formatCode>
                <c:ptCount val="28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 formatCode="0">
                  <c:v>59.382060185183953</c:v>
                </c:pt>
                <c:pt idx="11" formatCode="0">
                  <c:v>62.40296296296583</c:v>
                </c:pt>
                <c:pt idx="12" formatCode="0">
                  <c:v>66.360243055554719</c:v>
                </c:pt>
                <c:pt idx="13" formatCode="0">
                  <c:v>70.352581018516446</c:v>
                </c:pt>
                <c:pt idx="14" formatCode="0">
                  <c:v>73.360300925924079</c:v>
                </c:pt>
                <c:pt idx="15" formatCode="0">
                  <c:v>77.350682870368445</c:v>
                </c:pt>
                <c:pt idx="16" formatCode="0">
                  <c:v>80.341898148144509</c:v>
                </c:pt>
                <c:pt idx="17" formatCode="0">
                  <c:v>84.353344907409294</c:v>
                </c:pt>
                <c:pt idx="18" formatCode="0">
                  <c:v>87.344131944446417</c:v>
                </c:pt>
                <c:pt idx="19" formatCode="0">
                  <c:v>91.352627314816317</c:v>
                </c:pt>
                <c:pt idx="20" formatCode="0">
                  <c:v>94.367372685184804</c:v>
                </c:pt>
                <c:pt idx="21" formatCode="0">
                  <c:v>97.844282407408173</c:v>
                </c:pt>
                <c:pt idx="22" formatCode="0">
                  <c:v>100</c:v>
                </c:pt>
                <c:pt idx="23" formatCode="0">
                  <c:v>105</c:v>
                </c:pt>
                <c:pt idx="24" formatCode="0">
                  <c:v>110</c:v>
                </c:pt>
                <c:pt idx="25" formatCode="0">
                  <c:v>115</c:v>
                </c:pt>
                <c:pt idx="26" formatCode="0">
                  <c:v>120</c:v>
                </c:pt>
                <c:pt idx="27" formatCode="0">
                  <c:v>125</c:v>
                </c:pt>
              </c:numCache>
            </c:numRef>
          </c:cat>
          <c:val>
            <c:numRef>
              <c:f>Curinga!$E$51:$E$78</c:f>
              <c:numCache>
                <c:formatCode>General</c:formatCode>
                <c:ptCount val="28"/>
                <c:pt idx="10">
                  <c:v>80.25</c:v>
                </c:pt>
                <c:pt idx="11">
                  <c:v>82.7083333333333</c:v>
                </c:pt>
                <c:pt idx="12">
                  <c:v>77.0833333333333</c:v>
                </c:pt>
                <c:pt idx="13">
                  <c:v>80.124999999999986</c:v>
                </c:pt>
                <c:pt idx="14">
                  <c:v>74.9583333333333</c:v>
                </c:pt>
                <c:pt idx="15">
                  <c:v>76.4583333333333</c:v>
                </c:pt>
                <c:pt idx="16">
                  <c:v>74.124999999999986</c:v>
                </c:pt>
                <c:pt idx="17">
                  <c:v>72.4583333333333</c:v>
                </c:pt>
                <c:pt idx="18">
                  <c:v>72.75</c:v>
                </c:pt>
                <c:pt idx="19">
                  <c:v>70.7083333333333</c:v>
                </c:pt>
                <c:pt idx="20">
                  <c:v>71.75</c:v>
                </c:pt>
                <c:pt idx="21">
                  <c:v>76.124999999999986</c:v>
                </c:pt>
                <c:pt idx="22">
                  <c:v>74.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dropLines>
          <c:spPr>
            <a:ln w="6350" cap="flat" cmpd="sng" algn="ctr">
              <a:solidFill>
                <a:schemeClr val="tx1">
                  <a:alpha val="33000"/>
                </a:schemeClr>
              </a:solidFill>
              <a:prstDash val="dash"/>
              <a:round/>
            </a:ln>
            <a:effectLst/>
          </c:spPr>
        </c:dropLines>
        <c:smooth val="0"/>
        <c:axId val="325979720"/>
        <c:axId val="325980112"/>
      </c:lineChart>
      <c:dateAx>
        <c:axId val="32597972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1197" b="1" i="0" u="none" strike="noStrike" kern="1200" cap="all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CO" dirty="0" err="1"/>
                  <a:t>Days</a:t>
                </a:r>
                <a:r>
                  <a:rPr lang="es-CO" dirty="0"/>
                  <a:t> </a:t>
                </a:r>
                <a:r>
                  <a:rPr lang="es-CO" dirty="0" err="1"/>
                  <a:t>After</a:t>
                </a:r>
                <a:r>
                  <a:rPr lang="es-CO" dirty="0"/>
                  <a:t> </a:t>
                </a:r>
                <a:r>
                  <a:rPr lang="es-CO" dirty="0" err="1"/>
                  <a:t>Sowing</a:t>
                </a:r>
                <a:endParaRPr lang="es-CO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1197" b="1" i="0" u="none" strike="noStrike" kern="1200" cap="all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1" i="0" u="none" strike="noStrike" kern="1200" spc="2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25980112"/>
        <c:crosses val="autoZero"/>
        <c:auto val="0"/>
        <c:lblOffset val="100"/>
        <c:baseTimeUnit val="days"/>
        <c:majorUnit val="10"/>
        <c:majorTimeUnit val="days"/>
      </c:dateAx>
      <c:valAx>
        <c:axId val="325980112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197" b="1" i="0" u="none" strike="noStrike" kern="1200" cap="all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CO" dirty="0" err="1"/>
                  <a:t>Moisture</a:t>
                </a:r>
                <a:r>
                  <a:rPr lang="es-CO" dirty="0"/>
                  <a:t> (%)</a:t>
                </a:r>
              </a:p>
            </c:rich>
          </c:tx>
          <c:layout>
            <c:manualLayout>
              <c:xMode val="edge"/>
              <c:yMode val="edge"/>
              <c:x val="1.73211068975021E-2"/>
              <c:y val="0.2046958384148349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197" b="1" i="0" u="none" strike="noStrike" kern="1200" cap="all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1" i="0" u="none" strike="noStrike" kern="1200" spc="2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25979720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85746367641544796"/>
          <c:y val="0.17377806940799101"/>
          <c:w val="0.12138205380577401"/>
          <c:h val="0.5160367454068239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197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2911395460629501E-2"/>
          <c:y val="0.104815166312554"/>
          <c:w val="0.76619258779911503"/>
          <c:h val="0.70521842787102196"/>
        </c:manualLayout>
      </c:layout>
      <c:lineChart>
        <c:grouping val="standard"/>
        <c:varyColors val="0"/>
        <c:ser>
          <c:idx val="1"/>
          <c:order val="0"/>
          <c:tx>
            <c:strRef>
              <c:f>CURINGA!$F$392</c:f>
              <c:strCache>
                <c:ptCount val="1"/>
                <c:pt idx="0">
                  <c:v>20 cm</c:v>
                </c:pt>
              </c:strCache>
            </c:strRef>
          </c:tx>
          <c:spPr>
            <a:ln w="12700" cap="rnd" cmpd="sng" algn="ctr">
              <a:solidFill>
                <a:schemeClr val="tx1"/>
              </a:solidFill>
              <a:prstDash val="lgDashDot"/>
              <a:round/>
            </a:ln>
            <a:effectLst/>
          </c:spPr>
          <c:marker>
            <c:symbol val="none"/>
          </c:marker>
          <c:cat>
            <c:numRef>
              <c:f>CURINGA!$D$393:$D$417</c:f>
              <c:numCache>
                <c:formatCode>General</c:formatCode>
                <c:ptCount val="2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 formatCode="0">
                  <c:v>47.356909722220728</c:v>
                </c:pt>
                <c:pt idx="10" formatCode="0">
                  <c:v>50.365150462959733</c:v>
                </c:pt>
                <c:pt idx="11" formatCode="0">
                  <c:v>53.35447916666449</c:v>
                </c:pt>
                <c:pt idx="12" formatCode="0">
                  <c:v>57.344560185185387</c:v>
                </c:pt>
                <c:pt idx="13" formatCode="0">
                  <c:v>60.371550925927302</c:v>
                </c:pt>
                <c:pt idx="14" formatCode="0">
                  <c:v>64.350081018521379</c:v>
                </c:pt>
                <c:pt idx="15" formatCode="0">
                  <c:v>67.345960648148335</c:v>
                </c:pt>
                <c:pt idx="16" formatCode="0">
                  <c:v>71.373113425928764</c:v>
                </c:pt>
                <c:pt idx="17" formatCode="0">
                  <c:v>74.354062500002328</c:v>
                </c:pt>
                <c:pt idx="18" formatCode="0">
                  <c:v>81.343912037038507</c:v>
                </c:pt>
                <c:pt idx="19" formatCode="0">
                  <c:v>95.343912037038507</c:v>
                </c:pt>
                <c:pt idx="20" formatCode="0">
                  <c:v>102.34391203703851</c:v>
                </c:pt>
                <c:pt idx="21">
                  <c:v>110</c:v>
                </c:pt>
                <c:pt idx="22">
                  <c:v>115</c:v>
                </c:pt>
                <c:pt idx="23">
                  <c:v>120</c:v>
                </c:pt>
                <c:pt idx="24">
                  <c:v>125</c:v>
                </c:pt>
              </c:numCache>
            </c:numRef>
          </c:cat>
          <c:val>
            <c:numRef>
              <c:f>CURINGA!$F$393:$F$417</c:f>
              <c:numCache>
                <c:formatCode>General</c:formatCode>
                <c:ptCount val="25"/>
                <c:pt idx="9" formatCode="0.00">
                  <c:v>61.12903225806452</c:v>
                </c:pt>
                <c:pt idx="10" formatCode="0.00">
                  <c:v>56.516129032258057</c:v>
                </c:pt>
                <c:pt idx="11" formatCode="0.00">
                  <c:v>50.870967741935473</c:v>
                </c:pt>
                <c:pt idx="12" formatCode="0.00">
                  <c:v>46.741935483870968</c:v>
                </c:pt>
                <c:pt idx="13" formatCode="0.00">
                  <c:v>39.967741935483872</c:v>
                </c:pt>
                <c:pt idx="14" formatCode="0.00">
                  <c:v>37.41935483870968</c:v>
                </c:pt>
                <c:pt idx="15" formatCode="0.00">
                  <c:v>31.677419354838712</c:v>
                </c:pt>
                <c:pt idx="16" formatCode="0.00">
                  <c:v>28.483870967741929</c:v>
                </c:pt>
                <c:pt idx="17" formatCode="0.00">
                  <c:v>28.258064516129021</c:v>
                </c:pt>
                <c:pt idx="18" formatCode="0.00">
                  <c:v>28.41935483870968</c:v>
                </c:pt>
                <c:pt idx="19" formatCode="0.00">
                  <c:v>28.774193548387089</c:v>
                </c:pt>
                <c:pt idx="20" formatCode="0.00">
                  <c:v>51.41935483870968</c:v>
                </c:pt>
              </c:numCache>
            </c:numRef>
          </c:val>
          <c:smooth val="0"/>
        </c:ser>
        <c:ser>
          <c:idx val="2"/>
          <c:order val="1"/>
          <c:tx>
            <c:strRef>
              <c:f>CURINGA!$G$392</c:f>
              <c:strCache>
                <c:ptCount val="1"/>
                <c:pt idx="0">
                  <c:v>40 cm</c:v>
                </c:pt>
              </c:strCache>
            </c:strRef>
          </c:tx>
          <c:spPr>
            <a:ln w="12700" cap="rnd" cmpd="sng" algn="ctr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none"/>
          </c:marker>
          <c:cat>
            <c:numRef>
              <c:f>CURINGA!$D$393:$D$417</c:f>
              <c:numCache>
                <c:formatCode>General</c:formatCode>
                <c:ptCount val="2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 formatCode="0">
                  <c:v>47.356909722220728</c:v>
                </c:pt>
                <c:pt idx="10" formatCode="0">
                  <c:v>50.365150462959733</c:v>
                </c:pt>
                <c:pt idx="11" formatCode="0">
                  <c:v>53.35447916666449</c:v>
                </c:pt>
                <c:pt idx="12" formatCode="0">
                  <c:v>57.344560185185387</c:v>
                </c:pt>
                <c:pt idx="13" formatCode="0">
                  <c:v>60.371550925927302</c:v>
                </c:pt>
                <c:pt idx="14" formatCode="0">
                  <c:v>64.350081018521379</c:v>
                </c:pt>
                <c:pt idx="15" formatCode="0">
                  <c:v>67.345960648148335</c:v>
                </c:pt>
                <c:pt idx="16" formatCode="0">
                  <c:v>71.373113425928764</c:v>
                </c:pt>
                <c:pt idx="17" formatCode="0">
                  <c:v>74.354062500002328</c:v>
                </c:pt>
                <c:pt idx="18" formatCode="0">
                  <c:v>81.343912037038507</c:v>
                </c:pt>
                <c:pt idx="19" formatCode="0">
                  <c:v>95.343912037038507</c:v>
                </c:pt>
                <c:pt idx="20" formatCode="0">
                  <c:v>102.34391203703851</c:v>
                </c:pt>
                <c:pt idx="21">
                  <c:v>110</c:v>
                </c:pt>
                <c:pt idx="22">
                  <c:v>115</c:v>
                </c:pt>
                <c:pt idx="23">
                  <c:v>120</c:v>
                </c:pt>
                <c:pt idx="24">
                  <c:v>125</c:v>
                </c:pt>
              </c:numCache>
            </c:numRef>
          </c:cat>
          <c:val>
            <c:numRef>
              <c:f>CURINGA!$G$393:$G$417</c:f>
              <c:numCache>
                <c:formatCode>General</c:formatCode>
                <c:ptCount val="25"/>
                <c:pt idx="9" formatCode="0.00">
                  <c:v>71.967741935483843</c:v>
                </c:pt>
                <c:pt idx="10" formatCode="0.00">
                  <c:v>69.870967741935502</c:v>
                </c:pt>
                <c:pt idx="11" formatCode="0.00">
                  <c:v>67.258064516128997</c:v>
                </c:pt>
                <c:pt idx="12" formatCode="0.00">
                  <c:v>61.38709677419353</c:v>
                </c:pt>
                <c:pt idx="13" formatCode="0.00">
                  <c:v>56.161290322580648</c:v>
                </c:pt>
                <c:pt idx="14" formatCode="0.00">
                  <c:v>52.354838709677388</c:v>
                </c:pt>
                <c:pt idx="15" formatCode="0.00">
                  <c:v>52.354838709677388</c:v>
                </c:pt>
                <c:pt idx="16" formatCode="0.00">
                  <c:v>48.193548387096783</c:v>
                </c:pt>
                <c:pt idx="17" formatCode="0.00">
                  <c:v>52.096774193548377</c:v>
                </c:pt>
                <c:pt idx="18" formatCode="0.00">
                  <c:v>52.096774193548377</c:v>
                </c:pt>
                <c:pt idx="19" formatCode="0.00">
                  <c:v>52.096774193548377</c:v>
                </c:pt>
                <c:pt idx="20" formatCode="0.00">
                  <c:v>67.032258064516128</c:v>
                </c:pt>
              </c:numCache>
            </c:numRef>
          </c:val>
          <c:smooth val="0"/>
        </c:ser>
        <c:ser>
          <c:idx val="3"/>
          <c:order val="2"/>
          <c:tx>
            <c:strRef>
              <c:f>CURINGA!$H$392</c:f>
              <c:strCache>
                <c:ptCount val="1"/>
                <c:pt idx="0">
                  <c:v>60 cm</c:v>
                </c:pt>
              </c:strCache>
            </c:strRef>
          </c:tx>
          <c:spPr>
            <a:ln w="12700" cap="rnd" cmpd="sng" algn="ctr">
              <a:solidFill>
                <a:schemeClr val="tx1"/>
              </a:solidFill>
              <a:prstDash val="solid"/>
              <a:round/>
            </a:ln>
            <a:effectLst/>
          </c:spPr>
          <c:marker>
            <c:symbol val="none"/>
          </c:marker>
          <c:cat>
            <c:numRef>
              <c:f>CURINGA!$D$393:$D$417</c:f>
              <c:numCache>
                <c:formatCode>General</c:formatCode>
                <c:ptCount val="2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 formatCode="0">
                  <c:v>47.356909722220728</c:v>
                </c:pt>
                <c:pt idx="10" formatCode="0">
                  <c:v>50.365150462959733</c:v>
                </c:pt>
                <c:pt idx="11" formatCode="0">
                  <c:v>53.35447916666449</c:v>
                </c:pt>
                <c:pt idx="12" formatCode="0">
                  <c:v>57.344560185185387</c:v>
                </c:pt>
                <c:pt idx="13" formatCode="0">
                  <c:v>60.371550925927302</c:v>
                </c:pt>
                <c:pt idx="14" formatCode="0">
                  <c:v>64.350081018521379</c:v>
                </c:pt>
                <c:pt idx="15" formatCode="0">
                  <c:v>67.345960648148335</c:v>
                </c:pt>
                <c:pt idx="16" formatCode="0">
                  <c:v>71.373113425928764</c:v>
                </c:pt>
                <c:pt idx="17" formatCode="0">
                  <c:v>74.354062500002328</c:v>
                </c:pt>
                <c:pt idx="18" formatCode="0">
                  <c:v>81.343912037038507</c:v>
                </c:pt>
                <c:pt idx="19" formatCode="0">
                  <c:v>95.343912037038507</c:v>
                </c:pt>
                <c:pt idx="20" formatCode="0">
                  <c:v>102.34391203703851</c:v>
                </c:pt>
                <c:pt idx="21">
                  <c:v>110</c:v>
                </c:pt>
                <c:pt idx="22">
                  <c:v>115</c:v>
                </c:pt>
                <c:pt idx="23">
                  <c:v>120</c:v>
                </c:pt>
                <c:pt idx="24">
                  <c:v>125</c:v>
                </c:pt>
              </c:numCache>
            </c:numRef>
          </c:cat>
          <c:val>
            <c:numRef>
              <c:f>CURINGA!$H$393:$H$417</c:f>
              <c:numCache>
                <c:formatCode>General</c:formatCode>
                <c:ptCount val="25"/>
                <c:pt idx="9" formatCode="0.00">
                  <c:v>79.064516129032285</c:v>
                </c:pt>
                <c:pt idx="10" formatCode="0.00">
                  <c:v>77.387096774193552</c:v>
                </c:pt>
                <c:pt idx="11" formatCode="0.00">
                  <c:v>74.838709677419345</c:v>
                </c:pt>
                <c:pt idx="12" formatCode="0.00">
                  <c:v>71.225806451612883</c:v>
                </c:pt>
                <c:pt idx="13" formatCode="0.00">
                  <c:v>69.322580645161281</c:v>
                </c:pt>
                <c:pt idx="14" formatCode="0.00">
                  <c:v>67.612903225806463</c:v>
                </c:pt>
                <c:pt idx="15" formatCode="0.00">
                  <c:v>62.741935483870968</c:v>
                </c:pt>
                <c:pt idx="16" formatCode="0.00">
                  <c:v>64.870967741935502</c:v>
                </c:pt>
                <c:pt idx="17" formatCode="0.00">
                  <c:v>68.935483870967744</c:v>
                </c:pt>
                <c:pt idx="18" formatCode="0.00">
                  <c:v>68.935483870967744</c:v>
                </c:pt>
                <c:pt idx="19" formatCode="0.00">
                  <c:v>68.935483870967744</c:v>
                </c:pt>
                <c:pt idx="20" formatCode="0.00">
                  <c:v>73.19354838709674</c:v>
                </c:pt>
              </c:numCache>
            </c:numRef>
          </c:val>
          <c:smooth val="0"/>
        </c:ser>
        <c:ser>
          <c:idx val="4"/>
          <c:order val="3"/>
          <c:tx>
            <c:strRef>
              <c:f>CURINGA!$I$392</c:f>
              <c:strCache>
                <c:ptCount val="1"/>
                <c:pt idx="0">
                  <c:v>80 cm</c:v>
                </c:pt>
              </c:strCache>
            </c:strRef>
          </c:tx>
          <c:spPr>
            <a:ln w="12700" cap="rnd" cmpd="sng" algn="ctr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none"/>
          </c:marker>
          <c:cat>
            <c:numRef>
              <c:f>CURINGA!$D$393:$D$417</c:f>
              <c:numCache>
                <c:formatCode>General</c:formatCode>
                <c:ptCount val="2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 formatCode="0">
                  <c:v>47.356909722220728</c:v>
                </c:pt>
                <c:pt idx="10" formatCode="0">
                  <c:v>50.365150462959733</c:v>
                </c:pt>
                <c:pt idx="11" formatCode="0">
                  <c:v>53.35447916666449</c:v>
                </c:pt>
                <c:pt idx="12" formatCode="0">
                  <c:v>57.344560185185387</c:v>
                </c:pt>
                <c:pt idx="13" formatCode="0">
                  <c:v>60.371550925927302</c:v>
                </c:pt>
                <c:pt idx="14" formatCode="0">
                  <c:v>64.350081018521379</c:v>
                </c:pt>
                <c:pt idx="15" formatCode="0">
                  <c:v>67.345960648148335</c:v>
                </c:pt>
                <c:pt idx="16" formatCode="0">
                  <c:v>71.373113425928764</c:v>
                </c:pt>
                <c:pt idx="17" formatCode="0">
                  <c:v>74.354062500002328</c:v>
                </c:pt>
                <c:pt idx="18" formatCode="0">
                  <c:v>81.343912037038507</c:v>
                </c:pt>
                <c:pt idx="19" formatCode="0">
                  <c:v>95.343912037038507</c:v>
                </c:pt>
                <c:pt idx="20" formatCode="0">
                  <c:v>102.34391203703851</c:v>
                </c:pt>
                <c:pt idx="21">
                  <c:v>110</c:v>
                </c:pt>
                <c:pt idx="22">
                  <c:v>115</c:v>
                </c:pt>
                <c:pt idx="23">
                  <c:v>120</c:v>
                </c:pt>
                <c:pt idx="24">
                  <c:v>125</c:v>
                </c:pt>
              </c:numCache>
            </c:numRef>
          </c:cat>
          <c:val>
            <c:numRef>
              <c:f>CURINGA!$I$393:$I$417</c:f>
              <c:numCache>
                <c:formatCode>General</c:formatCode>
                <c:ptCount val="25"/>
                <c:pt idx="9" formatCode="0.00">
                  <c:v>80.129032258064456</c:v>
                </c:pt>
                <c:pt idx="10" formatCode="0.00">
                  <c:v>79.677419354838676</c:v>
                </c:pt>
                <c:pt idx="11" formatCode="0.00">
                  <c:v>78.709677419354804</c:v>
                </c:pt>
                <c:pt idx="12" formatCode="0.00">
                  <c:v>75.903225806451587</c:v>
                </c:pt>
                <c:pt idx="13" formatCode="0.00">
                  <c:v>74.58064516129032</c:v>
                </c:pt>
                <c:pt idx="14" formatCode="0.00">
                  <c:v>75.096774193548356</c:v>
                </c:pt>
                <c:pt idx="15" formatCode="0.00">
                  <c:v>74.064516129032285</c:v>
                </c:pt>
                <c:pt idx="16" formatCode="0.00">
                  <c:v>72.161290322580612</c:v>
                </c:pt>
                <c:pt idx="17" formatCode="0.00">
                  <c:v>75</c:v>
                </c:pt>
                <c:pt idx="18" formatCode="0.00">
                  <c:v>75</c:v>
                </c:pt>
                <c:pt idx="19" formatCode="0.00">
                  <c:v>75</c:v>
                </c:pt>
                <c:pt idx="20" formatCode="0.00">
                  <c:v>78.06451612903228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dropLines>
          <c:spPr>
            <a:ln w="6350" cap="flat" cmpd="sng" algn="ctr">
              <a:solidFill>
                <a:schemeClr val="tx1">
                  <a:alpha val="33000"/>
                </a:schemeClr>
              </a:solidFill>
              <a:prstDash val="dash"/>
              <a:round/>
            </a:ln>
            <a:effectLst/>
          </c:spPr>
        </c:dropLines>
        <c:smooth val="0"/>
        <c:axId val="325980896"/>
        <c:axId val="325981288"/>
      </c:lineChart>
      <c:dateAx>
        <c:axId val="32598089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1197" b="1" i="0" u="none" strike="noStrike" kern="1200" cap="all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CO"/>
                  <a:t>Days After Sowing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1197" b="1" i="0" u="none" strike="noStrike" kern="1200" cap="all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1" i="0" u="none" strike="noStrike" kern="1200" spc="2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25981288"/>
        <c:crosses val="autoZero"/>
        <c:auto val="0"/>
        <c:lblOffset val="100"/>
        <c:baseTimeUnit val="days"/>
        <c:majorUnit val="10"/>
        <c:majorTimeUnit val="days"/>
      </c:dateAx>
      <c:valAx>
        <c:axId val="32598128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197" b="1" i="0" u="none" strike="noStrike" kern="1200" cap="all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CO"/>
                  <a:t>Moisture (%)</a:t>
                </a:r>
              </a:p>
            </c:rich>
          </c:tx>
          <c:layout>
            <c:manualLayout>
              <c:xMode val="edge"/>
              <c:yMode val="edge"/>
              <c:x val="1.85796945151986E-2"/>
              <c:y val="0.23165455458972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197" b="1" i="0" u="none" strike="noStrike" kern="1200" cap="all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1" i="0" u="none" strike="noStrike" kern="1200" spc="2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25980896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86679188047843503"/>
          <c:y val="0.30803732866724998"/>
          <c:w val="0.111792217570661"/>
          <c:h val="0.4234441528142319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197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3932798494527802E-2"/>
          <c:y val="6.5820677524225296E-2"/>
          <c:w val="0.77677672955974797"/>
          <c:h val="0.691038358097121"/>
        </c:manualLayout>
      </c:layout>
      <c:lineChart>
        <c:grouping val="standard"/>
        <c:varyColors val="0"/>
        <c:ser>
          <c:idx val="1"/>
          <c:order val="0"/>
          <c:tx>
            <c:strRef>
              <c:f>'Nerica 4'!$B$35</c:f>
              <c:strCache>
                <c:ptCount val="1"/>
                <c:pt idx="0">
                  <c:v>20 cm</c:v>
                </c:pt>
              </c:strCache>
            </c:strRef>
          </c:tx>
          <c:spPr>
            <a:ln w="12700" cap="rnd" cmpd="sng" algn="ctr">
              <a:solidFill>
                <a:schemeClr val="tx1"/>
              </a:solidFill>
              <a:prstDash val="lgDashDot"/>
              <a:round/>
            </a:ln>
            <a:effectLst/>
          </c:spPr>
          <c:marker>
            <c:symbol val="none"/>
          </c:marker>
          <c:cat>
            <c:numRef>
              <c:f>'Nerica 4'!$A$36:$A$65</c:f>
              <c:numCache>
                <c:formatCode>General</c:formatCode>
                <c:ptCount val="30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 formatCode="0">
                  <c:v>59.393958333334012</c:v>
                </c:pt>
                <c:pt idx="13" formatCode="0">
                  <c:v>62.414467592592672</c:v>
                </c:pt>
                <c:pt idx="14" formatCode="0">
                  <c:v>66.373101851851914</c:v>
                </c:pt>
                <c:pt idx="15" formatCode="0">
                  <c:v>70.36629629629897</c:v>
                </c:pt>
                <c:pt idx="16" formatCode="0">
                  <c:v>73.374560185184208</c:v>
                </c:pt>
                <c:pt idx="17" formatCode="0">
                  <c:v>77.380335648151203</c:v>
                </c:pt>
                <c:pt idx="18" formatCode="0">
                  <c:v>80.354305555556437</c:v>
                </c:pt>
                <c:pt idx="19" formatCode="0">
                  <c:v>84.367361111108039</c:v>
                </c:pt>
                <c:pt idx="20" formatCode="0">
                  <c:v>87.354803240741603</c:v>
                </c:pt>
                <c:pt idx="21" formatCode="0">
                  <c:v>91.364594907405262</c:v>
                </c:pt>
                <c:pt idx="22" formatCode="0">
                  <c:v>94.379513888889051</c:v>
                </c:pt>
                <c:pt idx="23" formatCode="0">
                  <c:v>97.353472222224752</c:v>
                </c:pt>
                <c:pt idx="24" formatCode="0">
                  <c:v>100</c:v>
                </c:pt>
                <c:pt idx="25" formatCode="0">
                  <c:v>105</c:v>
                </c:pt>
                <c:pt idx="26" formatCode="0">
                  <c:v>110</c:v>
                </c:pt>
                <c:pt idx="27" formatCode="0">
                  <c:v>115</c:v>
                </c:pt>
                <c:pt idx="28" formatCode="0">
                  <c:v>120</c:v>
                </c:pt>
                <c:pt idx="29" formatCode="0">
                  <c:v>125</c:v>
                </c:pt>
              </c:numCache>
            </c:numRef>
          </c:cat>
          <c:val>
            <c:numRef>
              <c:f>'Nerica 4'!$B$36:$B$65</c:f>
              <c:numCache>
                <c:formatCode>General</c:formatCode>
                <c:ptCount val="30"/>
                <c:pt idx="12">
                  <c:v>62.083333333333343</c:v>
                </c:pt>
                <c:pt idx="13">
                  <c:v>59.75</c:v>
                </c:pt>
                <c:pt idx="14">
                  <c:v>51.833333333333343</c:v>
                </c:pt>
                <c:pt idx="15">
                  <c:v>48.833333333333343</c:v>
                </c:pt>
                <c:pt idx="16">
                  <c:v>43.916666666666622</c:v>
                </c:pt>
                <c:pt idx="17">
                  <c:v>38.916666666666622</c:v>
                </c:pt>
                <c:pt idx="18">
                  <c:v>35.583333333333343</c:v>
                </c:pt>
                <c:pt idx="19">
                  <c:v>30.666666666666671</c:v>
                </c:pt>
                <c:pt idx="20">
                  <c:v>28.166666666666671</c:v>
                </c:pt>
                <c:pt idx="21">
                  <c:v>31.583333333333311</c:v>
                </c:pt>
                <c:pt idx="22">
                  <c:v>77.75</c:v>
                </c:pt>
                <c:pt idx="23">
                  <c:v>63.75</c:v>
                </c:pt>
                <c:pt idx="24">
                  <c:v>55.583333333333343</c:v>
                </c:pt>
              </c:numCache>
            </c:numRef>
          </c:val>
          <c:smooth val="0"/>
        </c:ser>
        <c:ser>
          <c:idx val="2"/>
          <c:order val="1"/>
          <c:tx>
            <c:strRef>
              <c:f>'Nerica 4'!$C$35</c:f>
              <c:strCache>
                <c:ptCount val="1"/>
                <c:pt idx="0">
                  <c:v>40 cm</c:v>
                </c:pt>
              </c:strCache>
            </c:strRef>
          </c:tx>
          <c:spPr>
            <a:ln w="12700" cap="rnd" cmpd="sng" algn="ctr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none"/>
          </c:marker>
          <c:cat>
            <c:numRef>
              <c:f>'Nerica 4'!$A$36:$A$65</c:f>
              <c:numCache>
                <c:formatCode>General</c:formatCode>
                <c:ptCount val="30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 formatCode="0">
                  <c:v>59.393958333334012</c:v>
                </c:pt>
                <c:pt idx="13" formatCode="0">
                  <c:v>62.414467592592672</c:v>
                </c:pt>
                <c:pt idx="14" formatCode="0">
                  <c:v>66.373101851851914</c:v>
                </c:pt>
                <c:pt idx="15" formatCode="0">
                  <c:v>70.36629629629897</c:v>
                </c:pt>
                <c:pt idx="16" formatCode="0">
                  <c:v>73.374560185184208</c:v>
                </c:pt>
                <c:pt idx="17" formatCode="0">
                  <c:v>77.380335648151203</c:v>
                </c:pt>
                <c:pt idx="18" formatCode="0">
                  <c:v>80.354305555556437</c:v>
                </c:pt>
                <c:pt idx="19" formatCode="0">
                  <c:v>84.367361111108039</c:v>
                </c:pt>
                <c:pt idx="20" formatCode="0">
                  <c:v>87.354803240741603</c:v>
                </c:pt>
                <c:pt idx="21" formatCode="0">
                  <c:v>91.364594907405262</c:v>
                </c:pt>
                <c:pt idx="22" formatCode="0">
                  <c:v>94.379513888889051</c:v>
                </c:pt>
                <c:pt idx="23" formatCode="0">
                  <c:v>97.353472222224752</c:v>
                </c:pt>
                <c:pt idx="24" formatCode="0">
                  <c:v>100</c:v>
                </c:pt>
                <c:pt idx="25" formatCode="0">
                  <c:v>105</c:v>
                </c:pt>
                <c:pt idx="26" formatCode="0">
                  <c:v>110</c:v>
                </c:pt>
                <c:pt idx="27" formatCode="0">
                  <c:v>115</c:v>
                </c:pt>
                <c:pt idx="28" formatCode="0">
                  <c:v>120</c:v>
                </c:pt>
                <c:pt idx="29" formatCode="0">
                  <c:v>125</c:v>
                </c:pt>
              </c:numCache>
            </c:numRef>
          </c:cat>
          <c:val>
            <c:numRef>
              <c:f>'Nerica 4'!$C$36:$C$65</c:f>
              <c:numCache>
                <c:formatCode>General</c:formatCode>
                <c:ptCount val="30"/>
                <c:pt idx="12">
                  <c:v>73.3333333333333</c:v>
                </c:pt>
                <c:pt idx="13">
                  <c:v>67.5</c:v>
                </c:pt>
                <c:pt idx="14">
                  <c:v>68.75</c:v>
                </c:pt>
                <c:pt idx="15">
                  <c:v>65.25</c:v>
                </c:pt>
                <c:pt idx="16">
                  <c:v>64.0833333333333</c:v>
                </c:pt>
                <c:pt idx="17">
                  <c:v>61.583333333333343</c:v>
                </c:pt>
                <c:pt idx="18">
                  <c:v>60.25</c:v>
                </c:pt>
                <c:pt idx="19">
                  <c:v>55.833333333333343</c:v>
                </c:pt>
                <c:pt idx="20">
                  <c:v>56.916666666666622</c:v>
                </c:pt>
                <c:pt idx="21">
                  <c:v>55.5</c:v>
                </c:pt>
                <c:pt idx="22">
                  <c:v>60.75</c:v>
                </c:pt>
                <c:pt idx="23">
                  <c:v>67.4166666666667</c:v>
                </c:pt>
                <c:pt idx="24">
                  <c:v>66.5833333333333</c:v>
                </c:pt>
              </c:numCache>
            </c:numRef>
          </c:val>
          <c:smooth val="0"/>
        </c:ser>
        <c:ser>
          <c:idx val="3"/>
          <c:order val="2"/>
          <c:tx>
            <c:strRef>
              <c:f>'Nerica 4'!$D$35</c:f>
              <c:strCache>
                <c:ptCount val="1"/>
                <c:pt idx="0">
                  <c:v>60 cm</c:v>
                </c:pt>
              </c:strCache>
            </c:strRef>
          </c:tx>
          <c:spPr>
            <a:ln w="12700" cap="rnd" cmpd="sng" algn="ctr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'Nerica 4'!$A$36:$A$65</c:f>
              <c:numCache>
                <c:formatCode>General</c:formatCode>
                <c:ptCount val="30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 formatCode="0">
                  <c:v>59.393958333334012</c:v>
                </c:pt>
                <c:pt idx="13" formatCode="0">
                  <c:v>62.414467592592672</c:v>
                </c:pt>
                <c:pt idx="14" formatCode="0">
                  <c:v>66.373101851851914</c:v>
                </c:pt>
                <c:pt idx="15" formatCode="0">
                  <c:v>70.36629629629897</c:v>
                </c:pt>
                <c:pt idx="16" formatCode="0">
                  <c:v>73.374560185184208</c:v>
                </c:pt>
                <c:pt idx="17" formatCode="0">
                  <c:v>77.380335648151203</c:v>
                </c:pt>
                <c:pt idx="18" formatCode="0">
                  <c:v>80.354305555556437</c:v>
                </c:pt>
                <c:pt idx="19" formatCode="0">
                  <c:v>84.367361111108039</c:v>
                </c:pt>
                <c:pt idx="20" formatCode="0">
                  <c:v>87.354803240741603</c:v>
                </c:pt>
                <c:pt idx="21" formatCode="0">
                  <c:v>91.364594907405262</c:v>
                </c:pt>
                <c:pt idx="22" formatCode="0">
                  <c:v>94.379513888889051</c:v>
                </c:pt>
                <c:pt idx="23" formatCode="0">
                  <c:v>97.353472222224752</c:v>
                </c:pt>
                <c:pt idx="24" formatCode="0">
                  <c:v>100</c:v>
                </c:pt>
                <c:pt idx="25" formatCode="0">
                  <c:v>105</c:v>
                </c:pt>
                <c:pt idx="26" formatCode="0">
                  <c:v>110</c:v>
                </c:pt>
                <c:pt idx="27" formatCode="0">
                  <c:v>115</c:v>
                </c:pt>
                <c:pt idx="28" formatCode="0">
                  <c:v>120</c:v>
                </c:pt>
                <c:pt idx="29" formatCode="0">
                  <c:v>125</c:v>
                </c:pt>
              </c:numCache>
            </c:numRef>
          </c:cat>
          <c:val>
            <c:numRef>
              <c:f>'Nerica 4'!$D$36:$D$65</c:f>
              <c:numCache>
                <c:formatCode>General</c:formatCode>
                <c:ptCount val="30"/>
                <c:pt idx="12">
                  <c:v>76</c:v>
                </c:pt>
                <c:pt idx="13">
                  <c:v>78.25</c:v>
                </c:pt>
                <c:pt idx="14">
                  <c:v>73.25</c:v>
                </c:pt>
                <c:pt idx="15">
                  <c:v>71</c:v>
                </c:pt>
                <c:pt idx="16">
                  <c:v>65.75</c:v>
                </c:pt>
                <c:pt idx="17">
                  <c:v>63.25</c:v>
                </c:pt>
                <c:pt idx="18">
                  <c:v>61.333333333333343</c:v>
                </c:pt>
                <c:pt idx="19">
                  <c:v>57.833333333333343</c:v>
                </c:pt>
                <c:pt idx="20">
                  <c:v>58.333333333333343</c:v>
                </c:pt>
                <c:pt idx="21">
                  <c:v>54</c:v>
                </c:pt>
                <c:pt idx="22">
                  <c:v>57.833333333333343</c:v>
                </c:pt>
                <c:pt idx="23">
                  <c:v>63.5</c:v>
                </c:pt>
                <c:pt idx="24">
                  <c:v>64.4166666666667</c:v>
                </c:pt>
              </c:numCache>
            </c:numRef>
          </c:val>
          <c:smooth val="0"/>
        </c:ser>
        <c:ser>
          <c:idx val="4"/>
          <c:order val="3"/>
          <c:tx>
            <c:strRef>
              <c:f>'Nerica 4'!$E$35</c:f>
              <c:strCache>
                <c:ptCount val="1"/>
                <c:pt idx="0">
                  <c:v>80 cm</c:v>
                </c:pt>
              </c:strCache>
            </c:strRef>
          </c:tx>
          <c:spPr>
            <a:ln w="12700" cap="rnd" cmpd="sng" algn="ctr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none"/>
          </c:marker>
          <c:cat>
            <c:numRef>
              <c:f>'Nerica 4'!$A$36:$A$65</c:f>
              <c:numCache>
                <c:formatCode>General</c:formatCode>
                <c:ptCount val="30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 formatCode="0">
                  <c:v>59.393958333334012</c:v>
                </c:pt>
                <c:pt idx="13" formatCode="0">
                  <c:v>62.414467592592672</c:v>
                </c:pt>
                <c:pt idx="14" formatCode="0">
                  <c:v>66.373101851851914</c:v>
                </c:pt>
                <c:pt idx="15" formatCode="0">
                  <c:v>70.36629629629897</c:v>
                </c:pt>
                <c:pt idx="16" formatCode="0">
                  <c:v>73.374560185184208</c:v>
                </c:pt>
                <c:pt idx="17" formatCode="0">
                  <c:v>77.380335648151203</c:v>
                </c:pt>
                <c:pt idx="18" formatCode="0">
                  <c:v>80.354305555556437</c:v>
                </c:pt>
                <c:pt idx="19" formatCode="0">
                  <c:v>84.367361111108039</c:v>
                </c:pt>
                <c:pt idx="20" formatCode="0">
                  <c:v>87.354803240741603</c:v>
                </c:pt>
                <c:pt idx="21" formatCode="0">
                  <c:v>91.364594907405262</c:v>
                </c:pt>
                <c:pt idx="22" formatCode="0">
                  <c:v>94.379513888889051</c:v>
                </c:pt>
                <c:pt idx="23" formatCode="0">
                  <c:v>97.353472222224752</c:v>
                </c:pt>
                <c:pt idx="24" formatCode="0">
                  <c:v>100</c:v>
                </c:pt>
                <c:pt idx="25" formatCode="0">
                  <c:v>105</c:v>
                </c:pt>
                <c:pt idx="26" formatCode="0">
                  <c:v>110</c:v>
                </c:pt>
                <c:pt idx="27" formatCode="0">
                  <c:v>115</c:v>
                </c:pt>
                <c:pt idx="28" formatCode="0">
                  <c:v>120</c:v>
                </c:pt>
                <c:pt idx="29" formatCode="0">
                  <c:v>125</c:v>
                </c:pt>
              </c:numCache>
            </c:numRef>
          </c:cat>
          <c:val>
            <c:numRef>
              <c:f>'Nerica 4'!$E$36:$E$65</c:f>
              <c:numCache>
                <c:formatCode>General</c:formatCode>
                <c:ptCount val="30"/>
                <c:pt idx="12">
                  <c:v>77.0833333333333</c:v>
                </c:pt>
                <c:pt idx="13">
                  <c:v>79.8333333333333</c:v>
                </c:pt>
                <c:pt idx="14">
                  <c:v>76.5</c:v>
                </c:pt>
                <c:pt idx="15">
                  <c:v>75.166666666666671</c:v>
                </c:pt>
                <c:pt idx="16">
                  <c:v>69.5</c:v>
                </c:pt>
                <c:pt idx="17">
                  <c:v>67.4166666666667</c:v>
                </c:pt>
                <c:pt idx="18">
                  <c:v>64.666666666666671</c:v>
                </c:pt>
                <c:pt idx="19">
                  <c:v>60.083333333333343</c:v>
                </c:pt>
                <c:pt idx="20">
                  <c:v>58.833333333333343</c:v>
                </c:pt>
                <c:pt idx="21">
                  <c:v>55.333333333333343</c:v>
                </c:pt>
                <c:pt idx="22">
                  <c:v>54.416666666666622</c:v>
                </c:pt>
                <c:pt idx="23">
                  <c:v>60.333333333333343</c:v>
                </c:pt>
                <c:pt idx="24">
                  <c:v>61.66666666666664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dropLines>
          <c:spPr>
            <a:ln w="9525" cap="flat" cmpd="sng" algn="ctr">
              <a:solidFill>
                <a:schemeClr val="dk1">
                  <a:lumMod val="35000"/>
                  <a:lumOff val="65000"/>
                  <a:alpha val="33000"/>
                </a:schemeClr>
              </a:solidFill>
              <a:round/>
            </a:ln>
            <a:effectLst/>
          </c:spPr>
        </c:dropLines>
        <c:smooth val="0"/>
        <c:axId val="325982072"/>
        <c:axId val="327224792"/>
      </c:lineChart>
      <c:dateAx>
        <c:axId val="32598207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1197" b="1" i="0" u="none" strike="noStrike" kern="1200" cap="all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CO" dirty="0" err="1" smtClean="0"/>
                  <a:t>Days</a:t>
                </a:r>
                <a:r>
                  <a:rPr lang="es-CO" dirty="0" smtClean="0"/>
                  <a:t> </a:t>
                </a:r>
                <a:r>
                  <a:rPr lang="es-CO" dirty="0" err="1" smtClean="0"/>
                  <a:t>After</a:t>
                </a:r>
                <a:r>
                  <a:rPr lang="es-CO" dirty="0" smtClean="0"/>
                  <a:t> </a:t>
                </a:r>
                <a:r>
                  <a:rPr lang="es-CO" dirty="0" err="1" smtClean="0"/>
                  <a:t>Sowing</a:t>
                </a:r>
                <a:endParaRPr lang="es-CO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1197" b="1" i="0" u="none" strike="noStrike" kern="1200" cap="all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1" i="0" u="none" strike="noStrike" kern="1200" spc="2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27224792"/>
        <c:crosses val="autoZero"/>
        <c:auto val="0"/>
        <c:lblOffset val="100"/>
        <c:baseTimeUnit val="days"/>
        <c:majorUnit val="10"/>
        <c:majorTimeUnit val="days"/>
      </c:dateAx>
      <c:valAx>
        <c:axId val="32722479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197" b="1" i="0" u="none" strike="noStrike" kern="1200" cap="all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CO" dirty="0" err="1" smtClean="0"/>
                  <a:t>Moisture</a:t>
                </a:r>
                <a:r>
                  <a:rPr lang="es-CO" dirty="0" smtClean="0"/>
                  <a:t> (%)</a:t>
                </a:r>
                <a:endParaRPr lang="es-CO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197" b="1" i="0" u="none" strike="noStrike" kern="1200" cap="all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1" i="0" u="none" strike="noStrike" kern="1200" spc="2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25982072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82512454811073099"/>
          <c:y val="0.12691025369386699"/>
          <c:w val="0.154312852571104"/>
          <c:h val="0.5775175942358260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197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lt1"/>
    </a:solidFill>
    <a:ln>
      <a:noFill/>
    </a:ln>
    <a:effectLst/>
  </c:spPr>
  <c:txPr>
    <a:bodyPr/>
    <a:lstStyle/>
    <a:p>
      <a:pPr>
        <a:defRPr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4912515109449698E-2"/>
          <c:y val="6.0394865041563203E-2"/>
          <c:w val="0.77752422591792802"/>
          <c:h val="0.72954000249302797"/>
        </c:manualLayout>
      </c:layout>
      <c:lineChart>
        <c:grouping val="standard"/>
        <c:varyColors val="0"/>
        <c:ser>
          <c:idx val="1"/>
          <c:order val="0"/>
          <c:tx>
            <c:strRef>
              <c:f>'Nerica 4 DREB'!$D$135</c:f>
              <c:strCache>
                <c:ptCount val="1"/>
                <c:pt idx="0">
                  <c:v>20 cm</c:v>
                </c:pt>
              </c:strCache>
            </c:strRef>
          </c:tx>
          <c:spPr>
            <a:ln w="12700" cap="rnd" cmpd="sng" algn="ctr">
              <a:solidFill>
                <a:schemeClr val="tx1"/>
              </a:solidFill>
              <a:prstDash val="lgDashDot"/>
              <a:round/>
            </a:ln>
            <a:effectLst/>
          </c:spPr>
          <c:marker>
            <c:symbol val="none"/>
          </c:marker>
          <c:cat>
            <c:numRef>
              <c:f>'Nerica 4 DREB'!$C$136:$C$162</c:f>
              <c:numCache>
                <c:formatCode>General</c:formatCode>
                <c:ptCount val="2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 formatCode="0">
                  <c:v>58.476249999999709</c:v>
                </c:pt>
                <c:pt idx="11" formatCode="0">
                  <c:v>63.410150462965248</c:v>
                </c:pt>
                <c:pt idx="12" formatCode="0">
                  <c:v>66.404374999998254</c:v>
                </c:pt>
                <c:pt idx="13" formatCode="0">
                  <c:v>70.421261574076198</c:v>
                </c:pt>
                <c:pt idx="14" formatCode="0">
                  <c:v>73.404398148144509</c:v>
                </c:pt>
                <c:pt idx="15" formatCode="0">
                  <c:v>77.376099537039366</c:v>
                </c:pt>
                <c:pt idx="16" formatCode="0">
                  <c:v>80.380416666666846</c:v>
                </c:pt>
                <c:pt idx="17" formatCode="0">
                  <c:v>83.368113425924093</c:v>
                </c:pt>
                <c:pt idx="18" formatCode="0">
                  <c:v>86.387847222220415</c:v>
                </c:pt>
                <c:pt idx="19" formatCode="0">
                  <c:v>90.387789351851055</c:v>
                </c:pt>
                <c:pt idx="20" formatCode="0">
                  <c:v>93.378067129626245</c:v>
                </c:pt>
                <c:pt idx="21">
                  <c:v>100</c:v>
                </c:pt>
                <c:pt idx="22">
                  <c:v>105</c:v>
                </c:pt>
                <c:pt idx="23">
                  <c:v>110</c:v>
                </c:pt>
                <c:pt idx="24">
                  <c:v>115</c:v>
                </c:pt>
                <c:pt idx="25">
                  <c:v>120</c:v>
                </c:pt>
                <c:pt idx="26">
                  <c:v>125</c:v>
                </c:pt>
              </c:numCache>
            </c:numRef>
          </c:cat>
          <c:val>
            <c:numRef>
              <c:f>'Nerica 4 DREB'!$D$136:$D$163</c:f>
              <c:numCache>
                <c:formatCode>General</c:formatCode>
                <c:ptCount val="28"/>
                <c:pt idx="10">
                  <c:v>79.874999999999986</c:v>
                </c:pt>
                <c:pt idx="11">
                  <c:v>65.75</c:v>
                </c:pt>
                <c:pt idx="12">
                  <c:v>60.625</c:v>
                </c:pt>
                <c:pt idx="13">
                  <c:v>68.5</c:v>
                </c:pt>
                <c:pt idx="14">
                  <c:v>60.25</c:v>
                </c:pt>
                <c:pt idx="15">
                  <c:v>58.75</c:v>
                </c:pt>
                <c:pt idx="16">
                  <c:v>59.125</c:v>
                </c:pt>
                <c:pt idx="17">
                  <c:v>60.875</c:v>
                </c:pt>
                <c:pt idx="18">
                  <c:v>51.125</c:v>
                </c:pt>
                <c:pt idx="19">
                  <c:v>50.125</c:v>
                </c:pt>
                <c:pt idx="20">
                  <c:v>44.25</c:v>
                </c:pt>
              </c:numCache>
            </c:numRef>
          </c:val>
          <c:smooth val="0"/>
        </c:ser>
        <c:ser>
          <c:idx val="2"/>
          <c:order val="1"/>
          <c:tx>
            <c:strRef>
              <c:f>'Nerica 4 DREB'!$E$135</c:f>
              <c:strCache>
                <c:ptCount val="1"/>
                <c:pt idx="0">
                  <c:v>40 cm</c:v>
                </c:pt>
              </c:strCache>
            </c:strRef>
          </c:tx>
          <c:spPr>
            <a:ln w="12700" cap="rnd" cmpd="sng" algn="ctr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none"/>
          </c:marker>
          <c:cat>
            <c:numRef>
              <c:f>'Nerica 4 DREB'!$C$136:$C$162</c:f>
              <c:numCache>
                <c:formatCode>General</c:formatCode>
                <c:ptCount val="2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 formatCode="0">
                  <c:v>58.476249999999709</c:v>
                </c:pt>
                <c:pt idx="11" formatCode="0">
                  <c:v>63.410150462965248</c:v>
                </c:pt>
                <c:pt idx="12" formatCode="0">
                  <c:v>66.404374999998254</c:v>
                </c:pt>
                <c:pt idx="13" formatCode="0">
                  <c:v>70.421261574076198</c:v>
                </c:pt>
                <c:pt idx="14" formatCode="0">
                  <c:v>73.404398148144509</c:v>
                </c:pt>
                <c:pt idx="15" formatCode="0">
                  <c:v>77.376099537039366</c:v>
                </c:pt>
                <c:pt idx="16" formatCode="0">
                  <c:v>80.380416666666846</c:v>
                </c:pt>
                <c:pt idx="17" formatCode="0">
                  <c:v>83.368113425924093</c:v>
                </c:pt>
                <c:pt idx="18" formatCode="0">
                  <c:v>86.387847222220415</c:v>
                </c:pt>
                <c:pt idx="19" formatCode="0">
                  <c:v>90.387789351851055</c:v>
                </c:pt>
                <c:pt idx="20" formatCode="0">
                  <c:v>93.378067129626245</c:v>
                </c:pt>
                <c:pt idx="21">
                  <c:v>100</c:v>
                </c:pt>
                <c:pt idx="22">
                  <c:v>105</c:v>
                </c:pt>
                <c:pt idx="23">
                  <c:v>110</c:v>
                </c:pt>
                <c:pt idx="24">
                  <c:v>115</c:v>
                </c:pt>
                <c:pt idx="25">
                  <c:v>120</c:v>
                </c:pt>
                <c:pt idx="26">
                  <c:v>125</c:v>
                </c:pt>
              </c:numCache>
            </c:numRef>
          </c:cat>
          <c:val>
            <c:numRef>
              <c:f>'Nerica 4 DREB'!$E$136:$E$163</c:f>
              <c:numCache>
                <c:formatCode>General</c:formatCode>
                <c:ptCount val="28"/>
                <c:pt idx="10">
                  <c:v>88</c:v>
                </c:pt>
                <c:pt idx="11">
                  <c:v>82.25</c:v>
                </c:pt>
                <c:pt idx="12">
                  <c:v>83.25</c:v>
                </c:pt>
                <c:pt idx="13">
                  <c:v>83.374999999999986</c:v>
                </c:pt>
                <c:pt idx="14">
                  <c:v>79.874999999999986</c:v>
                </c:pt>
                <c:pt idx="15">
                  <c:v>82.75</c:v>
                </c:pt>
                <c:pt idx="16">
                  <c:v>81.624999999999986</c:v>
                </c:pt>
                <c:pt idx="17">
                  <c:v>83.25</c:v>
                </c:pt>
                <c:pt idx="18">
                  <c:v>76.75</c:v>
                </c:pt>
                <c:pt idx="19">
                  <c:v>73.374999999999986</c:v>
                </c:pt>
                <c:pt idx="20">
                  <c:v>74.624999999999986</c:v>
                </c:pt>
              </c:numCache>
            </c:numRef>
          </c:val>
          <c:smooth val="0"/>
        </c:ser>
        <c:ser>
          <c:idx val="3"/>
          <c:order val="2"/>
          <c:tx>
            <c:strRef>
              <c:f>'Nerica 4 DREB'!$F$135</c:f>
              <c:strCache>
                <c:ptCount val="1"/>
                <c:pt idx="0">
                  <c:v>60 cm</c:v>
                </c:pt>
              </c:strCache>
            </c:strRef>
          </c:tx>
          <c:spPr>
            <a:ln w="12700" cap="rnd" cmpd="sng" algn="ctr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'Nerica 4 DREB'!$C$136:$C$162</c:f>
              <c:numCache>
                <c:formatCode>General</c:formatCode>
                <c:ptCount val="2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 formatCode="0">
                  <c:v>58.476249999999709</c:v>
                </c:pt>
                <c:pt idx="11" formatCode="0">
                  <c:v>63.410150462965248</c:v>
                </c:pt>
                <c:pt idx="12" formatCode="0">
                  <c:v>66.404374999998254</c:v>
                </c:pt>
                <c:pt idx="13" formatCode="0">
                  <c:v>70.421261574076198</c:v>
                </c:pt>
                <c:pt idx="14" formatCode="0">
                  <c:v>73.404398148144509</c:v>
                </c:pt>
                <c:pt idx="15" formatCode="0">
                  <c:v>77.376099537039366</c:v>
                </c:pt>
                <c:pt idx="16" formatCode="0">
                  <c:v>80.380416666666846</c:v>
                </c:pt>
                <c:pt idx="17" formatCode="0">
                  <c:v>83.368113425924093</c:v>
                </c:pt>
                <c:pt idx="18" formatCode="0">
                  <c:v>86.387847222220415</c:v>
                </c:pt>
                <c:pt idx="19" formatCode="0">
                  <c:v>90.387789351851055</c:v>
                </c:pt>
                <c:pt idx="20" formatCode="0">
                  <c:v>93.378067129626245</c:v>
                </c:pt>
                <c:pt idx="21">
                  <c:v>100</c:v>
                </c:pt>
                <c:pt idx="22">
                  <c:v>105</c:v>
                </c:pt>
                <c:pt idx="23">
                  <c:v>110</c:v>
                </c:pt>
                <c:pt idx="24">
                  <c:v>115</c:v>
                </c:pt>
                <c:pt idx="25">
                  <c:v>120</c:v>
                </c:pt>
                <c:pt idx="26">
                  <c:v>125</c:v>
                </c:pt>
              </c:numCache>
            </c:numRef>
          </c:cat>
          <c:val>
            <c:numRef>
              <c:f>'Nerica 4 DREB'!$F$136:$F$163</c:f>
              <c:numCache>
                <c:formatCode>General</c:formatCode>
                <c:ptCount val="28"/>
                <c:pt idx="10">
                  <c:v>87</c:v>
                </c:pt>
                <c:pt idx="11">
                  <c:v>81.624999999999986</c:v>
                </c:pt>
                <c:pt idx="12">
                  <c:v>83.5</c:v>
                </c:pt>
                <c:pt idx="13">
                  <c:v>84</c:v>
                </c:pt>
                <c:pt idx="14">
                  <c:v>82.75</c:v>
                </c:pt>
                <c:pt idx="15">
                  <c:v>83.25</c:v>
                </c:pt>
                <c:pt idx="16">
                  <c:v>82.25</c:v>
                </c:pt>
                <c:pt idx="17">
                  <c:v>82.624999999999986</c:v>
                </c:pt>
                <c:pt idx="18">
                  <c:v>78.124999999999986</c:v>
                </c:pt>
                <c:pt idx="19">
                  <c:v>75.75</c:v>
                </c:pt>
                <c:pt idx="20">
                  <c:v>78.374999999999986</c:v>
                </c:pt>
              </c:numCache>
            </c:numRef>
          </c:val>
          <c:smooth val="0"/>
        </c:ser>
        <c:ser>
          <c:idx val="4"/>
          <c:order val="3"/>
          <c:tx>
            <c:strRef>
              <c:f>'Nerica 4 DREB'!$G$135</c:f>
              <c:strCache>
                <c:ptCount val="1"/>
                <c:pt idx="0">
                  <c:v>80 cm</c:v>
                </c:pt>
              </c:strCache>
            </c:strRef>
          </c:tx>
          <c:spPr>
            <a:ln w="12700" cap="rnd" cmpd="sng" algn="ctr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none"/>
          </c:marker>
          <c:cat>
            <c:numRef>
              <c:f>'Nerica 4 DREB'!$C$136:$C$162</c:f>
              <c:numCache>
                <c:formatCode>General</c:formatCode>
                <c:ptCount val="2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 formatCode="0">
                  <c:v>58.476249999999709</c:v>
                </c:pt>
                <c:pt idx="11" formatCode="0">
                  <c:v>63.410150462965248</c:v>
                </c:pt>
                <c:pt idx="12" formatCode="0">
                  <c:v>66.404374999998254</c:v>
                </c:pt>
                <c:pt idx="13" formatCode="0">
                  <c:v>70.421261574076198</c:v>
                </c:pt>
                <c:pt idx="14" formatCode="0">
                  <c:v>73.404398148144509</c:v>
                </c:pt>
                <c:pt idx="15" formatCode="0">
                  <c:v>77.376099537039366</c:v>
                </c:pt>
                <c:pt idx="16" formatCode="0">
                  <c:v>80.380416666666846</c:v>
                </c:pt>
                <c:pt idx="17" formatCode="0">
                  <c:v>83.368113425924093</c:v>
                </c:pt>
                <c:pt idx="18" formatCode="0">
                  <c:v>86.387847222220415</c:v>
                </c:pt>
                <c:pt idx="19" formatCode="0">
                  <c:v>90.387789351851055</c:v>
                </c:pt>
                <c:pt idx="20" formatCode="0">
                  <c:v>93.378067129626245</c:v>
                </c:pt>
                <c:pt idx="21">
                  <c:v>100</c:v>
                </c:pt>
                <c:pt idx="22">
                  <c:v>105</c:v>
                </c:pt>
                <c:pt idx="23">
                  <c:v>110</c:v>
                </c:pt>
                <c:pt idx="24">
                  <c:v>115</c:v>
                </c:pt>
                <c:pt idx="25">
                  <c:v>120</c:v>
                </c:pt>
                <c:pt idx="26">
                  <c:v>125</c:v>
                </c:pt>
              </c:numCache>
            </c:numRef>
          </c:cat>
          <c:val>
            <c:numRef>
              <c:f>'Nerica 4 DREB'!$G$136:$G$163</c:f>
              <c:numCache>
                <c:formatCode>General</c:formatCode>
                <c:ptCount val="28"/>
                <c:pt idx="10">
                  <c:v>85.75</c:v>
                </c:pt>
                <c:pt idx="11">
                  <c:v>82</c:v>
                </c:pt>
                <c:pt idx="12">
                  <c:v>85.624999999999986</c:v>
                </c:pt>
                <c:pt idx="13">
                  <c:v>84.25</c:v>
                </c:pt>
                <c:pt idx="14">
                  <c:v>84.374999999999986</c:v>
                </c:pt>
                <c:pt idx="15">
                  <c:v>85.374999999999986</c:v>
                </c:pt>
                <c:pt idx="16">
                  <c:v>86.374999999999986</c:v>
                </c:pt>
                <c:pt idx="17">
                  <c:v>86.25</c:v>
                </c:pt>
                <c:pt idx="18">
                  <c:v>80.5</c:v>
                </c:pt>
                <c:pt idx="19">
                  <c:v>79.75</c:v>
                </c:pt>
                <c:pt idx="20">
                  <c:v>80.624999999999986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dropLines>
          <c:spPr>
            <a:ln w="9525" cap="flat" cmpd="sng" algn="ctr">
              <a:solidFill>
                <a:schemeClr val="dk1">
                  <a:lumMod val="35000"/>
                  <a:lumOff val="65000"/>
                  <a:alpha val="33000"/>
                </a:schemeClr>
              </a:solidFill>
              <a:round/>
            </a:ln>
            <a:effectLst/>
          </c:spPr>
        </c:dropLines>
        <c:smooth val="0"/>
        <c:axId val="327225576"/>
        <c:axId val="327225968"/>
      </c:lineChart>
      <c:dateAx>
        <c:axId val="32722557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1197" b="1" i="0" u="none" strike="noStrike" kern="1200" cap="all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CO" dirty="0" err="1" smtClean="0"/>
                  <a:t>Days</a:t>
                </a:r>
                <a:r>
                  <a:rPr lang="es-CO" dirty="0" smtClean="0"/>
                  <a:t> </a:t>
                </a:r>
                <a:r>
                  <a:rPr lang="es-CO" dirty="0" err="1" smtClean="0"/>
                  <a:t>After</a:t>
                </a:r>
                <a:r>
                  <a:rPr lang="es-CO" dirty="0" smtClean="0"/>
                  <a:t> </a:t>
                </a:r>
                <a:r>
                  <a:rPr lang="es-CO" dirty="0" err="1" smtClean="0"/>
                  <a:t>Sowing</a:t>
                </a:r>
                <a:endParaRPr lang="es-CO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1197" b="1" i="0" u="none" strike="noStrike" kern="1200" cap="all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1" i="0" u="none" strike="noStrike" kern="1200" spc="2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27225968"/>
        <c:crosses val="autoZero"/>
        <c:auto val="0"/>
        <c:lblOffset val="100"/>
        <c:baseTimeUnit val="days"/>
        <c:majorUnit val="10"/>
        <c:majorTimeUnit val="days"/>
      </c:dateAx>
      <c:valAx>
        <c:axId val="32722596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197" b="1" i="0" u="none" strike="noStrike" kern="1200" cap="all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CO" dirty="0" err="1" smtClean="0"/>
                  <a:t>Moisture</a:t>
                </a:r>
                <a:r>
                  <a:rPr lang="es-CO" dirty="0" smtClean="0"/>
                  <a:t> (%)</a:t>
                </a:r>
                <a:endParaRPr lang="es-CO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197" b="1" i="0" u="none" strike="noStrike" kern="1200" cap="all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97" b="1" i="0" u="none" strike="noStrike" kern="1200" spc="2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27225576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81562258862104198"/>
          <c:y val="0.102403651691824"/>
          <c:w val="0.17458573426240201"/>
          <c:h val="0.6244013293624780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197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5!$B$1:$K$1</c:f>
              <c:strCache>
                <c:ptCount val="10"/>
                <c:pt idx="0">
                  <c:v>mRNA</c:v>
                </c:pt>
                <c:pt idx="1">
                  <c:v>SPY 2012-rainy</c:v>
                </c:pt>
                <c:pt idx="2">
                  <c:v>SPY 2012-dry</c:v>
                </c:pt>
                <c:pt idx="3">
                  <c:v>SPY 2014-rainy</c:v>
                </c:pt>
                <c:pt idx="4">
                  <c:v>GY 2012-13</c:v>
                </c:pt>
                <c:pt idx="5">
                  <c:v>GY 2013-14</c:v>
                </c:pt>
                <c:pt idx="6">
                  <c:v>GY 2014-2015</c:v>
                </c:pt>
                <c:pt idx="7">
                  <c:v>mRNA</c:v>
                </c:pt>
                <c:pt idx="8">
                  <c:v>GY 2013-14</c:v>
                </c:pt>
                <c:pt idx="9">
                  <c:v>GY 2014-2015</c:v>
                </c:pt>
              </c:strCache>
            </c:strRef>
          </c:cat>
          <c:val>
            <c:numRef>
              <c:f>Sheet5!$B$2:$K$2</c:f>
              <c:numCache>
                <c:formatCode>General</c:formatCode>
                <c:ptCount val="10"/>
                <c:pt idx="0" formatCode="0.00_);[Red]\(0.00\)">
                  <c:v>0.72</c:v>
                </c:pt>
                <c:pt idx="1">
                  <c:v>0.39</c:v>
                </c:pt>
                <c:pt idx="2" formatCode="0_ ">
                  <c:v>-0.05</c:v>
                </c:pt>
                <c:pt idx="3">
                  <c:v>0.34</c:v>
                </c:pt>
                <c:pt idx="4">
                  <c:v>0.14000000000000001</c:v>
                </c:pt>
                <c:pt idx="5">
                  <c:v>0.16</c:v>
                </c:pt>
                <c:pt idx="6">
                  <c:v>0.65</c:v>
                </c:pt>
                <c:pt idx="7">
                  <c:v>0.94</c:v>
                </c:pt>
                <c:pt idx="8">
                  <c:v>0.57999999999999996</c:v>
                </c:pt>
                <c:pt idx="9">
                  <c:v>0.3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27226752"/>
        <c:axId val="327227144"/>
      </c:barChart>
      <c:catAx>
        <c:axId val="32722675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 rot="0" vert="eaVert" anchor="ctr" anchorCtr="1"/>
          <a:lstStyle/>
          <a:p>
            <a:pPr>
              <a:defRPr lang="ja-JP" b="1">
                <a:latin typeface="Arial"/>
                <a:cs typeface="Arial"/>
              </a:defRPr>
            </a:pPr>
            <a:endParaRPr lang="en-US"/>
          </a:p>
        </c:txPr>
        <c:crossAx val="327227144"/>
        <c:crosses val="autoZero"/>
        <c:auto val="1"/>
        <c:lblAlgn val="ctr"/>
        <c:lblOffset val="100"/>
        <c:noMultiLvlLbl val="0"/>
      </c:catAx>
      <c:valAx>
        <c:axId val="32722714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ja-JP">
                    <a:latin typeface="Arial"/>
                    <a:cs typeface="Arial"/>
                  </a:defRPr>
                </a:pPr>
                <a:r>
                  <a:rPr lang="en-US" altLang="ja-JP" dirty="0" smtClean="0">
                    <a:latin typeface="Arial"/>
                    <a:cs typeface="Arial"/>
                  </a:rPr>
                  <a:t>Pearson’s coefficient of correlation</a:t>
                </a:r>
                <a:endParaRPr lang="ja-JP" altLang="en-US" dirty="0">
                  <a:latin typeface="Arial"/>
                  <a:cs typeface="Arial"/>
                </a:endParaRPr>
              </a:p>
            </c:rich>
          </c:tx>
          <c:layout/>
          <c:overlay val="0"/>
        </c:title>
        <c:numFmt formatCode="#,##0.00_ 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ja-JP" b="1">
                <a:latin typeface="Arial"/>
                <a:cs typeface="Arial"/>
              </a:defRPr>
            </a:pPr>
            <a:endParaRPr lang="en-US"/>
          </a:p>
        </c:txPr>
        <c:crossAx val="327226752"/>
        <c:crosses val="autoZero"/>
        <c:crossBetween val="between"/>
        <c:majorUnit val="0.2"/>
      </c:valAx>
      <c:spPr>
        <a:ln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layout>
        <c:manualLayout>
          <c:xMode val="edge"/>
          <c:yMode val="edge"/>
          <c:x val="0.442325299677433"/>
          <c:y val="0.21717592211592601"/>
        </c:manualLayout>
      </c:layout>
      <c:overlay val="0"/>
      <c:txPr>
        <a:bodyPr/>
        <a:lstStyle/>
        <a:p>
          <a:pPr>
            <a:defRPr lang="ja-JP" sz="1100"/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44479878297860398"/>
          <c:y val="0.211111111111111"/>
          <c:w val="0.50358373360753905"/>
          <c:h val="0.46160542432196"/>
        </c:manualLayout>
      </c:layout>
      <c:barChart>
        <c:barDir val="col"/>
        <c:grouping val="clustered"/>
        <c:varyColors val="0"/>
        <c:ser>
          <c:idx val="0"/>
          <c:order val="0"/>
          <c:tx>
            <c:v>LEA3</c:v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>
                  <a:alpha val="50000"/>
                </a:schemeClr>
              </a:solidFill>
            </a:ln>
          </c:spPr>
          <c:invertIfNegative val="0"/>
          <c:dLbls>
            <c:dLbl>
              <c:idx val="0"/>
              <c:layout>
                <c:manualLayout>
                  <c:x val="9.1743119266054999E-3"/>
                  <c:y val="9.7383247352701603E-3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numFmt formatCode="#,##0.0_);[Red]\(#,##0.0\)" sourceLinked="0"/>
            <c:spPr>
              <a:noFill/>
              <a:ln>
                <a:noFill/>
              </a:ln>
              <a:effectLst/>
            </c:spPr>
            <c:txPr>
              <a:bodyPr wrap="square" lIns="38100" tIns="19050" rIns="38100" bIns="19050" anchor="ctr">
                <a:spAutoFit/>
              </a:bodyPr>
              <a:lstStyle/>
              <a:p>
                <a:pPr>
                  <a:defRPr lang="ja-JP"/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[Marker gene expression%2c2017Feb.xlsx]Results2'!$F$27:$F$28</c:f>
                <c:numCache>
                  <c:formatCode>General</c:formatCode>
                  <c:ptCount val="2"/>
                  <c:pt idx="0">
                    <c:v>0.28607078712421802</c:v>
                  </c:pt>
                  <c:pt idx="1">
                    <c:v>319.9652799575137</c:v>
                  </c:pt>
                </c:numCache>
              </c:numRef>
            </c:plus>
            <c:minus>
              <c:numRef>
                <c:f>'[Marker gene expression%2c2017Feb.xlsx]Results2'!$F$27:$F$28</c:f>
                <c:numCache>
                  <c:formatCode>General</c:formatCode>
                  <c:ptCount val="2"/>
                  <c:pt idx="0">
                    <c:v>0.28607078712421802</c:v>
                  </c:pt>
                  <c:pt idx="1">
                    <c:v>319.9652799575137</c:v>
                  </c:pt>
                </c:numCache>
              </c:numRef>
            </c:minus>
          </c:errBars>
          <c:cat>
            <c:multiLvlStrRef>
              <c:f>'[Marker gene expression%2c2017Feb.xlsx]Results2'!$C$27:$D$28</c:f>
              <c:multiLvlStrCache>
                <c:ptCount val="2"/>
                <c:lvl>
                  <c:pt idx="0">
                    <c:v>Day-0</c:v>
                  </c:pt>
                  <c:pt idx="1">
                    <c:v>Day-4</c:v>
                  </c:pt>
                </c:lvl>
                <c:lvl>
                  <c:pt idx="0">
                    <c:v>NT Curinga
Drought</c:v>
                  </c:pt>
                </c:lvl>
              </c:multiLvlStrCache>
            </c:multiLvlStrRef>
          </c:cat>
          <c:val>
            <c:numRef>
              <c:f>'[Marker gene expression%2c2017Feb.xlsx]Results2'!$E$27:$E$28</c:f>
              <c:numCache>
                <c:formatCode>0</c:formatCode>
                <c:ptCount val="2"/>
                <c:pt idx="0">
                  <c:v>1</c:v>
                </c:pt>
                <c:pt idx="1">
                  <c:v>840.9991936727113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16877560"/>
        <c:axId val="317030472"/>
      </c:barChart>
      <c:catAx>
        <c:axId val="31687756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lang="ja-JP" sz="1000"/>
            </a:pPr>
            <a:endParaRPr lang="en-US"/>
          </a:p>
        </c:txPr>
        <c:crossAx val="317030472"/>
        <c:crossesAt val="0"/>
        <c:auto val="1"/>
        <c:lblAlgn val="ctr"/>
        <c:lblOffset val="100"/>
        <c:noMultiLvlLbl val="0"/>
      </c:catAx>
      <c:valAx>
        <c:axId val="317030472"/>
        <c:scaling>
          <c:orientation val="minMax"/>
          <c:max val="130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ja-JP" sz="1000"/>
                </a:pPr>
                <a:r>
                  <a:rPr lang="en-US" sz="1000" dirty="0"/>
                  <a:t>Relative mRNA level</a:t>
                </a:r>
                <a:endParaRPr lang="ja-JP" sz="1000" dirty="0"/>
              </a:p>
            </c:rich>
          </c:tx>
          <c:layout/>
          <c:overlay val="0"/>
        </c:title>
        <c:numFmt formatCode="#,##0_);[Red]\(#,##0\)" sourceLinked="0"/>
        <c:majorTickMark val="out"/>
        <c:minorTickMark val="none"/>
        <c:tickLblPos val="nextTo"/>
        <c:txPr>
          <a:bodyPr/>
          <a:lstStyle/>
          <a:p>
            <a:pPr>
              <a:defRPr lang="ja-JP" sz="1000" b="1"/>
            </a:pPr>
            <a:endParaRPr lang="en-US"/>
          </a:p>
        </c:txPr>
        <c:crossAx val="316877560"/>
        <c:crosses val="autoZero"/>
        <c:crossBetween val="between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txPr>
    <a:bodyPr/>
    <a:lstStyle/>
    <a:p>
      <a:pPr>
        <a:defRPr sz="1100" b="1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lang="ja-JP" sz="1100"/>
            </a:pPr>
            <a:r>
              <a:rPr lang="en-US" sz="1100"/>
              <a:t>ICL</a:t>
            </a:r>
          </a:p>
        </c:rich>
      </c:tx>
      <c:layout>
        <c:manualLayout>
          <c:xMode val="edge"/>
          <c:yMode val="edge"/>
          <c:x val="0.19794945890384399"/>
          <c:y val="0.138957852577546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01572153952259"/>
          <c:y val="0.130222654752426"/>
          <c:w val="0.78311439195464405"/>
          <c:h val="0.41740480421716802"/>
        </c:manualLayout>
      </c:layout>
      <c:barChart>
        <c:barDir val="col"/>
        <c:grouping val="clustered"/>
        <c:varyColors val="0"/>
        <c:ser>
          <c:idx val="0"/>
          <c:order val="0"/>
          <c:tx>
            <c:v>ICL1</c:v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>
                  <a:alpha val="50000"/>
                </a:schemeClr>
              </a:solidFill>
            </a:ln>
          </c:spPr>
          <c:invertIfNegative val="0"/>
          <c:dLbls>
            <c:dLbl>
              <c:idx val="6"/>
              <c:layout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wrap="square" lIns="38100" tIns="19050" rIns="38100" bIns="19050" anchor="ctr">
                <a:spAutoFit/>
              </a:bodyPr>
              <a:lstStyle/>
              <a:p>
                <a:pPr>
                  <a:defRPr lang="ja-JP"/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[Marker gene expression%2c2017Feb.xlsx]Results2'!$H$8:$H$21</c:f>
                <c:numCache>
                  <c:formatCode>General</c:formatCode>
                  <c:ptCount val="14"/>
                  <c:pt idx="0">
                    <c:v>8.5664495988414094E-2</c:v>
                  </c:pt>
                  <c:pt idx="1">
                    <c:v>3.0423064712089502E-2</c:v>
                  </c:pt>
                  <c:pt idx="2">
                    <c:v>9.21908895805678E-2</c:v>
                  </c:pt>
                  <c:pt idx="3">
                    <c:v>1.16777699155334E-2</c:v>
                  </c:pt>
                  <c:pt idx="4">
                    <c:v>7.7433791868364604E-2</c:v>
                  </c:pt>
                  <c:pt idx="5">
                    <c:v>0.50806995443021696</c:v>
                  </c:pt>
                  <c:pt idx="6">
                    <c:v>0.30558250389422698</c:v>
                  </c:pt>
                  <c:pt idx="7">
                    <c:v>4.4916648242945403E-2</c:v>
                  </c:pt>
                  <c:pt idx="8">
                    <c:v>8.2469464663513306E-2</c:v>
                  </c:pt>
                  <c:pt idx="9">
                    <c:v>1.50556625137334E-2</c:v>
                  </c:pt>
                  <c:pt idx="10">
                    <c:v>7.1288565739881196E-2</c:v>
                  </c:pt>
                  <c:pt idx="11">
                    <c:v>1.80380075012515E-2</c:v>
                  </c:pt>
                  <c:pt idx="12">
                    <c:v>6.8538357385344001E-2</c:v>
                  </c:pt>
                  <c:pt idx="13">
                    <c:v>7.4781055586486803E-2</c:v>
                  </c:pt>
                </c:numCache>
              </c:numRef>
            </c:plus>
            <c:minus>
              <c:numRef>
                <c:f>'[Marker gene expression%2c2017Feb.xlsx]Results2'!$H$8:$H$21</c:f>
                <c:numCache>
                  <c:formatCode>General</c:formatCode>
                  <c:ptCount val="14"/>
                  <c:pt idx="0">
                    <c:v>8.5664495988414094E-2</c:v>
                  </c:pt>
                  <c:pt idx="1">
                    <c:v>3.0423064712089502E-2</c:v>
                  </c:pt>
                  <c:pt idx="2">
                    <c:v>9.21908895805678E-2</c:v>
                  </c:pt>
                  <c:pt idx="3">
                    <c:v>1.16777699155334E-2</c:v>
                  </c:pt>
                  <c:pt idx="4">
                    <c:v>7.7433791868364604E-2</c:v>
                  </c:pt>
                  <c:pt idx="5">
                    <c:v>0.50806995443021696</c:v>
                  </c:pt>
                  <c:pt idx="6">
                    <c:v>0.30558250389422698</c:v>
                  </c:pt>
                  <c:pt idx="7">
                    <c:v>4.4916648242945403E-2</c:v>
                  </c:pt>
                  <c:pt idx="8">
                    <c:v>8.2469464663513306E-2</c:v>
                  </c:pt>
                  <c:pt idx="9">
                    <c:v>1.50556625137334E-2</c:v>
                  </c:pt>
                  <c:pt idx="10">
                    <c:v>7.1288565739881196E-2</c:v>
                  </c:pt>
                  <c:pt idx="11">
                    <c:v>1.80380075012515E-2</c:v>
                  </c:pt>
                  <c:pt idx="12">
                    <c:v>6.8538357385344001E-2</c:v>
                  </c:pt>
                  <c:pt idx="13">
                    <c:v>7.4781055586486803E-2</c:v>
                  </c:pt>
                </c:numCache>
              </c:numRef>
            </c:minus>
          </c:errBars>
          <c:cat>
            <c:multiLvlStrRef>
              <c:f>'[Marker gene expression%2c2017Feb.xlsx]Results2'!$B$8:$D$21</c:f>
              <c:multiLvlStrCache>
                <c:ptCount val="14"/>
                <c:lvl>
                  <c:pt idx="0">
                    <c:v>2580</c:v>
                  </c:pt>
                  <c:pt idx="1">
                    <c:v>2590</c:v>
                  </c:pt>
                  <c:pt idx="2">
                    <c:v>2783</c:v>
                  </c:pt>
                  <c:pt idx="3">
                    <c:v>3020</c:v>
                  </c:pt>
                  <c:pt idx="4">
                    <c:v>3025</c:v>
                  </c:pt>
                  <c:pt idx="5">
                    <c:v>3214</c:v>
                  </c:pt>
                  <c:pt idx="6">
                    <c:v>NT</c:v>
                  </c:pt>
                  <c:pt idx="7">
                    <c:v>1575</c:v>
                  </c:pt>
                  <c:pt idx="8">
                    <c:v>1577</c:v>
                  </c:pt>
                  <c:pt idx="9">
                    <c:v>2054</c:v>
                  </c:pt>
                  <c:pt idx="10">
                    <c:v>2344</c:v>
                  </c:pt>
                  <c:pt idx="11">
                    <c:v>2361</c:v>
                  </c:pt>
                  <c:pt idx="12">
                    <c:v>2362</c:v>
                  </c:pt>
                  <c:pt idx="13">
                    <c:v>NT</c:v>
                  </c:pt>
                </c:lvl>
                <c:lvl>
                  <c:pt idx="0">
                    <c:v>Curinga</c:v>
                  </c:pt>
                  <c:pt idx="7">
                    <c:v>NERICA4</c:v>
                  </c:pt>
                </c:lvl>
                <c:lvl>
                  <c:pt idx="0">
                    <c:v>Well-watered</c:v>
                  </c:pt>
                </c:lvl>
              </c:multiLvlStrCache>
            </c:multiLvlStrRef>
          </c:cat>
          <c:val>
            <c:numRef>
              <c:f>'[Marker gene expression%2c2017Feb.xlsx]Results2'!$G$8:$G$21</c:f>
              <c:numCache>
                <c:formatCode>#,#00</c:formatCode>
                <c:ptCount val="14"/>
                <c:pt idx="0">
                  <c:v>1.96908110485824</c:v>
                </c:pt>
                <c:pt idx="1">
                  <c:v>0.33670379922888299</c:v>
                </c:pt>
                <c:pt idx="2">
                  <c:v>0.30239520749183302</c:v>
                </c:pt>
                <c:pt idx="3">
                  <c:v>1.9806350403329901E-2</c:v>
                </c:pt>
                <c:pt idx="4">
                  <c:v>0.99630610140633802</c:v>
                </c:pt>
                <c:pt idx="5">
                  <c:v>3.2911281507446728</c:v>
                </c:pt>
                <c:pt idx="6">
                  <c:v>1</c:v>
                </c:pt>
                <c:pt idx="7">
                  <c:v>0.834356566845602</c:v>
                </c:pt>
                <c:pt idx="8">
                  <c:v>1.2027841777266159</c:v>
                </c:pt>
                <c:pt idx="9">
                  <c:v>9.4556432756360401E-2</c:v>
                </c:pt>
                <c:pt idx="10">
                  <c:v>0.20590347612527199</c:v>
                </c:pt>
                <c:pt idx="11">
                  <c:v>0.19279545038589399</c:v>
                </c:pt>
                <c:pt idx="12">
                  <c:v>1.088005915091556</c:v>
                </c:pt>
                <c:pt idx="13">
                  <c:v>0.6836958831839029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17014000"/>
        <c:axId val="317097512"/>
      </c:barChart>
      <c:catAx>
        <c:axId val="31701400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lang="ja-JP" sz="1050"/>
            </a:pPr>
            <a:endParaRPr lang="en-US"/>
          </a:p>
        </c:txPr>
        <c:crossAx val="317097512"/>
        <c:crossesAt val="0"/>
        <c:auto val="1"/>
        <c:lblAlgn val="ctr"/>
        <c:lblOffset val="100"/>
        <c:noMultiLvlLbl val="0"/>
      </c:catAx>
      <c:valAx>
        <c:axId val="317097512"/>
        <c:scaling>
          <c:orientation val="minMax"/>
          <c:max val="1000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ja-JP"/>
                </a:pPr>
                <a:r>
                  <a:rPr lang="en-US"/>
                  <a:t>Relative mRNA level</a:t>
                </a:r>
                <a:endParaRPr lang="ja-JP"/>
              </a:p>
            </c:rich>
          </c:tx>
          <c:layout>
            <c:manualLayout>
              <c:xMode val="edge"/>
              <c:yMode val="edge"/>
              <c:x val="6.7496749821970306E-2"/>
              <c:y val="0.10486362093408701"/>
            </c:manualLayout>
          </c:layout>
          <c:overlay val="0"/>
        </c:title>
        <c:numFmt formatCode="#,##0_);[Red]\(#,##0\)" sourceLinked="0"/>
        <c:majorTickMark val="out"/>
        <c:minorTickMark val="none"/>
        <c:tickLblPos val="nextTo"/>
        <c:txPr>
          <a:bodyPr/>
          <a:lstStyle/>
          <a:p>
            <a:pPr>
              <a:defRPr lang="ja-JP" sz="1000"/>
            </a:pPr>
            <a:endParaRPr lang="en-US"/>
          </a:p>
        </c:txPr>
        <c:crossAx val="317014000"/>
        <c:crosses val="autoZero"/>
        <c:crossBetween val="between"/>
        <c:majorUnit val="2000"/>
        <c:minorUnit val="400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txPr>
    <a:bodyPr/>
    <a:lstStyle/>
    <a:p>
      <a:pPr>
        <a:defRPr sz="1100" b="1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 lang="ja-JP" sz="1100"/>
            </a:pPr>
            <a:r>
              <a:rPr lang="en-US" sz="1100"/>
              <a:t>ICL</a:t>
            </a:r>
          </a:p>
        </c:rich>
      </c:tx>
      <c:layout>
        <c:manualLayout>
          <c:xMode val="edge"/>
          <c:yMode val="edge"/>
          <c:x val="0.43521563977834099"/>
          <c:y val="0.20611741335089001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42510188810780902"/>
          <c:y val="0.211111111111111"/>
          <c:w val="0.52507574540900404"/>
          <c:h val="0.46160542432196"/>
        </c:manualLayout>
      </c:layout>
      <c:barChart>
        <c:barDir val="col"/>
        <c:grouping val="clustered"/>
        <c:varyColors val="0"/>
        <c:ser>
          <c:idx val="0"/>
          <c:order val="0"/>
          <c:tx>
            <c:v>ICL1</c:v>
          </c:tx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>
                    <a:alpha val="50000"/>
                  </a:schemeClr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50000"/>
                </a:schemeClr>
              </a:solidFill>
              <a:ln>
                <a:solidFill>
                  <a:schemeClr val="tx1">
                    <a:alpha val="50000"/>
                  </a:schemeClr>
                </a:solidFill>
              </a:ln>
            </c:spPr>
          </c:dPt>
          <c:dLbls>
            <c:dLbl>
              <c:idx val="0"/>
              <c:layout>
                <c:manualLayout>
                  <c:x val="8.4096887832793305E-17"/>
                  <c:y val="1.1176350800978299E-3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numFmt formatCode="#,##0.0_);[Red]\(#,##0.0\)" sourceLinked="0"/>
            <c:spPr>
              <a:noFill/>
              <a:ln>
                <a:noFill/>
              </a:ln>
              <a:effectLst/>
            </c:spPr>
            <c:txPr>
              <a:bodyPr wrap="square" lIns="38100" tIns="19050" rIns="38100" bIns="19050" anchor="ctr">
                <a:spAutoFit/>
              </a:bodyPr>
              <a:lstStyle/>
              <a:p>
                <a:pPr>
                  <a:defRPr lang="ja-JP"/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[Marker gene expression%2c2017Feb.xlsx]Results2'!$H$27:$H$28</c:f>
                <c:numCache>
                  <c:formatCode>General</c:formatCode>
                  <c:ptCount val="2"/>
                  <c:pt idx="0">
                    <c:v>1.3178354743171981</c:v>
                  </c:pt>
                  <c:pt idx="1">
                    <c:v>315.57225272760257</c:v>
                  </c:pt>
                </c:numCache>
              </c:numRef>
            </c:plus>
            <c:minus>
              <c:numRef>
                <c:f>'[Marker gene expression%2c2017Feb.xlsx]Results2'!$H$27:$H$28</c:f>
                <c:numCache>
                  <c:formatCode>General</c:formatCode>
                  <c:ptCount val="2"/>
                  <c:pt idx="0">
                    <c:v>1.3178354743171981</c:v>
                  </c:pt>
                  <c:pt idx="1">
                    <c:v>315.57225272760257</c:v>
                  </c:pt>
                </c:numCache>
              </c:numRef>
            </c:minus>
          </c:errBars>
          <c:cat>
            <c:multiLvlStrRef>
              <c:f>'[Marker gene expression%2c2017Feb.xlsx]Results2'!$C$27:$D$28</c:f>
              <c:multiLvlStrCache>
                <c:ptCount val="2"/>
                <c:lvl>
                  <c:pt idx="0">
                    <c:v>Day-0</c:v>
                  </c:pt>
                  <c:pt idx="1">
                    <c:v>Day-4</c:v>
                  </c:pt>
                </c:lvl>
                <c:lvl>
                  <c:pt idx="0">
                    <c:v>NT Curinga
Drought</c:v>
                  </c:pt>
                </c:lvl>
              </c:multiLvlStrCache>
            </c:multiLvlStrRef>
          </c:cat>
          <c:val>
            <c:numRef>
              <c:f>'[Marker gene expression%2c2017Feb.xlsx]Results2'!$G$27:$G$28</c:f>
              <c:numCache>
                <c:formatCode>0</c:formatCode>
                <c:ptCount val="2"/>
                <c:pt idx="0">
                  <c:v>1</c:v>
                </c:pt>
                <c:pt idx="1">
                  <c:v>9259.42373929786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16871384"/>
        <c:axId val="317075552"/>
      </c:barChart>
      <c:catAx>
        <c:axId val="31687138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en-US"/>
          </a:p>
        </c:txPr>
        <c:crossAx val="317075552"/>
        <c:crossesAt val="0"/>
        <c:auto val="1"/>
        <c:lblAlgn val="ctr"/>
        <c:lblOffset val="100"/>
        <c:noMultiLvlLbl val="0"/>
      </c:catAx>
      <c:valAx>
        <c:axId val="317075552"/>
        <c:scaling>
          <c:orientation val="minMax"/>
          <c:max val="1000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ja-JP"/>
                </a:pPr>
                <a:r>
                  <a:rPr lang="en-US"/>
                  <a:t>Relative mRNA level</a:t>
                </a:r>
                <a:endParaRPr lang="ja-JP"/>
              </a:p>
            </c:rich>
          </c:tx>
          <c:layout>
            <c:manualLayout>
              <c:xMode val="edge"/>
              <c:yMode val="edge"/>
              <c:x val="1.4953112572800799E-2"/>
              <c:y val="0.17675839522716499"/>
            </c:manualLayout>
          </c:layout>
          <c:overlay val="0"/>
        </c:title>
        <c:numFmt formatCode="#,##0_);[Red]\(#,##0\)" sourceLinked="0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en-US"/>
          </a:p>
        </c:txPr>
        <c:crossAx val="316871384"/>
        <c:crosses val="autoZero"/>
        <c:crossBetween val="between"/>
        <c:minorUnit val="2000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txPr>
    <a:bodyPr/>
    <a:lstStyle/>
    <a:p>
      <a:pPr>
        <a:defRPr sz="1000" b="1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layout>
        <c:manualLayout>
          <c:xMode val="edge"/>
          <c:yMode val="edge"/>
          <c:x val="0.18460141387436099"/>
          <c:y val="0.16537467700258399"/>
        </c:manualLayout>
      </c:layout>
      <c:overlay val="0"/>
      <c:txPr>
        <a:bodyPr/>
        <a:lstStyle/>
        <a:p>
          <a:pPr>
            <a:defRPr lang="ja-JP" sz="1100"/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85153936049965"/>
          <c:y val="0.16018518518518499"/>
          <c:w val="0.77738433243289795"/>
          <c:h val="0.33332804329691401"/>
        </c:manualLayout>
      </c:layout>
      <c:barChart>
        <c:barDir val="col"/>
        <c:grouping val="clustered"/>
        <c:varyColors val="0"/>
        <c:ser>
          <c:idx val="0"/>
          <c:order val="0"/>
          <c:tx>
            <c:v>NAC6</c:v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>
                  <a:alpha val="50000"/>
                </a:schemeClr>
              </a:solidFill>
            </a:ln>
          </c:spPr>
          <c:invertIfNegative val="0"/>
          <c:dLbls>
            <c:dLbl>
              <c:idx val="6"/>
              <c:layout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wrap="square" lIns="38100" tIns="19050" rIns="38100" bIns="19050" anchor="ctr">
                <a:spAutoFit/>
              </a:bodyPr>
              <a:lstStyle/>
              <a:p>
                <a:pPr>
                  <a:defRPr lang="ja-JP"/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[Marker gene expression%2c2017Feb.xlsx]Results2'!$J$8:$J$21</c:f>
                <c:numCache>
                  <c:formatCode>General</c:formatCode>
                  <c:ptCount val="14"/>
                  <c:pt idx="0">
                    <c:v>0.41167969815766903</c:v>
                  </c:pt>
                  <c:pt idx="1">
                    <c:v>0.314001551759234</c:v>
                  </c:pt>
                  <c:pt idx="2">
                    <c:v>0.46613844935743398</c:v>
                  </c:pt>
                  <c:pt idx="3">
                    <c:v>0.15024062613591799</c:v>
                  </c:pt>
                  <c:pt idx="4">
                    <c:v>0.124382560948716</c:v>
                  </c:pt>
                  <c:pt idx="5">
                    <c:v>0.33013516756404898</c:v>
                  </c:pt>
                  <c:pt idx="6">
                    <c:v>8.5733696249932101E-2</c:v>
                  </c:pt>
                  <c:pt idx="7">
                    <c:v>0.42258697622241598</c:v>
                  </c:pt>
                  <c:pt idx="8">
                    <c:v>0.25114315311876301</c:v>
                  </c:pt>
                  <c:pt idx="9">
                    <c:v>7.6875612006799293E-2</c:v>
                  </c:pt>
                  <c:pt idx="10">
                    <c:v>0.22119097833175999</c:v>
                  </c:pt>
                  <c:pt idx="11">
                    <c:v>5.0715586887450897E-2</c:v>
                  </c:pt>
                  <c:pt idx="12">
                    <c:v>0.132109996483498</c:v>
                  </c:pt>
                  <c:pt idx="13">
                    <c:v>4.0696817288881498E-2</c:v>
                  </c:pt>
                </c:numCache>
              </c:numRef>
            </c:plus>
            <c:minus>
              <c:numRef>
                <c:f>'[Marker gene expression%2c2017Feb.xlsx]Results2'!$J$8:$J$21</c:f>
                <c:numCache>
                  <c:formatCode>General</c:formatCode>
                  <c:ptCount val="14"/>
                  <c:pt idx="0">
                    <c:v>0.41167969815766903</c:v>
                  </c:pt>
                  <c:pt idx="1">
                    <c:v>0.314001551759234</c:v>
                  </c:pt>
                  <c:pt idx="2">
                    <c:v>0.46613844935743398</c:v>
                  </c:pt>
                  <c:pt idx="3">
                    <c:v>0.15024062613591799</c:v>
                  </c:pt>
                  <c:pt idx="4">
                    <c:v>0.124382560948716</c:v>
                  </c:pt>
                  <c:pt idx="5">
                    <c:v>0.33013516756404898</c:v>
                  </c:pt>
                  <c:pt idx="6">
                    <c:v>8.5733696249932101E-2</c:v>
                  </c:pt>
                  <c:pt idx="7">
                    <c:v>0.42258697622241598</c:v>
                  </c:pt>
                  <c:pt idx="8">
                    <c:v>0.25114315311876301</c:v>
                  </c:pt>
                  <c:pt idx="9">
                    <c:v>7.6875612006799293E-2</c:v>
                  </c:pt>
                  <c:pt idx="10">
                    <c:v>0.22119097833175999</c:v>
                  </c:pt>
                  <c:pt idx="11">
                    <c:v>5.0715586887450897E-2</c:v>
                  </c:pt>
                  <c:pt idx="12">
                    <c:v>0.132109996483498</c:v>
                  </c:pt>
                  <c:pt idx="13">
                    <c:v>4.0696817288881498E-2</c:v>
                  </c:pt>
                </c:numCache>
              </c:numRef>
            </c:minus>
          </c:errBars>
          <c:cat>
            <c:multiLvlStrRef>
              <c:f>'[Marker gene expression%2c2017Feb.xlsx]Results2'!$B$8:$D$21</c:f>
              <c:multiLvlStrCache>
                <c:ptCount val="14"/>
                <c:lvl>
                  <c:pt idx="0">
                    <c:v>2580</c:v>
                  </c:pt>
                  <c:pt idx="1">
                    <c:v>2590</c:v>
                  </c:pt>
                  <c:pt idx="2">
                    <c:v>2783</c:v>
                  </c:pt>
                  <c:pt idx="3">
                    <c:v>3020</c:v>
                  </c:pt>
                  <c:pt idx="4">
                    <c:v>3025</c:v>
                  </c:pt>
                  <c:pt idx="5">
                    <c:v>3214</c:v>
                  </c:pt>
                  <c:pt idx="6">
                    <c:v>NT</c:v>
                  </c:pt>
                  <c:pt idx="7">
                    <c:v>1575</c:v>
                  </c:pt>
                  <c:pt idx="8">
                    <c:v>1577</c:v>
                  </c:pt>
                  <c:pt idx="9">
                    <c:v>2054</c:v>
                  </c:pt>
                  <c:pt idx="10">
                    <c:v>2344</c:v>
                  </c:pt>
                  <c:pt idx="11">
                    <c:v>2361</c:v>
                  </c:pt>
                  <c:pt idx="12">
                    <c:v>2362</c:v>
                  </c:pt>
                  <c:pt idx="13">
                    <c:v>NT</c:v>
                  </c:pt>
                </c:lvl>
                <c:lvl>
                  <c:pt idx="0">
                    <c:v>Curinga</c:v>
                  </c:pt>
                  <c:pt idx="7">
                    <c:v>NERICA4</c:v>
                  </c:pt>
                </c:lvl>
                <c:lvl>
                  <c:pt idx="0">
                    <c:v>Well-watered</c:v>
                  </c:pt>
                </c:lvl>
              </c:multiLvlStrCache>
            </c:multiLvlStrRef>
          </c:cat>
          <c:val>
            <c:numRef>
              <c:f>'[Marker gene expression%2c2017Feb.xlsx]Results2'!$I$8:$I$21</c:f>
              <c:numCache>
                <c:formatCode>#,#00</c:formatCode>
                <c:ptCount val="14"/>
                <c:pt idx="0">
                  <c:v>1.5999935024693721</c:v>
                </c:pt>
                <c:pt idx="1">
                  <c:v>1.820189188414373</c:v>
                </c:pt>
                <c:pt idx="2">
                  <c:v>2.032502536946049</c:v>
                </c:pt>
                <c:pt idx="3">
                  <c:v>2.1847861886867972</c:v>
                </c:pt>
                <c:pt idx="4">
                  <c:v>2.3106719925409371</c:v>
                </c:pt>
                <c:pt idx="5">
                  <c:v>2.719808054893889</c:v>
                </c:pt>
                <c:pt idx="6">
                  <c:v>1</c:v>
                </c:pt>
                <c:pt idx="7">
                  <c:v>2.6767700353544281</c:v>
                </c:pt>
                <c:pt idx="8">
                  <c:v>2.006420813469636</c:v>
                </c:pt>
                <c:pt idx="9">
                  <c:v>1.676186216051724</c:v>
                </c:pt>
                <c:pt idx="10">
                  <c:v>3.0888261493397891</c:v>
                </c:pt>
                <c:pt idx="11">
                  <c:v>1.0902466041207839</c:v>
                </c:pt>
                <c:pt idx="12">
                  <c:v>1.87325715525968</c:v>
                </c:pt>
                <c:pt idx="13">
                  <c:v>1.802171555788877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17076336"/>
        <c:axId val="317076728"/>
      </c:barChart>
      <c:catAx>
        <c:axId val="31707633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lang="ja-JP" sz="1050"/>
            </a:pPr>
            <a:endParaRPr lang="en-US"/>
          </a:p>
        </c:txPr>
        <c:crossAx val="317076728"/>
        <c:crosses val="autoZero"/>
        <c:auto val="1"/>
        <c:lblAlgn val="ctr"/>
        <c:lblOffset val="100"/>
        <c:noMultiLvlLbl val="0"/>
      </c:catAx>
      <c:valAx>
        <c:axId val="317076728"/>
        <c:scaling>
          <c:orientation val="minMax"/>
          <c:max val="7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ja-JP"/>
                </a:pPr>
                <a:r>
                  <a:rPr lang="en-US"/>
                  <a:t>Relative mRNA level</a:t>
                </a:r>
                <a:endParaRPr lang="ja-JP"/>
              </a:p>
            </c:rich>
          </c:tx>
          <c:layout>
            <c:manualLayout>
              <c:xMode val="edge"/>
              <c:yMode val="edge"/>
              <c:x val="5.2741153706151699E-2"/>
              <c:y val="0.11367352336771901"/>
            </c:manualLayout>
          </c:layout>
          <c:overlay val="0"/>
        </c:title>
        <c:numFmt formatCode="#,##0_);[Red]\(#,##0\)" sourceLinked="0"/>
        <c:majorTickMark val="out"/>
        <c:minorTickMark val="none"/>
        <c:tickLblPos val="nextTo"/>
        <c:txPr>
          <a:bodyPr/>
          <a:lstStyle/>
          <a:p>
            <a:pPr>
              <a:defRPr lang="ja-JP" sz="1000"/>
            </a:pPr>
            <a:endParaRPr lang="en-US"/>
          </a:p>
        </c:txPr>
        <c:crossAx val="317076336"/>
        <c:crosses val="autoZero"/>
        <c:crossBetween val="between"/>
        <c:majorUnit val="1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txPr>
    <a:bodyPr/>
    <a:lstStyle/>
    <a:p>
      <a:pPr>
        <a:defRPr sz="1100" b="1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layout>
        <c:manualLayout>
          <c:xMode val="edge"/>
          <c:yMode val="edge"/>
          <c:x val="0.40123877829309301"/>
          <c:y val="0.208754208754209"/>
        </c:manualLayout>
      </c:layout>
      <c:overlay val="0"/>
      <c:txPr>
        <a:bodyPr/>
        <a:lstStyle/>
        <a:p>
          <a:pPr>
            <a:defRPr lang="ja-JP" sz="1100"/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40227210443982903"/>
          <c:y val="0.211111111111111"/>
          <c:w val="0.489667565634682"/>
          <c:h val="0.46160542432196"/>
        </c:manualLayout>
      </c:layout>
      <c:barChart>
        <c:barDir val="col"/>
        <c:grouping val="clustered"/>
        <c:varyColors val="0"/>
        <c:ser>
          <c:idx val="0"/>
          <c:order val="0"/>
          <c:tx>
            <c:v>NAC6</c:v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>
                  <a:alpha val="50000"/>
                </a:schemeClr>
              </a:solidFill>
            </a:ln>
          </c:spPr>
          <c:invertIfNegative val="0"/>
          <c:dLbls>
            <c:dLbl>
              <c:idx val="0"/>
              <c:layout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wrap="square" lIns="38100" tIns="19050" rIns="38100" bIns="19050" anchor="ctr">
                <a:spAutoFit/>
              </a:bodyPr>
              <a:lstStyle/>
              <a:p>
                <a:pPr>
                  <a:defRPr lang="ja-JP"/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'[Marker gene expression%2c2017Feb.xlsx]Results2'!$J$27:$J$28</c:f>
                <c:numCache>
                  <c:formatCode>General</c:formatCode>
                  <c:ptCount val="2"/>
                  <c:pt idx="0">
                    <c:v>9.8595532268283201E-2</c:v>
                  </c:pt>
                  <c:pt idx="1">
                    <c:v>0.39001619677622901</c:v>
                  </c:pt>
                </c:numCache>
              </c:numRef>
            </c:plus>
            <c:minus>
              <c:numRef>
                <c:f>'[Marker gene expression%2c2017Feb.xlsx]Results2'!$J$27:$J$28</c:f>
                <c:numCache>
                  <c:formatCode>General</c:formatCode>
                  <c:ptCount val="2"/>
                  <c:pt idx="0">
                    <c:v>9.8595532268283201E-2</c:v>
                  </c:pt>
                  <c:pt idx="1">
                    <c:v>0.39001619677622901</c:v>
                  </c:pt>
                </c:numCache>
              </c:numRef>
            </c:minus>
          </c:errBars>
          <c:cat>
            <c:multiLvlStrRef>
              <c:f>'[Marker gene expression%2c2017Feb.xlsx]Results2'!$C$27:$D$28</c:f>
              <c:multiLvlStrCache>
                <c:ptCount val="2"/>
                <c:lvl>
                  <c:pt idx="0">
                    <c:v>Day-0</c:v>
                  </c:pt>
                  <c:pt idx="1">
                    <c:v>Day-4</c:v>
                  </c:pt>
                </c:lvl>
                <c:lvl>
                  <c:pt idx="0">
                    <c:v>NT Curinga
Drought</c:v>
                  </c:pt>
                </c:lvl>
              </c:multiLvlStrCache>
            </c:multiLvlStrRef>
          </c:cat>
          <c:val>
            <c:numRef>
              <c:f>'[Marker gene expression%2c2017Feb.xlsx]Results2'!$I$27:$I$28</c:f>
              <c:numCache>
                <c:formatCode>#,#00</c:formatCode>
                <c:ptCount val="2"/>
                <c:pt idx="0">
                  <c:v>1</c:v>
                </c:pt>
                <c:pt idx="1">
                  <c:v>5.667385873786924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17077512"/>
        <c:axId val="317077904"/>
      </c:barChart>
      <c:catAx>
        <c:axId val="31707751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lang="ja-JP" sz="1000"/>
            </a:pPr>
            <a:endParaRPr lang="en-US"/>
          </a:p>
        </c:txPr>
        <c:crossAx val="317077904"/>
        <c:crosses val="autoZero"/>
        <c:auto val="1"/>
        <c:lblAlgn val="ctr"/>
        <c:lblOffset val="100"/>
        <c:noMultiLvlLbl val="0"/>
      </c:catAx>
      <c:valAx>
        <c:axId val="31707790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ja-JP" sz="1000" b="1"/>
                </a:pPr>
                <a:r>
                  <a:rPr lang="en-US" sz="1000" b="1"/>
                  <a:t>Relative mRNA level</a:t>
                </a:r>
                <a:endParaRPr lang="ja-JP" sz="1000" b="1"/>
              </a:p>
            </c:rich>
          </c:tx>
          <c:layout>
            <c:manualLayout>
              <c:xMode val="edge"/>
              <c:yMode val="edge"/>
              <c:x val="3.3644856721113899E-2"/>
              <c:y val="0.18417508417508399"/>
            </c:manualLayout>
          </c:layout>
          <c:overlay val="0"/>
        </c:title>
        <c:numFmt formatCode="#,##0_);[Red]\(#,##0\)" sourceLinked="0"/>
        <c:majorTickMark val="out"/>
        <c:minorTickMark val="none"/>
        <c:tickLblPos val="nextTo"/>
        <c:txPr>
          <a:bodyPr/>
          <a:lstStyle/>
          <a:p>
            <a:pPr>
              <a:defRPr lang="ja-JP"/>
            </a:pPr>
            <a:endParaRPr lang="en-US"/>
          </a:p>
        </c:txPr>
        <c:crossAx val="317077512"/>
        <c:crosses val="autoZero"/>
        <c:crossBetween val="between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txPr>
    <a:bodyPr/>
    <a:lstStyle/>
    <a:p>
      <a:pPr>
        <a:defRPr sz="1100" b="1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7.8946584826272606E-2"/>
          <c:y val="6.2437480377860899E-2"/>
          <c:w val="0.75055797363630306"/>
          <c:h val="0.75533533986541201"/>
        </c:manualLayout>
      </c:layout>
      <c:lineChart>
        <c:grouping val="standard"/>
        <c:varyColors val="0"/>
        <c:ser>
          <c:idx val="0"/>
          <c:order val="0"/>
          <c:tx>
            <c:strRef>
              <c:f>'soil moisture'!$C$124</c:f>
              <c:strCache>
                <c:ptCount val="1"/>
                <c:pt idx="0">
                  <c:v>20 cm </c:v>
                </c:pt>
              </c:strCache>
            </c:strRef>
          </c:tx>
          <c:spPr>
            <a:ln w="12700" cap="rnd" cmpd="sng" algn="ctr">
              <a:solidFill>
                <a:schemeClr val="tx1"/>
              </a:solidFill>
              <a:prstDash val="lgDashDot"/>
              <a:round/>
            </a:ln>
            <a:effectLst/>
          </c:spPr>
          <c:marker>
            <c:symbol val="none"/>
          </c:marker>
          <c:cat>
            <c:numRef>
              <c:f>'soil moisture'!$D$123:$AD$123</c:f>
              <c:numCache>
                <c:formatCode>General</c:formatCode>
                <c:ptCount val="2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3</c:v>
                </c:pt>
                <c:pt idx="15">
                  <c:v>78</c:v>
                </c:pt>
                <c:pt idx="16">
                  <c:v>81</c:v>
                </c:pt>
                <c:pt idx="17">
                  <c:v>86</c:v>
                </c:pt>
                <c:pt idx="18">
                  <c:v>88</c:v>
                </c:pt>
                <c:pt idx="19">
                  <c:v>92</c:v>
                </c:pt>
                <c:pt idx="20">
                  <c:v>95</c:v>
                </c:pt>
                <c:pt idx="21">
                  <c:v>98</c:v>
                </c:pt>
                <c:pt idx="22">
                  <c:v>102</c:v>
                </c:pt>
                <c:pt idx="23">
                  <c:v>110</c:v>
                </c:pt>
                <c:pt idx="24">
                  <c:v>115</c:v>
                </c:pt>
                <c:pt idx="25">
                  <c:v>120</c:v>
                </c:pt>
                <c:pt idx="26">
                  <c:v>125</c:v>
                </c:pt>
              </c:numCache>
            </c:numRef>
          </c:cat>
          <c:val>
            <c:numRef>
              <c:f>'soil moisture'!$D$124:$AD$124</c:f>
              <c:numCache>
                <c:formatCode>General</c:formatCode>
                <c:ptCount val="27"/>
                <c:pt idx="14">
                  <c:v>73.179999999999978</c:v>
                </c:pt>
                <c:pt idx="15" formatCode="0.00">
                  <c:v>75.230769230769212</c:v>
                </c:pt>
                <c:pt idx="16" formatCode="0.00">
                  <c:v>67.925925925925924</c:v>
                </c:pt>
                <c:pt idx="17" formatCode="0.00">
                  <c:v>58.666666666666643</c:v>
                </c:pt>
                <c:pt idx="18" formatCode="0.00">
                  <c:v>53.777777777777779</c:v>
                </c:pt>
                <c:pt idx="19" formatCode="0.00">
                  <c:v>47.8888888888889</c:v>
                </c:pt>
                <c:pt idx="20" formatCode="0.00">
                  <c:v>42.925925925925952</c:v>
                </c:pt>
                <c:pt idx="21" formatCode="0.00">
                  <c:v>38.703703703703702</c:v>
                </c:pt>
                <c:pt idx="22" formatCode="0.00">
                  <c:v>59.925925925925952</c:v>
                </c:pt>
              </c:numCache>
            </c:numRef>
          </c:val>
          <c:smooth val="1"/>
        </c:ser>
        <c:ser>
          <c:idx val="1"/>
          <c:order val="1"/>
          <c:tx>
            <c:strRef>
              <c:f>'soil moisture'!$C$125</c:f>
              <c:strCache>
                <c:ptCount val="1"/>
                <c:pt idx="0">
                  <c:v>40 cm </c:v>
                </c:pt>
              </c:strCache>
            </c:strRef>
          </c:tx>
          <c:spPr>
            <a:ln w="12700" cap="rnd" cmpd="sng" algn="ctr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none"/>
          </c:marker>
          <c:cat>
            <c:numRef>
              <c:f>'soil moisture'!$D$123:$AD$123</c:f>
              <c:numCache>
                <c:formatCode>General</c:formatCode>
                <c:ptCount val="2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3</c:v>
                </c:pt>
                <c:pt idx="15">
                  <c:v>78</c:v>
                </c:pt>
                <c:pt idx="16">
                  <c:v>81</c:v>
                </c:pt>
                <c:pt idx="17">
                  <c:v>86</c:v>
                </c:pt>
                <c:pt idx="18">
                  <c:v>88</c:v>
                </c:pt>
                <c:pt idx="19">
                  <c:v>92</c:v>
                </c:pt>
                <c:pt idx="20">
                  <c:v>95</c:v>
                </c:pt>
                <c:pt idx="21">
                  <c:v>98</c:v>
                </c:pt>
                <c:pt idx="22">
                  <c:v>102</c:v>
                </c:pt>
                <c:pt idx="23">
                  <c:v>110</c:v>
                </c:pt>
                <c:pt idx="24">
                  <c:v>115</c:v>
                </c:pt>
                <c:pt idx="25">
                  <c:v>120</c:v>
                </c:pt>
                <c:pt idx="26">
                  <c:v>125</c:v>
                </c:pt>
              </c:numCache>
            </c:numRef>
          </c:cat>
          <c:val>
            <c:numRef>
              <c:f>'soil moisture'!$D$125:$AD$125</c:f>
              <c:numCache>
                <c:formatCode>General</c:formatCode>
                <c:ptCount val="27"/>
                <c:pt idx="14" formatCode="0.00">
                  <c:v>84.185185185185176</c:v>
                </c:pt>
                <c:pt idx="15" formatCode="0.00">
                  <c:v>87</c:v>
                </c:pt>
                <c:pt idx="16" formatCode="0.00">
                  <c:v>80.148148148148152</c:v>
                </c:pt>
                <c:pt idx="17" formatCode="0.00">
                  <c:v>79.037037037037038</c:v>
                </c:pt>
                <c:pt idx="18" formatCode="0.00">
                  <c:v>73.851851851851762</c:v>
                </c:pt>
                <c:pt idx="19" formatCode="0.00">
                  <c:v>70.333333333333272</c:v>
                </c:pt>
                <c:pt idx="20" formatCode="0.00">
                  <c:v>69.6666666666667</c:v>
                </c:pt>
                <c:pt idx="21" formatCode="0.00">
                  <c:v>68.2222222222222</c:v>
                </c:pt>
                <c:pt idx="22" formatCode="0.00">
                  <c:v>66.740740740740705</c:v>
                </c:pt>
              </c:numCache>
            </c:numRef>
          </c:val>
          <c:smooth val="1"/>
        </c:ser>
        <c:ser>
          <c:idx val="2"/>
          <c:order val="2"/>
          <c:tx>
            <c:strRef>
              <c:f>'soil moisture'!$C$126</c:f>
              <c:strCache>
                <c:ptCount val="1"/>
                <c:pt idx="0">
                  <c:v>60 cm </c:v>
                </c:pt>
              </c:strCache>
            </c:strRef>
          </c:tx>
          <c:spPr>
            <a:ln w="12700" cap="rnd" cmpd="sng" algn="ctr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'soil moisture'!$D$123:$AD$123</c:f>
              <c:numCache>
                <c:formatCode>General</c:formatCode>
                <c:ptCount val="2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3</c:v>
                </c:pt>
                <c:pt idx="15">
                  <c:v>78</c:v>
                </c:pt>
                <c:pt idx="16">
                  <c:v>81</c:v>
                </c:pt>
                <c:pt idx="17">
                  <c:v>86</c:v>
                </c:pt>
                <c:pt idx="18">
                  <c:v>88</c:v>
                </c:pt>
                <c:pt idx="19">
                  <c:v>92</c:v>
                </c:pt>
                <c:pt idx="20">
                  <c:v>95</c:v>
                </c:pt>
                <c:pt idx="21">
                  <c:v>98</c:v>
                </c:pt>
                <c:pt idx="22">
                  <c:v>102</c:v>
                </c:pt>
                <c:pt idx="23">
                  <c:v>110</c:v>
                </c:pt>
                <c:pt idx="24">
                  <c:v>115</c:v>
                </c:pt>
                <c:pt idx="25">
                  <c:v>120</c:v>
                </c:pt>
                <c:pt idx="26">
                  <c:v>125</c:v>
                </c:pt>
              </c:numCache>
            </c:numRef>
          </c:cat>
          <c:val>
            <c:numRef>
              <c:f>'soil moisture'!$D$126:$AD$126</c:f>
              <c:numCache>
                <c:formatCode>General</c:formatCode>
                <c:ptCount val="27"/>
                <c:pt idx="14" formatCode="0.00">
                  <c:v>84.538461538461476</c:v>
                </c:pt>
                <c:pt idx="15" formatCode="0.00">
                  <c:v>87.740740740740762</c:v>
                </c:pt>
                <c:pt idx="16" formatCode="0.00">
                  <c:v>81.666666666666671</c:v>
                </c:pt>
                <c:pt idx="17" formatCode="0.00">
                  <c:v>80.407407407407405</c:v>
                </c:pt>
                <c:pt idx="18" formatCode="0.00">
                  <c:v>80.629629629629633</c:v>
                </c:pt>
                <c:pt idx="19" formatCode="0.00">
                  <c:v>79.444444444444471</c:v>
                </c:pt>
                <c:pt idx="20" formatCode="0.00">
                  <c:v>80.074074074074048</c:v>
                </c:pt>
                <c:pt idx="21" formatCode="0.00">
                  <c:v>80.296296296296305</c:v>
                </c:pt>
                <c:pt idx="22" formatCode="0.00">
                  <c:v>81.259259259259267</c:v>
                </c:pt>
              </c:numCache>
            </c:numRef>
          </c:val>
          <c:smooth val="1"/>
        </c:ser>
        <c:ser>
          <c:idx val="6"/>
          <c:order val="3"/>
          <c:tx>
            <c:strRef>
              <c:f>'soil moisture'!$C$127</c:f>
              <c:strCache>
                <c:ptCount val="1"/>
                <c:pt idx="0">
                  <c:v>80 cm </c:v>
                </c:pt>
              </c:strCache>
            </c:strRef>
          </c:tx>
          <c:spPr>
            <a:ln w="12700" cap="rnd" cmpd="sng" algn="ctr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none"/>
          </c:marker>
          <c:cat>
            <c:numRef>
              <c:f>'soil moisture'!$D$123:$AD$123</c:f>
              <c:numCache>
                <c:formatCode>General</c:formatCode>
                <c:ptCount val="27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3</c:v>
                </c:pt>
                <c:pt idx="15">
                  <c:v>78</c:v>
                </c:pt>
                <c:pt idx="16">
                  <c:v>81</c:v>
                </c:pt>
                <c:pt idx="17">
                  <c:v>86</c:v>
                </c:pt>
                <c:pt idx="18">
                  <c:v>88</c:v>
                </c:pt>
                <c:pt idx="19">
                  <c:v>92</c:v>
                </c:pt>
                <c:pt idx="20">
                  <c:v>95</c:v>
                </c:pt>
                <c:pt idx="21">
                  <c:v>98</c:v>
                </c:pt>
                <c:pt idx="22">
                  <c:v>102</c:v>
                </c:pt>
                <c:pt idx="23">
                  <c:v>110</c:v>
                </c:pt>
                <c:pt idx="24">
                  <c:v>115</c:v>
                </c:pt>
                <c:pt idx="25">
                  <c:v>120</c:v>
                </c:pt>
                <c:pt idx="26">
                  <c:v>125</c:v>
                </c:pt>
              </c:numCache>
            </c:numRef>
          </c:cat>
          <c:val>
            <c:numRef>
              <c:f>'soil moisture'!$D$127:$AD$127</c:f>
              <c:numCache>
                <c:formatCode>General</c:formatCode>
                <c:ptCount val="27"/>
                <c:pt idx="14" formatCode="0.00">
                  <c:v>93</c:v>
                </c:pt>
                <c:pt idx="15" formatCode="0.00">
                  <c:v>94.074074074074048</c:v>
                </c:pt>
                <c:pt idx="16" formatCode="0.00">
                  <c:v>87.666666666666671</c:v>
                </c:pt>
                <c:pt idx="17" formatCode="0.00">
                  <c:v>86.444444444444471</c:v>
                </c:pt>
                <c:pt idx="18" formatCode="0.00">
                  <c:v>86.629629629629633</c:v>
                </c:pt>
                <c:pt idx="19" formatCode="0.00">
                  <c:v>86.222222222222229</c:v>
                </c:pt>
                <c:pt idx="20" formatCode="0.00">
                  <c:v>86.629629629629633</c:v>
                </c:pt>
                <c:pt idx="21" formatCode="0.00">
                  <c:v>86.592592592592553</c:v>
                </c:pt>
                <c:pt idx="22" formatCode="0.00">
                  <c:v>87.629629629629633</c:v>
                </c:pt>
              </c:numCache>
            </c:numRef>
          </c: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dropLines>
          <c:spPr>
            <a:ln w="12700" cap="flat" cmpd="sng" algn="ctr">
              <a:solidFill>
                <a:schemeClr val="tx1">
                  <a:alpha val="33000"/>
                </a:schemeClr>
              </a:solidFill>
              <a:prstDash val="dash"/>
              <a:round/>
            </a:ln>
            <a:effectLst/>
          </c:spPr>
        </c:dropLines>
        <c:smooth val="0"/>
        <c:axId val="325918480"/>
        <c:axId val="325918872"/>
      </c:lineChart>
      <c:dateAx>
        <c:axId val="32591848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1100" b="1" i="0" u="none" strike="noStrike" kern="1200" cap="all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Days After Sowing</a:t>
                </a:r>
              </a:p>
            </c:rich>
          </c:tx>
          <c:layout>
            <c:manualLayout>
              <c:xMode val="edge"/>
              <c:yMode val="edge"/>
              <c:x val="0.35804958018564897"/>
              <c:y val="0.9119887560991920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1100" b="1" i="0" u="none" strike="noStrike" kern="1200" cap="all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lang="ja-JP" sz="1100" b="1" i="0" u="none" strike="noStrike" kern="1200" spc="2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25918872"/>
        <c:crosses val="autoZero"/>
        <c:auto val="0"/>
        <c:lblOffset val="100"/>
        <c:baseTimeUnit val="days"/>
        <c:majorUnit val="10"/>
        <c:majorTimeUnit val="days"/>
      </c:dateAx>
      <c:valAx>
        <c:axId val="325918872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100" b="1" i="0" u="none" strike="noStrike" kern="1200" cap="all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/>
                  <a:t>Moisture (%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100" b="1" i="0" u="none" strike="noStrike" kern="1200" cap="all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lang="ja-JP" sz="1100" b="1" i="0" u="none" strike="noStrike" kern="1200" spc="2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25918480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83459824337107402"/>
          <c:y val="0.133007659331769"/>
          <c:w val="0.134021387222789"/>
          <c:h val="0.4958267114379860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1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lt1"/>
    </a:solidFill>
    <a:ln>
      <a:noFill/>
    </a:ln>
    <a:effectLst/>
  </c:spPr>
  <c:txPr>
    <a:bodyPr/>
    <a:lstStyle/>
    <a:p>
      <a:pPr>
        <a:defRPr sz="11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92812633938874E-2"/>
          <c:y val="0.125747056330721"/>
          <c:w val="0.75405612619552198"/>
          <c:h val="0.66194367358370398"/>
        </c:manualLayout>
      </c:layout>
      <c:lineChart>
        <c:grouping val="standard"/>
        <c:varyColors val="0"/>
        <c:ser>
          <c:idx val="0"/>
          <c:order val="0"/>
          <c:tx>
            <c:strRef>
              <c:f>'Soil moisture data'!$H$3</c:f>
              <c:strCache>
                <c:ptCount val="1"/>
                <c:pt idx="0">
                  <c:v>20 cm</c:v>
                </c:pt>
              </c:strCache>
            </c:strRef>
          </c:tx>
          <c:spPr>
            <a:ln w="12700" cap="rnd" cmpd="sng" algn="ctr">
              <a:solidFill>
                <a:schemeClr val="tx1"/>
              </a:solidFill>
              <a:prstDash val="lgDashDot"/>
              <a:round/>
            </a:ln>
            <a:effectLst/>
          </c:spPr>
          <c:marker>
            <c:symbol val="none"/>
          </c:marker>
          <c:cat>
            <c:numRef>
              <c:f>'Soil moisture data'!$I$2:$AG$2</c:f>
              <c:numCache>
                <c:formatCode>General</c:formatCode>
                <c:ptCount val="2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  <c:pt idx="15">
                  <c:v>76</c:v>
                </c:pt>
                <c:pt idx="16">
                  <c:v>89</c:v>
                </c:pt>
                <c:pt idx="17">
                  <c:v>91</c:v>
                </c:pt>
                <c:pt idx="18">
                  <c:v>96</c:v>
                </c:pt>
                <c:pt idx="19">
                  <c:v>101</c:v>
                </c:pt>
                <c:pt idx="20">
                  <c:v>104</c:v>
                </c:pt>
                <c:pt idx="21">
                  <c:v>109</c:v>
                </c:pt>
                <c:pt idx="22">
                  <c:v>115</c:v>
                </c:pt>
                <c:pt idx="23">
                  <c:v>120</c:v>
                </c:pt>
                <c:pt idx="24">
                  <c:v>125</c:v>
                </c:pt>
              </c:numCache>
            </c:numRef>
          </c:cat>
          <c:val>
            <c:numRef>
              <c:f>'Soil moisture data'!$I$3:$AG$3</c:f>
              <c:numCache>
                <c:formatCode>General</c:formatCode>
                <c:ptCount val="25"/>
                <c:pt idx="13">
                  <c:v>83.292682926829244</c:v>
                </c:pt>
                <c:pt idx="14">
                  <c:v>77.283950617283949</c:v>
                </c:pt>
                <c:pt idx="15">
                  <c:v>81.160493827160479</c:v>
                </c:pt>
                <c:pt idx="16">
                  <c:v>43.172839506172842</c:v>
                </c:pt>
                <c:pt idx="17">
                  <c:v>40.580246913580247</c:v>
                </c:pt>
                <c:pt idx="18">
                  <c:v>34.97530864197531</c:v>
                </c:pt>
                <c:pt idx="19">
                  <c:v>31.691358024691361</c:v>
                </c:pt>
                <c:pt idx="20">
                  <c:v>53.950617283950599</c:v>
                </c:pt>
                <c:pt idx="21">
                  <c:v>60.63</c:v>
                </c:pt>
              </c:numCache>
            </c:numRef>
          </c:val>
          <c:smooth val="1"/>
        </c:ser>
        <c:ser>
          <c:idx val="1"/>
          <c:order val="1"/>
          <c:tx>
            <c:strRef>
              <c:f>'Soil moisture data'!$H$4</c:f>
              <c:strCache>
                <c:ptCount val="1"/>
                <c:pt idx="0">
                  <c:v>40 cm</c:v>
                </c:pt>
              </c:strCache>
            </c:strRef>
          </c:tx>
          <c:spPr>
            <a:ln w="12700" cap="rnd" cmpd="sng" algn="ctr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none"/>
          </c:marker>
          <c:cat>
            <c:numRef>
              <c:f>'Soil moisture data'!$I$2:$AG$2</c:f>
              <c:numCache>
                <c:formatCode>General</c:formatCode>
                <c:ptCount val="2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  <c:pt idx="15">
                  <c:v>76</c:v>
                </c:pt>
                <c:pt idx="16">
                  <c:v>89</c:v>
                </c:pt>
                <c:pt idx="17">
                  <c:v>91</c:v>
                </c:pt>
                <c:pt idx="18">
                  <c:v>96</c:v>
                </c:pt>
                <c:pt idx="19">
                  <c:v>101</c:v>
                </c:pt>
                <c:pt idx="20">
                  <c:v>104</c:v>
                </c:pt>
                <c:pt idx="21">
                  <c:v>109</c:v>
                </c:pt>
                <c:pt idx="22">
                  <c:v>115</c:v>
                </c:pt>
                <c:pt idx="23">
                  <c:v>120</c:v>
                </c:pt>
                <c:pt idx="24">
                  <c:v>125</c:v>
                </c:pt>
              </c:numCache>
            </c:numRef>
          </c:cat>
          <c:val>
            <c:numRef>
              <c:f>'Soil moisture data'!$I$4:$AG$4</c:f>
              <c:numCache>
                <c:formatCode>General</c:formatCode>
                <c:ptCount val="25"/>
                <c:pt idx="13">
                  <c:v>89.5</c:v>
                </c:pt>
                <c:pt idx="14">
                  <c:v>85.987654320987701</c:v>
                </c:pt>
                <c:pt idx="15">
                  <c:v>87.956790123456727</c:v>
                </c:pt>
                <c:pt idx="16">
                  <c:v>61.592592592592602</c:v>
                </c:pt>
                <c:pt idx="17">
                  <c:v>58.586419753086389</c:v>
                </c:pt>
                <c:pt idx="18">
                  <c:v>52.90123456790122</c:v>
                </c:pt>
                <c:pt idx="19">
                  <c:v>50.086419753086389</c:v>
                </c:pt>
                <c:pt idx="20">
                  <c:v>71.9166666666667</c:v>
                </c:pt>
                <c:pt idx="21">
                  <c:v>72.63</c:v>
                </c:pt>
              </c:numCache>
            </c:numRef>
          </c:val>
          <c:smooth val="1"/>
        </c:ser>
        <c:ser>
          <c:idx val="2"/>
          <c:order val="2"/>
          <c:tx>
            <c:strRef>
              <c:f>'Soil moisture data'!$H$5</c:f>
              <c:strCache>
                <c:ptCount val="1"/>
                <c:pt idx="0">
                  <c:v>60 cm</c:v>
                </c:pt>
              </c:strCache>
            </c:strRef>
          </c:tx>
          <c:spPr>
            <a:ln w="12700" cap="rnd" cmpd="sng" algn="ctr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'Soil moisture data'!$I$2:$AG$2</c:f>
              <c:numCache>
                <c:formatCode>General</c:formatCode>
                <c:ptCount val="2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  <c:pt idx="15">
                  <c:v>76</c:v>
                </c:pt>
                <c:pt idx="16">
                  <c:v>89</c:v>
                </c:pt>
                <c:pt idx="17">
                  <c:v>91</c:v>
                </c:pt>
                <c:pt idx="18">
                  <c:v>96</c:v>
                </c:pt>
                <c:pt idx="19">
                  <c:v>101</c:v>
                </c:pt>
                <c:pt idx="20">
                  <c:v>104</c:v>
                </c:pt>
                <c:pt idx="21">
                  <c:v>109</c:v>
                </c:pt>
                <c:pt idx="22">
                  <c:v>115</c:v>
                </c:pt>
                <c:pt idx="23">
                  <c:v>120</c:v>
                </c:pt>
                <c:pt idx="24">
                  <c:v>125</c:v>
                </c:pt>
              </c:numCache>
            </c:numRef>
          </c:cat>
          <c:val>
            <c:numRef>
              <c:f>'Soil moisture data'!$I$5:$AG$5</c:f>
              <c:numCache>
                <c:formatCode>General</c:formatCode>
                <c:ptCount val="25"/>
                <c:pt idx="13">
                  <c:v>94.362804878048749</c:v>
                </c:pt>
                <c:pt idx="14">
                  <c:v>92.450617283950621</c:v>
                </c:pt>
                <c:pt idx="15">
                  <c:v>93.518518518518505</c:v>
                </c:pt>
                <c:pt idx="16">
                  <c:v>79.679012345678984</c:v>
                </c:pt>
                <c:pt idx="17">
                  <c:v>77.932098765432102</c:v>
                </c:pt>
                <c:pt idx="18">
                  <c:v>74.274691358024654</c:v>
                </c:pt>
                <c:pt idx="19">
                  <c:v>71.466049382716065</c:v>
                </c:pt>
                <c:pt idx="20">
                  <c:v>71.9166666666667</c:v>
                </c:pt>
                <c:pt idx="21">
                  <c:v>75.63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Soil moisture data'!$H$6</c:f>
              <c:strCache>
                <c:ptCount val="1"/>
                <c:pt idx="0">
                  <c:v>80 cm</c:v>
                </c:pt>
              </c:strCache>
            </c:strRef>
          </c:tx>
          <c:spPr>
            <a:ln w="12700" cap="rnd" cmpd="sng" algn="ctr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none"/>
          </c:marker>
          <c:cat>
            <c:numRef>
              <c:f>'Soil moisture data'!$I$2:$AG$2</c:f>
              <c:numCache>
                <c:formatCode>General</c:formatCode>
                <c:ptCount val="2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5</c:v>
                </c:pt>
                <c:pt idx="14">
                  <c:v>70</c:v>
                </c:pt>
                <c:pt idx="15">
                  <c:v>76</c:v>
                </c:pt>
                <c:pt idx="16">
                  <c:v>89</c:v>
                </c:pt>
                <c:pt idx="17">
                  <c:v>91</c:v>
                </c:pt>
                <c:pt idx="18">
                  <c:v>96</c:v>
                </c:pt>
                <c:pt idx="19">
                  <c:v>101</c:v>
                </c:pt>
                <c:pt idx="20">
                  <c:v>104</c:v>
                </c:pt>
                <c:pt idx="21">
                  <c:v>109</c:v>
                </c:pt>
                <c:pt idx="22">
                  <c:v>115</c:v>
                </c:pt>
                <c:pt idx="23">
                  <c:v>120</c:v>
                </c:pt>
                <c:pt idx="24">
                  <c:v>125</c:v>
                </c:pt>
              </c:numCache>
            </c:numRef>
          </c:cat>
          <c:val>
            <c:numRef>
              <c:f>'Soil moisture data'!$I$6:$AG$6</c:f>
              <c:numCache>
                <c:formatCode>General</c:formatCode>
                <c:ptCount val="25"/>
                <c:pt idx="13">
                  <c:v>94.362804878048749</c:v>
                </c:pt>
                <c:pt idx="14">
                  <c:v>92.450617283950621</c:v>
                </c:pt>
                <c:pt idx="15">
                  <c:v>93.518518518518505</c:v>
                </c:pt>
                <c:pt idx="16">
                  <c:v>79.679012345678984</c:v>
                </c:pt>
                <c:pt idx="17">
                  <c:v>77.932098765432102</c:v>
                </c:pt>
                <c:pt idx="18">
                  <c:v>74.274691358024654</c:v>
                </c:pt>
                <c:pt idx="19">
                  <c:v>71.466049382716065</c:v>
                </c:pt>
                <c:pt idx="20">
                  <c:v>81.9166666666667</c:v>
                </c:pt>
                <c:pt idx="21">
                  <c:v>82.63</c:v>
                </c:pt>
              </c:numCache>
            </c:numRef>
          </c: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dropLines>
          <c:spPr>
            <a:ln w="6350" cap="flat" cmpd="sng" algn="ctr">
              <a:solidFill>
                <a:schemeClr val="tx1">
                  <a:alpha val="33000"/>
                </a:schemeClr>
              </a:solidFill>
              <a:prstDash val="dash"/>
              <a:round/>
            </a:ln>
            <a:effectLst/>
          </c:spPr>
        </c:dropLines>
        <c:smooth val="0"/>
        <c:axId val="325919656"/>
        <c:axId val="325920048"/>
      </c:lineChart>
      <c:dateAx>
        <c:axId val="32591965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1100" b="1" i="0" u="none" strike="noStrike" kern="1200" cap="all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CO" dirty="0" err="1" smtClean="0"/>
                  <a:t>Days</a:t>
                </a:r>
                <a:r>
                  <a:rPr lang="es-CO" dirty="0" smtClean="0"/>
                  <a:t> </a:t>
                </a:r>
                <a:r>
                  <a:rPr lang="es-CO" dirty="0" err="1" smtClean="0"/>
                  <a:t>After</a:t>
                </a:r>
                <a:r>
                  <a:rPr lang="es-CO" dirty="0" smtClean="0"/>
                  <a:t> </a:t>
                </a:r>
                <a:r>
                  <a:rPr lang="es-CO" dirty="0" err="1" smtClean="0"/>
                  <a:t>Sowing</a:t>
                </a:r>
                <a:endParaRPr lang="es-CO" dirty="0"/>
              </a:p>
            </c:rich>
          </c:tx>
          <c:layout>
            <c:manualLayout>
              <c:xMode val="edge"/>
              <c:yMode val="edge"/>
              <c:x val="0.360263996331386"/>
              <c:y val="0.8768144155231959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1100" b="1" i="0" u="none" strike="noStrike" kern="1200" cap="all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1" i="0" u="none" strike="noStrike" kern="1200" spc="2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25920048"/>
        <c:crosses val="autoZero"/>
        <c:auto val="0"/>
        <c:lblOffset val="100"/>
        <c:baseTimeUnit val="days"/>
        <c:majorUnit val="10"/>
        <c:majorTimeUnit val="days"/>
      </c:dateAx>
      <c:valAx>
        <c:axId val="32592004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100" b="1" i="0" u="none" strike="noStrike" kern="1200" cap="all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CO" dirty="0" err="1" smtClean="0"/>
                  <a:t>Moisture</a:t>
                </a:r>
                <a:r>
                  <a:rPr lang="es-CO" dirty="0" smtClean="0"/>
                  <a:t> (%)</a:t>
                </a:r>
                <a:endParaRPr lang="es-CO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100" b="1" i="0" u="none" strike="noStrike" kern="1200" cap="all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1" i="0" u="none" strike="noStrike" kern="1200" spc="2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25919656"/>
        <c:crosses val="autoZero"/>
        <c:crossBetween val="between"/>
        <c:majorUnit val="20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842564912585684"/>
          <c:y val="0.25017307385075999"/>
          <c:w val="0.12413447319712"/>
          <c:h val="0.4815665596881559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1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7275529084254201E-2"/>
          <c:y val="7.1183631705883293E-2"/>
          <c:w val="0.75846218265156695"/>
          <c:h val="0.72900138953178895"/>
        </c:manualLayout>
      </c:layout>
      <c:lineChart>
        <c:grouping val="standard"/>
        <c:varyColors val="0"/>
        <c:ser>
          <c:idx val="1"/>
          <c:order val="0"/>
          <c:tx>
            <c:strRef>
              <c:f>Sheet2!$K$748</c:f>
              <c:strCache>
                <c:ptCount val="1"/>
                <c:pt idx="0">
                  <c:v>20 cm</c:v>
                </c:pt>
              </c:strCache>
            </c:strRef>
          </c:tx>
          <c:spPr>
            <a:ln w="12700" cap="rnd" cmpd="sng" algn="ctr">
              <a:solidFill>
                <a:schemeClr val="tx1"/>
              </a:solidFill>
              <a:prstDash val="lgDashDot"/>
              <a:round/>
            </a:ln>
            <a:effectLst/>
          </c:spPr>
          <c:marker>
            <c:symbol val="none"/>
          </c:marker>
          <c:cat>
            <c:numRef>
              <c:f>Sheet2!$I$749:$I$773</c:f>
              <c:numCache>
                <c:formatCode>General</c:formatCode>
                <c:ptCount val="2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3</c:v>
                </c:pt>
                <c:pt idx="14">
                  <c:v>70</c:v>
                </c:pt>
                <c:pt idx="15">
                  <c:v>76</c:v>
                </c:pt>
                <c:pt idx="16">
                  <c:v>89</c:v>
                </c:pt>
                <c:pt idx="17">
                  <c:v>91</c:v>
                </c:pt>
                <c:pt idx="18">
                  <c:v>96</c:v>
                </c:pt>
                <c:pt idx="19">
                  <c:v>101</c:v>
                </c:pt>
                <c:pt idx="20">
                  <c:v>104</c:v>
                </c:pt>
                <c:pt idx="21">
                  <c:v>109</c:v>
                </c:pt>
                <c:pt idx="22">
                  <c:v>115</c:v>
                </c:pt>
                <c:pt idx="23">
                  <c:v>120</c:v>
                </c:pt>
                <c:pt idx="24">
                  <c:v>125</c:v>
                </c:pt>
              </c:numCache>
            </c:numRef>
          </c:cat>
          <c:val>
            <c:numRef>
              <c:f>Sheet2!$K$749:$K$773</c:f>
              <c:numCache>
                <c:formatCode>General</c:formatCode>
                <c:ptCount val="25"/>
                <c:pt idx="13">
                  <c:v>83.292682926829244</c:v>
                </c:pt>
                <c:pt idx="14">
                  <c:v>77.357227840571085</c:v>
                </c:pt>
                <c:pt idx="15">
                  <c:v>81.160493827160479</c:v>
                </c:pt>
                <c:pt idx="16">
                  <c:v>43.172839506172842</c:v>
                </c:pt>
                <c:pt idx="17">
                  <c:v>40.580246913580247</c:v>
                </c:pt>
                <c:pt idx="18">
                  <c:v>34.97530864197531</c:v>
                </c:pt>
                <c:pt idx="19">
                  <c:v>31.691358024691361</c:v>
                </c:pt>
                <c:pt idx="20">
                  <c:v>39.520626317374301</c:v>
                </c:pt>
                <c:pt idx="21">
                  <c:v>30.283950617283949</c:v>
                </c:pt>
              </c:numCache>
            </c:numRef>
          </c:val>
          <c:smooth val="1"/>
        </c:ser>
        <c:ser>
          <c:idx val="2"/>
          <c:order val="1"/>
          <c:tx>
            <c:strRef>
              <c:f>Sheet2!$L$748</c:f>
              <c:strCache>
                <c:ptCount val="1"/>
                <c:pt idx="0">
                  <c:v>40 cm</c:v>
                </c:pt>
              </c:strCache>
            </c:strRef>
          </c:tx>
          <c:spPr>
            <a:ln w="12700" cap="rnd" cmpd="sng" algn="ctr">
              <a:solidFill>
                <a:schemeClr val="tx1"/>
              </a:solidFill>
              <a:prstDash val="dash"/>
              <a:round/>
            </a:ln>
            <a:effectLst/>
          </c:spPr>
          <c:marker>
            <c:symbol val="none"/>
          </c:marker>
          <c:cat>
            <c:numRef>
              <c:f>Sheet2!$I$749:$I$773</c:f>
              <c:numCache>
                <c:formatCode>General</c:formatCode>
                <c:ptCount val="2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3</c:v>
                </c:pt>
                <c:pt idx="14">
                  <c:v>70</c:v>
                </c:pt>
                <c:pt idx="15">
                  <c:v>76</c:v>
                </c:pt>
                <c:pt idx="16">
                  <c:v>89</c:v>
                </c:pt>
                <c:pt idx="17">
                  <c:v>91</c:v>
                </c:pt>
                <c:pt idx="18">
                  <c:v>96</c:v>
                </c:pt>
                <c:pt idx="19">
                  <c:v>101</c:v>
                </c:pt>
                <c:pt idx="20">
                  <c:v>104</c:v>
                </c:pt>
                <c:pt idx="21">
                  <c:v>109</c:v>
                </c:pt>
                <c:pt idx="22">
                  <c:v>115</c:v>
                </c:pt>
                <c:pt idx="23">
                  <c:v>120</c:v>
                </c:pt>
                <c:pt idx="24">
                  <c:v>125</c:v>
                </c:pt>
              </c:numCache>
            </c:numRef>
          </c:cat>
          <c:val>
            <c:numRef>
              <c:f>Sheet2!$L$749:$L$773</c:f>
              <c:numCache>
                <c:formatCode>General</c:formatCode>
                <c:ptCount val="25"/>
                <c:pt idx="13">
                  <c:v>95.707317073170728</c:v>
                </c:pt>
                <c:pt idx="14">
                  <c:v>94.703747769185014</c:v>
                </c:pt>
                <c:pt idx="15">
                  <c:v>94.753086419753075</c:v>
                </c:pt>
                <c:pt idx="16">
                  <c:v>80.012345679012356</c:v>
                </c:pt>
                <c:pt idx="17">
                  <c:v>76.592592592592553</c:v>
                </c:pt>
                <c:pt idx="18">
                  <c:v>70.827160493827165</c:v>
                </c:pt>
                <c:pt idx="19">
                  <c:v>68.481481481481481</c:v>
                </c:pt>
                <c:pt idx="20">
                  <c:v>68.286359530261947</c:v>
                </c:pt>
                <c:pt idx="21">
                  <c:v>66.037037037037038</c:v>
                </c:pt>
              </c:numCache>
            </c:numRef>
          </c:val>
          <c:smooth val="1"/>
        </c:ser>
        <c:ser>
          <c:idx val="3"/>
          <c:order val="2"/>
          <c:tx>
            <c:strRef>
              <c:f>Sheet2!$M$748</c:f>
              <c:strCache>
                <c:ptCount val="1"/>
                <c:pt idx="0">
                  <c:v>60 cm</c:v>
                </c:pt>
              </c:strCache>
            </c:strRef>
          </c:tx>
          <c:spPr>
            <a:ln w="12700" cap="rnd" cmpd="sng" algn="ctr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numRef>
              <c:f>Sheet2!$I$749:$I$773</c:f>
              <c:numCache>
                <c:formatCode>General</c:formatCode>
                <c:ptCount val="2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3</c:v>
                </c:pt>
                <c:pt idx="14">
                  <c:v>70</c:v>
                </c:pt>
                <c:pt idx="15">
                  <c:v>76</c:v>
                </c:pt>
                <c:pt idx="16">
                  <c:v>89</c:v>
                </c:pt>
                <c:pt idx="17">
                  <c:v>91</c:v>
                </c:pt>
                <c:pt idx="18">
                  <c:v>96</c:v>
                </c:pt>
                <c:pt idx="19">
                  <c:v>101</c:v>
                </c:pt>
                <c:pt idx="20">
                  <c:v>104</c:v>
                </c:pt>
                <c:pt idx="21">
                  <c:v>109</c:v>
                </c:pt>
                <c:pt idx="22">
                  <c:v>115</c:v>
                </c:pt>
                <c:pt idx="23">
                  <c:v>120</c:v>
                </c:pt>
                <c:pt idx="24">
                  <c:v>125</c:v>
                </c:pt>
              </c:numCache>
            </c:numRef>
          </c:cat>
          <c:val>
            <c:numRef>
              <c:f>Sheet2!$M$749:$M$773</c:f>
              <c:numCache>
                <c:formatCode>General</c:formatCode>
                <c:ptCount val="25"/>
                <c:pt idx="13">
                  <c:v>98.524390243902445</c:v>
                </c:pt>
                <c:pt idx="14">
                  <c:v>98.018590124925609</c:v>
                </c:pt>
                <c:pt idx="15">
                  <c:v>98.271604938271622</c:v>
                </c:pt>
                <c:pt idx="16">
                  <c:v>95.901234567901255</c:v>
                </c:pt>
                <c:pt idx="17">
                  <c:v>95.024691358024654</c:v>
                </c:pt>
                <c:pt idx="18">
                  <c:v>92.098765432098745</c:v>
                </c:pt>
                <c:pt idx="19">
                  <c:v>88</c:v>
                </c:pt>
                <c:pt idx="20">
                  <c:v>85.048780487804848</c:v>
                </c:pt>
                <c:pt idx="21">
                  <c:v>83.716049382716065</c:v>
                </c:pt>
              </c:numCache>
            </c:numRef>
          </c:val>
          <c:smooth val="1"/>
        </c:ser>
        <c:ser>
          <c:idx val="4"/>
          <c:order val="3"/>
          <c:tx>
            <c:strRef>
              <c:f>Sheet2!$N$748</c:f>
              <c:strCache>
                <c:ptCount val="1"/>
                <c:pt idx="0">
                  <c:v>80 cm</c:v>
                </c:pt>
              </c:strCache>
            </c:strRef>
          </c:tx>
          <c:spPr>
            <a:ln w="12700" cap="rnd" cmpd="sng" algn="ctr">
              <a:solidFill>
                <a:schemeClr val="tx1"/>
              </a:solidFill>
              <a:prstDash val="sysDot"/>
              <a:round/>
            </a:ln>
            <a:effectLst/>
          </c:spPr>
          <c:marker>
            <c:symbol val="none"/>
          </c:marker>
          <c:cat>
            <c:numRef>
              <c:f>Sheet2!$I$749:$I$773</c:f>
              <c:numCache>
                <c:formatCode>General</c:formatCode>
                <c:ptCount val="25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45</c:v>
                </c:pt>
                <c:pt idx="10">
                  <c:v>50</c:v>
                </c:pt>
                <c:pt idx="11">
                  <c:v>55</c:v>
                </c:pt>
                <c:pt idx="12">
                  <c:v>60</c:v>
                </c:pt>
                <c:pt idx="13">
                  <c:v>63</c:v>
                </c:pt>
                <c:pt idx="14">
                  <c:v>70</c:v>
                </c:pt>
                <c:pt idx="15">
                  <c:v>76</c:v>
                </c:pt>
                <c:pt idx="16">
                  <c:v>89</c:v>
                </c:pt>
                <c:pt idx="17">
                  <c:v>91</c:v>
                </c:pt>
                <c:pt idx="18">
                  <c:v>96</c:v>
                </c:pt>
                <c:pt idx="19">
                  <c:v>101</c:v>
                </c:pt>
                <c:pt idx="20">
                  <c:v>104</c:v>
                </c:pt>
                <c:pt idx="21">
                  <c:v>109</c:v>
                </c:pt>
                <c:pt idx="22">
                  <c:v>115</c:v>
                </c:pt>
                <c:pt idx="23">
                  <c:v>120</c:v>
                </c:pt>
                <c:pt idx="24">
                  <c:v>125</c:v>
                </c:pt>
              </c:numCache>
            </c:numRef>
          </c:cat>
          <c:val>
            <c:numRef>
              <c:f>Sheet2!$N$749:$N$773</c:f>
              <c:numCache>
                <c:formatCode>General</c:formatCode>
                <c:ptCount val="25"/>
                <c:pt idx="13">
                  <c:v>98</c:v>
                </c:pt>
                <c:pt idx="14">
                  <c:v>98</c:v>
                </c:pt>
                <c:pt idx="15">
                  <c:v>98</c:v>
                </c:pt>
                <c:pt idx="16">
                  <c:v>97</c:v>
                </c:pt>
                <c:pt idx="17">
                  <c:v>97</c:v>
                </c:pt>
                <c:pt idx="18">
                  <c:v>96</c:v>
                </c:pt>
                <c:pt idx="19">
                  <c:v>92</c:v>
                </c:pt>
                <c:pt idx="20">
                  <c:v>90</c:v>
                </c:pt>
                <c:pt idx="21">
                  <c:v>90</c:v>
                </c:pt>
              </c:numCache>
            </c:numRef>
          </c: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dropLines>
          <c:spPr>
            <a:ln w="6350" cap="flat" cmpd="sng" algn="ctr">
              <a:solidFill>
                <a:schemeClr val="tx1">
                  <a:alpha val="33000"/>
                </a:schemeClr>
              </a:solidFill>
              <a:prstDash val="dash"/>
              <a:round/>
            </a:ln>
            <a:effectLst/>
          </c:spPr>
        </c:dropLines>
        <c:smooth val="0"/>
        <c:axId val="325920832"/>
        <c:axId val="325921224"/>
      </c:lineChart>
      <c:dateAx>
        <c:axId val="32592083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lang="ja-JP" sz="1100" b="1" i="0" u="none" strike="noStrike" kern="1200" cap="all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CO" dirty="0" err="1" smtClean="0"/>
                  <a:t>Days</a:t>
                </a:r>
                <a:r>
                  <a:rPr lang="es-CO" dirty="0" smtClean="0"/>
                  <a:t> </a:t>
                </a:r>
                <a:r>
                  <a:rPr lang="es-CO" dirty="0" err="1" smtClean="0"/>
                  <a:t>After</a:t>
                </a:r>
                <a:r>
                  <a:rPr lang="es-CO" dirty="0" smtClean="0"/>
                  <a:t> </a:t>
                </a:r>
                <a:r>
                  <a:rPr lang="es-CO" dirty="0" err="1" smtClean="0"/>
                  <a:t>Sowing</a:t>
                </a:r>
                <a:endParaRPr lang="es-CO" dirty="0"/>
              </a:p>
            </c:rich>
          </c:tx>
          <c:layout>
            <c:manualLayout>
              <c:xMode val="edge"/>
              <c:yMode val="edge"/>
              <c:x val="0.35068351045937002"/>
              <c:y val="0.9027566349817549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lang="ja-JP" sz="1100" b="1" i="0" u="none" strike="noStrike" kern="1200" cap="all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1" i="0" u="none" strike="noStrike" kern="1200" spc="2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25921224"/>
        <c:crosses val="autoZero"/>
        <c:auto val="0"/>
        <c:lblOffset val="100"/>
        <c:baseTimeUnit val="days"/>
        <c:majorUnit val="10"/>
        <c:majorTimeUnit val="days"/>
      </c:dateAx>
      <c:valAx>
        <c:axId val="325921224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100" b="1" i="0" u="none" strike="noStrike" kern="1200" cap="all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CO" dirty="0" err="1" smtClean="0"/>
                  <a:t>Moisture</a:t>
                </a:r>
                <a:r>
                  <a:rPr lang="es-CO" dirty="0" smtClean="0"/>
                  <a:t> (%)</a:t>
                </a:r>
                <a:endParaRPr lang="es-CO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100" b="1" i="0" u="none" strike="noStrike" kern="1200" cap="all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100" b="1" i="0" u="none" strike="noStrike" kern="1200" spc="2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25920832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83951673934749005"/>
          <c:y val="0.203894181516553"/>
          <c:w val="0.116315186028975"/>
          <c:h val="0.5156824212316879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1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30">
  <cs:axisTitle>
    <cs:lnRef idx="0"/>
    <cs:fillRef idx="0"/>
    <cs:effectRef idx="0"/>
    <cs:fontRef idx="minor">
      <a:schemeClr val="dk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b="0" kern="1200" spc="20" baseline="0"/>
  </cs:categoryAxis>
  <cs:chartArea mods="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 cmpd="sng" algn="ctr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 cap="flat" cmpd="sng" algn="ctr">
        <a:solidFill>
          <a:schemeClr val="phClr"/>
        </a:solidFill>
        <a:round/>
      </a:ln>
    </cs:spPr>
  </cs:dataPointMarker>
  <cs:dataPointMarkerLayout symbol="circle" size="4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65000"/>
        <a:lumOff val="35000"/>
      </a:schemeClr>
    </cs:fontRef>
    <cs:spPr>
      <a:ln w="9525">
        <a:solidFill>
          <a:schemeClr val="dk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dk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  <a:alpha val="33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dk1">
            <a:lumMod val="65000"/>
            <a:lumOff val="35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>
        <a:solidFill>
          <a:schemeClr val="dk1">
            <a:lumMod val="15000"/>
            <a:lumOff val="85000"/>
          </a:schemeClr>
        </a:solidFill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dk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legend>
  <cs:plotArea>
    <cs:lnRef idx="0"/>
    <cs:fillRef idx="0"/>
    <cs:effectRef idx="0"/>
    <cs:fontRef idx="minor">
      <a:schemeClr val="dk1"/>
    </cs:fontRef>
    <cs:spPr>
      <a:gradFill>
        <a:gsLst>
          <a:gs pos="100000">
            <a:schemeClr val="lt1">
              <a:lumMod val="95000"/>
            </a:schemeClr>
          </a:gs>
          <a:gs pos="0">
            <a:schemeClr val="lt1"/>
          </a:gs>
        </a:gsLst>
        <a:lin ang="5400000" scaled="0"/>
      </a:gradFill>
    </cs:spPr>
  </cs:plotArea>
  <cs:plotArea3D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dk1">
        <a:lumMod val="50000"/>
        <a:lumOff val="50000"/>
      </a:schemeClr>
    </cs:fontRef>
    <cs:defRPr sz="1862" kern="1200" cap="none" spc="2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dk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dk1">
        <a:lumMod val="65000"/>
        <a:lumOff val="35000"/>
      </a:schemeClr>
    </cs:fontRef>
    <cs:defRPr sz="1197" kern="1200" spc="20" baseline="0"/>
  </cs:valueAxis>
  <cs:wall>
    <cs:lnRef idx="0"/>
    <cs:fillRef idx="0"/>
    <cs:effectRef idx="0"/>
    <cs:fontRef idx="minor">
      <a:schemeClr val="dk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30">
  <cs:axisTitle>
    <cs:lnRef idx="0"/>
    <cs:fillRef idx="0"/>
    <cs:effectRef idx="0"/>
    <cs:fontRef idx="minor">
      <a:schemeClr val="dk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b="0" kern="1200" spc="20" baseline="0"/>
  </cs:categoryAxis>
  <cs:chartArea mods="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 cmpd="sng" algn="ctr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 cap="flat" cmpd="sng" algn="ctr">
        <a:solidFill>
          <a:schemeClr val="phClr"/>
        </a:solidFill>
        <a:round/>
      </a:ln>
    </cs:spPr>
  </cs:dataPointMarker>
  <cs:dataPointMarkerLayout symbol="circle" size="4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65000"/>
        <a:lumOff val="35000"/>
      </a:schemeClr>
    </cs:fontRef>
    <cs:spPr>
      <a:ln w="9525">
        <a:solidFill>
          <a:schemeClr val="dk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dk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  <a:alpha val="33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dk1">
            <a:lumMod val="65000"/>
            <a:lumOff val="35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>
        <a:solidFill>
          <a:schemeClr val="dk1">
            <a:lumMod val="15000"/>
            <a:lumOff val="85000"/>
          </a:schemeClr>
        </a:solidFill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dk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legend>
  <cs:plotArea>
    <cs:lnRef idx="0"/>
    <cs:fillRef idx="0"/>
    <cs:effectRef idx="0"/>
    <cs:fontRef idx="minor">
      <a:schemeClr val="dk1"/>
    </cs:fontRef>
    <cs:spPr>
      <a:gradFill>
        <a:gsLst>
          <a:gs pos="100000">
            <a:schemeClr val="lt1">
              <a:lumMod val="95000"/>
            </a:schemeClr>
          </a:gs>
          <a:gs pos="0">
            <a:schemeClr val="lt1"/>
          </a:gs>
        </a:gsLst>
        <a:lin ang="5400000" scaled="0"/>
      </a:gradFill>
    </cs:spPr>
  </cs:plotArea>
  <cs:plotArea3D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dk1">
        <a:lumMod val="50000"/>
        <a:lumOff val="50000"/>
      </a:schemeClr>
    </cs:fontRef>
    <cs:defRPr sz="1862" kern="1200" cap="none" spc="2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dk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dk1">
        <a:lumMod val="65000"/>
        <a:lumOff val="35000"/>
      </a:schemeClr>
    </cs:fontRef>
    <cs:defRPr sz="1197" kern="1200" spc="20" baseline="0"/>
  </cs:valueAxis>
  <cs:wall>
    <cs:lnRef idx="0"/>
    <cs:fillRef idx="0"/>
    <cs:effectRef idx="0"/>
    <cs:fontRef idx="minor">
      <a:schemeClr val="dk1"/>
    </cs:fontRef>
  </cs:wall>
</cs:chartStyle>
</file>

<file path=ppt/charts/style3.xml><?xml version="1.0" encoding="utf-8"?>
<cs:chartStyle xmlns:cs="http://schemas.microsoft.com/office/drawing/2012/chartStyle" xmlns:a="http://schemas.openxmlformats.org/drawingml/2006/main" id="230">
  <cs:axisTitle>
    <cs:lnRef idx="0"/>
    <cs:fillRef idx="0"/>
    <cs:effectRef idx="0"/>
    <cs:fontRef idx="minor">
      <a:schemeClr val="dk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b="0" kern="1200" spc="20" baseline="0"/>
  </cs:categoryAxis>
  <cs:chartArea mods="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 cmpd="sng" algn="ctr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 cap="flat" cmpd="sng" algn="ctr">
        <a:solidFill>
          <a:schemeClr val="phClr"/>
        </a:solidFill>
        <a:round/>
      </a:ln>
    </cs:spPr>
  </cs:dataPointMarker>
  <cs:dataPointMarkerLayout symbol="circle" size="4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65000"/>
        <a:lumOff val="35000"/>
      </a:schemeClr>
    </cs:fontRef>
    <cs:spPr>
      <a:ln w="9525">
        <a:solidFill>
          <a:schemeClr val="dk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dk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  <a:alpha val="33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dk1">
            <a:lumMod val="65000"/>
            <a:lumOff val="35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>
        <a:solidFill>
          <a:schemeClr val="dk1">
            <a:lumMod val="15000"/>
            <a:lumOff val="85000"/>
          </a:schemeClr>
        </a:solidFill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dk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legend>
  <cs:plotArea>
    <cs:lnRef idx="0"/>
    <cs:fillRef idx="0"/>
    <cs:effectRef idx="0"/>
    <cs:fontRef idx="minor">
      <a:schemeClr val="dk1"/>
    </cs:fontRef>
    <cs:spPr>
      <a:gradFill>
        <a:gsLst>
          <a:gs pos="100000">
            <a:schemeClr val="lt1">
              <a:lumMod val="95000"/>
            </a:schemeClr>
          </a:gs>
          <a:gs pos="0">
            <a:schemeClr val="lt1"/>
          </a:gs>
        </a:gsLst>
        <a:lin ang="5400000" scaled="0"/>
      </a:gradFill>
    </cs:spPr>
  </cs:plotArea>
  <cs:plotArea3D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dk1">
        <a:lumMod val="50000"/>
        <a:lumOff val="50000"/>
      </a:schemeClr>
    </cs:fontRef>
    <cs:defRPr sz="1862" kern="1200" cap="none" spc="2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dk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dk1">
        <a:lumMod val="65000"/>
        <a:lumOff val="35000"/>
      </a:schemeClr>
    </cs:fontRef>
    <cs:defRPr sz="1197" kern="1200" spc="20" baseline="0"/>
  </cs:valueAxis>
  <cs:wall>
    <cs:lnRef idx="0"/>
    <cs:fillRef idx="0"/>
    <cs:effectRef idx="0"/>
    <cs:fontRef idx="minor">
      <a:schemeClr val="dk1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230">
  <cs:axisTitle>
    <cs:lnRef idx="0"/>
    <cs:fillRef idx="0"/>
    <cs:effectRef idx="0"/>
    <cs:fontRef idx="minor">
      <a:schemeClr val="dk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b="0" kern="1200" spc="20" baseline="0"/>
  </cs:categoryAxis>
  <cs:chartArea mods="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 cmpd="sng" algn="ctr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 cap="flat" cmpd="sng" algn="ctr">
        <a:solidFill>
          <a:schemeClr val="phClr"/>
        </a:solidFill>
        <a:round/>
      </a:ln>
    </cs:spPr>
  </cs:dataPointMarker>
  <cs:dataPointMarkerLayout symbol="circle" size="4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65000"/>
        <a:lumOff val="35000"/>
      </a:schemeClr>
    </cs:fontRef>
    <cs:spPr>
      <a:ln w="9525">
        <a:solidFill>
          <a:schemeClr val="dk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dk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  <a:alpha val="33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dk1">
            <a:lumMod val="65000"/>
            <a:lumOff val="35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>
        <a:solidFill>
          <a:schemeClr val="dk1">
            <a:lumMod val="15000"/>
            <a:lumOff val="85000"/>
          </a:schemeClr>
        </a:solidFill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dk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legend>
  <cs:plotArea>
    <cs:lnRef idx="0"/>
    <cs:fillRef idx="0"/>
    <cs:effectRef idx="0"/>
    <cs:fontRef idx="minor">
      <a:schemeClr val="dk1"/>
    </cs:fontRef>
    <cs:spPr>
      <a:gradFill>
        <a:gsLst>
          <a:gs pos="100000">
            <a:schemeClr val="lt1">
              <a:lumMod val="95000"/>
            </a:schemeClr>
          </a:gs>
          <a:gs pos="0">
            <a:schemeClr val="lt1"/>
          </a:gs>
        </a:gsLst>
        <a:lin ang="5400000" scaled="0"/>
      </a:gradFill>
    </cs:spPr>
  </cs:plotArea>
  <cs:plotArea3D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dk1">
        <a:lumMod val="50000"/>
        <a:lumOff val="50000"/>
      </a:schemeClr>
    </cs:fontRef>
    <cs:defRPr sz="1862" kern="1200" cap="none" spc="2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dk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dk1">
        <a:lumMod val="65000"/>
        <a:lumOff val="35000"/>
      </a:schemeClr>
    </cs:fontRef>
    <cs:defRPr sz="1197" kern="1200" spc="20" baseline="0"/>
  </cs:valueAxis>
  <cs:wall>
    <cs:lnRef idx="0"/>
    <cs:fillRef idx="0"/>
    <cs:effectRef idx="0"/>
    <cs:fontRef idx="minor">
      <a:schemeClr val="dk1"/>
    </cs:fontRef>
  </cs:wall>
</cs:chartStyle>
</file>

<file path=ppt/charts/style5.xml><?xml version="1.0" encoding="utf-8"?>
<cs:chartStyle xmlns:cs="http://schemas.microsoft.com/office/drawing/2012/chartStyle" xmlns:a="http://schemas.openxmlformats.org/drawingml/2006/main" id="230">
  <cs:axisTitle>
    <cs:lnRef idx="0"/>
    <cs:fillRef idx="0"/>
    <cs:effectRef idx="0"/>
    <cs:fontRef idx="minor">
      <a:schemeClr val="dk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b="0" kern="1200" spc="20" baseline="0"/>
  </cs:categoryAxis>
  <cs:chartArea mods="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 cmpd="sng" algn="ctr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 cap="flat" cmpd="sng" algn="ctr">
        <a:solidFill>
          <a:schemeClr val="phClr"/>
        </a:solidFill>
        <a:round/>
      </a:ln>
    </cs:spPr>
  </cs:dataPointMarker>
  <cs:dataPointMarkerLayout symbol="circle" size="4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65000"/>
        <a:lumOff val="35000"/>
      </a:schemeClr>
    </cs:fontRef>
    <cs:spPr>
      <a:ln w="9525">
        <a:solidFill>
          <a:schemeClr val="dk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dk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  <a:alpha val="33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dk1">
            <a:lumMod val="65000"/>
            <a:lumOff val="35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>
        <a:solidFill>
          <a:schemeClr val="dk1">
            <a:lumMod val="15000"/>
            <a:lumOff val="85000"/>
          </a:schemeClr>
        </a:solidFill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dk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legend>
  <cs:plotArea>
    <cs:lnRef idx="0"/>
    <cs:fillRef idx="0"/>
    <cs:effectRef idx="0"/>
    <cs:fontRef idx="minor">
      <a:schemeClr val="dk1"/>
    </cs:fontRef>
    <cs:spPr>
      <a:gradFill>
        <a:gsLst>
          <a:gs pos="100000">
            <a:schemeClr val="lt1">
              <a:lumMod val="95000"/>
            </a:schemeClr>
          </a:gs>
          <a:gs pos="0">
            <a:schemeClr val="lt1"/>
          </a:gs>
        </a:gsLst>
        <a:lin ang="5400000" scaled="0"/>
      </a:gradFill>
    </cs:spPr>
  </cs:plotArea>
  <cs:plotArea3D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dk1">
        <a:lumMod val="50000"/>
        <a:lumOff val="50000"/>
      </a:schemeClr>
    </cs:fontRef>
    <cs:defRPr sz="1862" kern="1200" cap="none" spc="2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dk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dk1">
        <a:lumMod val="65000"/>
        <a:lumOff val="35000"/>
      </a:schemeClr>
    </cs:fontRef>
    <cs:defRPr sz="1197" kern="1200" spc="20" baseline="0"/>
  </cs:valueAxis>
  <cs:wall>
    <cs:lnRef idx="0"/>
    <cs:fillRef idx="0"/>
    <cs:effectRef idx="0"/>
    <cs:fontRef idx="minor">
      <a:schemeClr val="dk1"/>
    </cs:fontRef>
  </cs:wall>
</cs:chartStyle>
</file>

<file path=ppt/charts/style6.xml><?xml version="1.0" encoding="utf-8"?>
<cs:chartStyle xmlns:cs="http://schemas.microsoft.com/office/drawing/2012/chartStyle" xmlns:a="http://schemas.openxmlformats.org/drawingml/2006/main" id="230">
  <cs:axisTitle>
    <cs:lnRef idx="0"/>
    <cs:fillRef idx="0"/>
    <cs:effectRef idx="0"/>
    <cs:fontRef idx="minor">
      <a:schemeClr val="dk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b="0" kern="1200" spc="20" baseline="0"/>
  </cs:categoryAxis>
  <cs:chartArea mods="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 cmpd="sng" algn="ctr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 cap="flat" cmpd="sng" algn="ctr">
        <a:solidFill>
          <a:schemeClr val="phClr"/>
        </a:solidFill>
        <a:round/>
      </a:ln>
    </cs:spPr>
  </cs:dataPointMarker>
  <cs:dataPointMarkerLayout symbol="circle" size="4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65000"/>
        <a:lumOff val="35000"/>
      </a:schemeClr>
    </cs:fontRef>
    <cs:spPr>
      <a:ln w="9525">
        <a:solidFill>
          <a:schemeClr val="dk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dk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  <a:alpha val="33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dk1">
            <a:lumMod val="65000"/>
            <a:lumOff val="35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>
        <a:solidFill>
          <a:schemeClr val="dk1">
            <a:lumMod val="15000"/>
            <a:lumOff val="85000"/>
          </a:schemeClr>
        </a:solidFill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dk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legend>
  <cs:plotArea>
    <cs:lnRef idx="0"/>
    <cs:fillRef idx="0"/>
    <cs:effectRef idx="0"/>
    <cs:fontRef idx="minor">
      <a:schemeClr val="dk1"/>
    </cs:fontRef>
    <cs:spPr>
      <a:gradFill>
        <a:gsLst>
          <a:gs pos="100000">
            <a:schemeClr val="lt1">
              <a:lumMod val="95000"/>
            </a:schemeClr>
          </a:gs>
          <a:gs pos="0">
            <a:schemeClr val="lt1"/>
          </a:gs>
        </a:gsLst>
        <a:lin ang="5400000" scaled="0"/>
      </a:gradFill>
    </cs:spPr>
  </cs:plotArea>
  <cs:plotArea3D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dk1">
        <a:lumMod val="50000"/>
        <a:lumOff val="50000"/>
      </a:schemeClr>
    </cs:fontRef>
    <cs:defRPr sz="1862" kern="1200" cap="none" spc="2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dk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dk1">
        <a:lumMod val="65000"/>
        <a:lumOff val="35000"/>
      </a:schemeClr>
    </cs:fontRef>
    <cs:defRPr sz="1197" kern="1200" spc="20" baseline="0"/>
  </cs:valueAxis>
  <cs:wall>
    <cs:lnRef idx="0"/>
    <cs:fillRef idx="0"/>
    <cs:effectRef idx="0"/>
    <cs:fontRef idx="minor">
      <a:schemeClr val="dk1"/>
    </cs:fontRef>
  </cs:wall>
</cs:chartStyle>
</file>

<file path=ppt/charts/style7.xml><?xml version="1.0" encoding="utf-8"?>
<cs:chartStyle xmlns:cs="http://schemas.microsoft.com/office/drawing/2012/chartStyle" xmlns:a="http://schemas.openxmlformats.org/drawingml/2006/main" id="230">
  <cs:axisTitle>
    <cs:lnRef idx="0"/>
    <cs:fillRef idx="0"/>
    <cs:effectRef idx="0"/>
    <cs:fontRef idx="minor">
      <a:schemeClr val="dk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b="0" kern="1200" spc="20" baseline="0"/>
  </cs:categoryAxis>
  <cs:chartArea mods="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 cmpd="sng" algn="ctr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 cap="flat" cmpd="sng" algn="ctr">
        <a:solidFill>
          <a:schemeClr val="phClr"/>
        </a:solidFill>
        <a:round/>
      </a:ln>
    </cs:spPr>
  </cs:dataPointMarker>
  <cs:dataPointMarkerLayout symbol="circle" size="4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65000"/>
        <a:lumOff val="35000"/>
      </a:schemeClr>
    </cs:fontRef>
    <cs:spPr>
      <a:ln w="9525">
        <a:solidFill>
          <a:schemeClr val="dk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dk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  <a:alpha val="33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dk1">
            <a:lumMod val="65000"/>
            <a:lumOff val="35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>
        <a:solidFill>
          <a:schemeClr val="dk1">
            <a:lumMod val="15000"/>
            <a:lumOff val="85000"/>
          </a:schemeClr>
        </a:solidFill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dk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legend>
  <cs:plotArea>
    <cs:lnRef idx="0"/>
    <cs:fillRef idx="0"/>
    <cs:effectRef idx="0"/>
    <cs:fontRef idx="minor">
      <a:schemeClr val="dk1"/>
    </cs:fontRef>
    <cs:spPr>
      <a:gradFill>
        <a:gsLst>
          <a:gs pos="100000">
            <a:schemeClr val="lt1">
              <a:lumMod val="95000"/>
            </a:schemeClr>
          </a:gs>
          <a:gs pos="0">
            <a:schemeClr val="lt1"/>
          </a:gs>
        </a:gsLst>
        <a:lin ang="5400000" scaled="0"/>
      </a:gradFill>
    </cs:spPr>
  </cs:plotArea>
  <cs:plotArea3D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dk1">
        <a:lumMod val="50000"/>
        <a:lumOff val="50000"/>
      </a:schemeClr>
    </cs:fontRef>
    <cs:defRPr sz="1862" kern="1200" cap="none" spc="2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dk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dk1">
        <a:lumMod val="65000"/>
        <a:lumOff val="35000"/>
      </a:schemeClr>
    </cs:fontRef>
    <cs:defRPr sz="1197" kern="1200" spc="20" baseline="0"/>
  </cs:valueAxis>
  <cs:wall>
    <cs:lnRef idx="0"/>
    <cs:fillRef idx="0"/>
    <cs:effectRef idx="0"/>
    <cs:fontRef idx="minor">
      <a:schemeClr val="dk1"/>
    </cs:fontRef>
  </cs:wall>
</cs:chartStyle>
</file>

<file path=ppt/charts/style8.xml><?xml version="1.0" encoding="utf-8"?>
<cs:chartStyle xmlns:cs="http://schemas.microsoft.com/office/drawing/2012/chartStyle" xmlns:a="http://schemas.openxmlformats.org/drawingml/2006/main" id="230">
  <cs:axisTitle>
    <cs:lnRef idx="0"/>
    <cs:fillRef idx="0"/>
    <cs:effectRef idx="0"/>
    <cs:fontRef idx="minor">
      <a:schemeClr val="dk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b="0" kern="1200" spc="20" baseline="0"/>
  </cs:categoryAxis>
  <cs:chartArea mods="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 cmpd="sng" algn="ctr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 cap="flat" cmpd="sng" algn="ctr">
        <a:solidFill>
          <a:schemeClr val="phClr"/>
        </a:solidFill>
        <a:round/>
      </a:ln>
    </cs:spPr>
  </cs:dataPointMarker>
  <cs:dataPointMarkerLayout symbol="circle" size="4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65000"/>
        <a:lumOff val="35000"/>
      </a:schemeClr>
    </cs:fontRef>
    <cs:spPr>
      <a:ln w="9525">
        <a:solidFill>
          <a:schemeClr val="dk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dk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  <a:alpha val="33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dk1">
            <a:lumMod val="65000"/>
            <a:lumOff val="35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>
        <a:solidFill>
          <a:schemeClr val="dk1">
            <a:lumMod val="15000"/>
            <a:lumOff val="85000"/>
          </a:schemeClr>
        </a:solidFill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dk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legend>
  <cs:plotArea>
    <cs:lnRef idx="0"/>
    <cs:fillRef idx="0"/>
    <cs:effectRef idx="0"/>
    <cs:fontRef idx="minor">
      <a:schemeClr val="dk1"/>
    </cs:fontRef>
    <cs:spPr>
      <a:gradFill>
        <a:gsLst>
          <a:gs pos="100000">
            <a:schemeClr val="lt1">
              <a:lumMod val="95000"/>
            </a:schemeClr>
          </a:gs>
          <a:gs pos="0">
            <a:schemeClr val="lt1"/>
          </a:gs>
        </a:gsLst>
        <a:lin ang="5400000" scaled="0"/>
      </a:gradFill>
    </cs:spPr>
  </cs:plotArea>
  <cs:plotArea3D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dk1">
        <a:lumMod val="50000"/>
        <a:lumOff val="50000"/>
      </a:schemeClr>
    </cs:fontRef>
    <cs:defRPr sz="1862" kern="1200" cap="none" spc="2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dk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dk1">
        <a:lumMod val="65000"/>
        <a:lumOff val="35000"/>
      </a:schemeClr>
    </cs:fontRef>
    <cs:defRPr sz="1197" kern="1200" spc="20" baseline="0"/>
  </cs:valueAxis>
  <cs:wall>
    <cs:lnRef idx="0"/>
    <cs:fillRef idx="0"/>
    <cs:effectRef idx="0"/>
    <cs:fontRef idx="minor">
      <a:schemeClr val="dk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s-CO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AED8A844-22B2-44EF-8162-CE08508B3F48}" type="datetimeFigureOut">
              <a:rPr lang="es-CO" smtClean="0"/>
              <a:t>09/02/2017</a:t>
            </a:fld>
            <a:endParaRPr lang="es-CO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s-CO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C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s-C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E3C5E6B1-40D7-454E-8BAE-D5BDC6C735B5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7194127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31774">
              <a:defRPr/>
            </a:pPr>
            <a:r>
              <a:rPr lang="es-CO" b="1" dirty="0"/>
              <a:t>CURINGA</a:t>
            </a:r>
          </a:p>
          <a:p>
            <a:endParaRPr lang="es-CO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DA7CEAA-DF85-45AD-BBFA-F91C27A340AC}" type="slidenum">
              <a:rPr lang="en-US" smtClean="0"/>
              <a:pPr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471933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CO" sz="980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DA7CEAA-DF85-45AD-BBFA-F91C27A340AC}" type="slidenum">
              <a:rPr lang="en-US" smtClean="0"/>
              <a:pPr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80639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s-CO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s-C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7FC08-9B87-48D7-BF98-D5965A5264D6}" type="datetimeFigureOut">
              <a:rPr lang="es-CO" smtClean="0"/>
              <a:t>09/02/2017</a:t>
            </a:fld>
            <a:endParaRPr lang="es-C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8E445C-D4BE-4AD1-929A-12CA90EECB16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562667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CO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C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7FC08-9B87-48D7-BF98-D5965A5264D6}" type="datetimeFigureOut">
              <a:rPr lang="es-CO" smtClean="0"/>
              <a:t>09/02/2017</a:t>
            </a:fld>
            <a:endParaRPr lang="es-C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8E445C-D4BE-4AD1-929A-12CA90EECB16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4007161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s-CO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C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7FC08-9B87-48D7-BF98-D5965A5264D6}" type="datetimeFigureOut">
              <a:rPr lang="es-CO" smtClean="0"/>
              <a:t>09/02/2017</a:t>
            </a:fld>
            <a:endParaRPr lang="es-C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8E445C-D4BE-4AD1-929A-12CA90EECB16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5440771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CO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C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7FC08-9B87-48D7-BF98-D5965A5264D6}" type="datetimeFigureOut">
              <a:rPr lang="es-CO" smtClean="0"/>
              <a:t>09/02/2017</a:t>
            </a:fld>
            <a:endParaRPr lang="es-C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8E445C-D4BE-4AD1-929A-12CA90EECB16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4868874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s-CO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7FC08-9B87-48D7-BF98-D5965A5264D6}" type="datetimeFigureOut">
              <a:rPr lang="es-CO" smtClean="0"/>
              <a:t>09/02/2017</a:t>
            </a:fld>
            <a:endParaRPr lang="es-C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8E445C-D4BE-4AD1-929A-12CA90EECB16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5520586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CO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CO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CO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7FC08-9B87-48D7-BF98-D5965A5264D6}" type="datetimeFigureOut">
              <a:rPr lang="es-CO" smtClean="0"/>
              <a:t>09/02/2017</a:t>
            </a:fld>
            <a:endParaRPr lang="es-C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8E445C-D4BE-4AD1-929A-12CA90EECB16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2715380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s-CO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CO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CO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7FC08-9B87-48D7-BF98-D5965A5264D6}" type="datetimeFigureOut">
              <a:rPr lang="es-CO" smtClean="0"/>
              <a:t>09/02/2017</a:t>
            </a:fld>
            <a:endParaRPr lang="es-CO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8E445C-D4BE-4AD1-929A-12CA90EECB16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1782853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CO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7FC08-9B87-48D7-BF98-D5965A5264D6}" type="datetimeFigureOut">
              <a:rPr lang="es-CO" smtClean="0"/>
              <a:t>09/02/2017</a:t>
            </a:fld>
            <a:endParaRPr lang="es-CO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8E445C-D4BE-4AD1-929A-12CA90EECB16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0285598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7FC08-9B87-48D7-BF98-D5965A5264D6}" type="datetimeFigureOut">
              <a:rPr lang="es-CO" smtClean="0"/>
              <a:t>09/02/2017</a:t>
            </a:fld>
            <a:endParaRPr lang="es-CO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8E445C-D4BE-4AD1-929A-12CA90EECB16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558897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s-CO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CO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7FC08-9B87-48D7-BF98-D5965A5264D6}" type="datetimeFigureOut">
              <a:rPr lang="es-CO" smtClean="0"/>
              <a:t>09/02/2017</a:t>
            </a:fld>
            <a:endParaRPr lang="es-C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8E445C-D4BE-4AD1-929A-12CA90EECB16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7210423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s-CO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CO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27FC08-9B87-48D7-BF98-D5965A5264D6}" type="datetimeFigureOut">
              <a:rPr lang="es-CO" smtClean="0"/>
              <a:t>09/02/2017</a:t>
            </a:fld>
            <a:endParaRPr lang="es-C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8E445C-D4BE-4AD1-929A-12CA90EECB16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8078967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s-CO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C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27FC08-9B87-48D7-BF98-D5965A5264D6}" type="datetimeFigureOut">
              <a:rPr lang="es-CO" smtClean="0"/>
              <a:t>09/02/2017</a:t>
            </a:fld>
            <a:endParaRPr lang="es-C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C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8E445C-D4BE-4AD1-929A-12CA90EECB16}" type="slidenum">
              <a:rPr lang="es-CO" smtClean="0"/>
              <a:t>‹#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0523985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9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0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12.xml"/><Relationship Id="rId4" Type="http://schemas.openxmlformats.org/officeDocument/2006/relationships/chart" Target="../charts/chart1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3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14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5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287215" y="5374005"/>
            <a:ext cx="11904785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4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Figure S1. 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Expression analysis of drought responsive genes in Ubi:AtGolS2 transgenic rice. Expression of NAC6, ICL and LEA3 were analyzed in the transgenic rice at well-watered conditions. Expression of the genes in drought stress-treated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uringa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was also analyzed. Expression of OsUbi1 was used as an internal control. The average value of Non-transgenic (NT) was set as 1.0 and the relative values were shown. Five plants were combined into one sample for each line, and the relative values are mean ± SD of three technical replicates. Primer sets used for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qRT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-PCR analysis are listed in Table S6. </a:t>
            </a:r>
          </a:p>
        </p:txBody>
      </p:sp>
      <p:graphicFrame>
        <p:nvGraphicFramePr>
          <p:cNvPr id="4" name="グラフ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24069016"/>
              </p:ext>
            </p:extLst>
          </p:nvPr>
        </p:nvGraphicFramePr>
        <p:xfrm>
          <a:off x="3086100" y="151341"/>
          <a:ext cx="5040842" cy="18012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0" name="グラフ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10921672"/>
              </p:ext>
            </p:extLst>
          </p:nvPr>
        </p:nvGraphicFramePr>
        <p:xfrm>
          <a:off x="7939193" y="-168755"/>
          <a:ext cx="1774825" cy="18712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" name="グラフ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58866749"/>
              </p:ext>
            </p:extLst>
          </p:nvPr>
        </p:nvGraphicFramePr>
        <p:xfrm>
          <a:off x="2897189" y="1701987"/>
          <a:ext cx="5170486" cy="20032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2" name="グラフ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57074896"/>
              </p:ext>
            </p:extLst>
          </p:nvPr>
        </p:nvGraphicFramePr>
        <p:xfrm>
          <a:off x="8007329" y="1585298"/>
          <a:ext cx="1698643" cy="18484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7" name="グラフ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25469669"/>
              </p:ext>
            </p:extLst>
          </p:nvPr>
        </p:nvGraphicFramePr>
        <p:xfrm>
          <a:off x="2962275" y="3362325"/>
          <a:ext cx="5219700" cy="24574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9" name="グラフ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298564"/>
              </p:ext>
            </p:extLst>
          </p:nvPr>
        </p:nvGraphicFramePr>
        <p:xfrm>
          <a:off x="8001000" y="3348990"/>
          <a:ext cx="1813561" cy="18859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</p:spTree>
    <p:extLst>
      <p:ext uri="{BB962C8B-B14F-4D97-AF65-F5344CB8AC3E}">
        <p14:creationId xmlns:p14="http://schemas.microsoft.com/office/powerpoint/2010/main" val="31368908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6" name="Chart 3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71866280"/>
              </p:ext>
            </p:extLst>
          </p:nvPr>
        </p:nvGraphicFramePr>
        <p:xfrm>
          <a:off x="2291607" y="4523509"/>
          <a:ext cx="8404967" cy="225829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2" name="Chart 2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48564222"/>
              </p:ext>
            </p:extLst>
          </p:nvPr>
        </p:nvGraphicFramePr>
        <p:xfrm>
          <a:off x="2298700" y="2046643"/>
          <a:ext cx="8341025" cy="25350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2345527" y="-42142"/>
            <a:ext cx="5183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es-CO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2330566" y="2186563"/>
            <a:ext cx="5183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es-CO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5" name="Chart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32936433"/>
              </p:ext>
            </p:extLst>
          </p:nvPr>
        </p:nvGraphicFramePr>
        <p:xfrm>
          <a:off x="2400301" y="57270"/>
          <a:ext cx="8294094" cy="23050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" name="Rectangle 1"/>
          <p:cNvSpPr/>
          <p:nvPr/>
        </p:nvSpPr>
        <p:spPr>
          <a:xfrm rot="16200000">
            <a:off x="2489294" y="845455"/>
            <a:ext cx="1340421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CO" sz="1100" dirty="0" err="1">
                <a:latin typeface="Arial" panose="020B0604020202020204" pitchFamily="34" charset="0"/>
                <a:cs typeface="Arial" panose="020B0604020202020204" pitchFamily="34" charset="0"/>
              </a:rPr>
              <a:t>Direct</a:t>
            </a:r>
            <a:r>
              <a:rPr lang="es-CO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CO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eding</a:t>
            </a:r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CO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owing</a:t>
            </a:r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es-CO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ight Arrow 16"/>
          <p:cNvSpPr/>
          <p:nvPr/>
        </p:nvSpPr>
        <p:spPr>
          <a:xfrm rot="5400000">
            <a:off x="2973849" y="1611520"/>
            <a:ext cx="174625" cy="111125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6995587" y="1456520"/>
            <a:ext cx="114967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CO" sz="1100" dirty="0">
                <a:latin typeface="Arial" panose="020B0604020202020204" pitchFamily="34" charset="0"/>
                <a:cs typeface="Arial" panose="020B0604020202020204" pitchFamily="34" charset="0"/>
              </a:rPr>
              <a:t>Data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ollection</a:t>
            </a:r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s-CO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Left Brace 22"/>
          <p:cNvSpPr/>
          <p:nvPr/>
        </p:nvSpPr>
        <p:spPr>
          <a:xfrm rot="16200000" flipH="1" flipV="1">
            <a:off x="7178201" y="613251"/>
            <a:ext cx="171127" cy="2297430"/>
          </a:xfrm>
          <a:prstGeom prst="leftBrace">
            <a:avLst>
              <a:gd name="adj1" fmla="val 22224"/>
              <a:gd name="adj2" fmla="val 37194"/>
            </a:avLst>
          </a:prstGeom>
          <a:pattFill prst="narVert">
            <a:fgClr>
              <a:schemeClr val="tx1"/>
            </a:fgClr>
            <a:bgClr>
              <a:schemeClr val="bg1"/>
            </a:bgClr>
          </a:pattFill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CO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Rectangle 25"/>
          <p:cNvSpPr/>
          <p:nvPr/>
        </p:nvSpPr>
        <p:spPr>
          <a:xfrm rot="16200000">
            <a:off x="7980911" y="1040029"/>
            <a:ext cx="101502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Re-</a:t>
            </a:r>
            <a:r>
              <a:rPr lang="es-CO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atering</a:t>
            </a:r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s-CO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Right Arrow 26"/>
          <p:cNvSpPr/>
          <p:nvPr/>
        </p:nvSpPr>
        <p:spPr>
          <a:xfrm rot="5400000">
            <a:off x="8393574" y="1630570"/>
            <a:ext cx="174625" cy="111125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Left Brace 45"/>
          <p:cNvSpPr/>
          <p:nvPr/>
        </p:nvSpPr>
        <p:spPr>
          <a:xfrm rot="16200000" flipH="1" flipV="1">
            <a:off x="4421102" y="323617"/>
            <a:ext cx="198432" cy="2843039"/>
          </a:xfrm>
          <a:prstGeom prst="leftBrace">
            <a:avLst>
              <a:gd name="adj1" fmla="val 22224"/>
              <a:gd name="adj2" fmla="val 50617"/>
            </a:avLst>
          </a:prstGeom>
          <a:pattFill prst="dotDmnd">
            <a:fgClr>
              <a:schemeClr val="tx1"/>
            </a:fgClr>
            <a:bgClr>
              <a:schemeClr val="bg1"/>
            </a:bgClr>
          </a:pattFill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CO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Rectangle 46"/>
          <p:cNvSpPr/>
          <p:nvPr/>
        </p:nvSpPr>
        <p:spPr>
          <a:xfrm>
            <a:off x="3877737" y="1202520"/>
            <a:ext cx="1265090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Vegetative Stage</a:t>
            </a:r>
          </a:p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Normal Irrigation 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Rectangle 49"/>
          <p:cNvSpPr/>
          <p:nvPr/>
        </p:nvSpPr>
        <p:spPr>
          <a:xfrm rot="16200000">
            <a:off x="2462131" y="2954915"/>
            <a:ext cx="1340421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CO" sz="1100" dirty="0" err="1">
                <a:latin typeface="Arial" panose="020B0604020202020204" pitchFamily="34" charset="0"/>
                <a:cs typeface="Arial" panose="020B0604020202020204" pitchFamily="34" charset="0"/>
              </a:rPr>
              <a:t>Direct</a:t>
            </a:r>
            <a:r>
              <a:rPr lang="es-CO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CO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eding</a:t>
            </a:r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CO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owing</a:t>
            </a:r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es-CO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Right Arrow 50"/>
          <p:cNvSpPr/>
          <p:nvPr/>
        </p:nvSpPr>
        <p:spPr>
          <a:xfrm rot="5400000">
            <a:off x="7417086" y="4394080"/>
            <a:ext cx="174625" cy="111125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Rectangle 53"/>
          <p:cNvSpPr/>
          <p:nvPr/>
        </p:nvSpPr>
        <p:spPr>
          <a:xfrm>
            <a:off x="7025574" y="3565980"/>
            <a:ext cx="114967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CO" sz="1100" dirty="0">
                <a:latin typeface="Arial" panose="020B0604020202020204" pitchFamily="34" charset="0"/>
                <a:cs typeface="Arial" panose="020B0604020202020204" pitchFamily="34" charset="0"/>
              </a:rPr>
              <a:t>Data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ollection</a:t>
            </a:r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s-CO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Left Brace 54"/>
          <p:cNvSpPr/>
          <p:nvPr/>
        </p:nvSpPr>
        <p:spPr>
          <a:xfrm rot="16200000" flipH="1" flipV="1">
            <a:off x="7211448" y="2785342"/>
            <a:ext cx="215125" cy="2186943"/>
          </a:xfrm>
          <a:prstGeom prst="leftBrace">
            <a:avLst>
              <a:gd name="adj1" fmla="val 22224"/>
              <a:gd name="adj2" fmla="val 42197"/>
            </a:avLst>
          </a:prstGeom>
          <a:pattFill prst="narVert">
            <a:fgClr>
              <a:schemeClr val="tx1"/>
            </a:fgClr>
            <a:bgClr>
              <a:schemeClr val="bg1"/>
            </a:bgClr>
          </a:pattFill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CO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Rectangle 55"/>
          <p:cNvSpPr/>
          <p:nvPr/>
        </p:nvSpPr>
        <p:spPr>
          <a:xfrm rot="16200000">
            <a:off x="7976608" y="3149489"/>
            <a:ext cx="101502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Re-</a:t>
            </a:r>
            <a:r>
              <a:rPr lang="es-CO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atering</a:t>
            </a:r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s-CO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Right Arrow 56"/>
          <p:cNvSpPr/>
          <p:nvPr/>
        </p:nvSpPr>
        <p:spPr>
          <a:xfrm rot="5400000">
            <a:off x="8389271" y="3740030"/>
            <a:ext cx="174625" cy="111125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Left Brace 57"/>
          <p:cNvSpPr/>
          <p:nvPr/>
        </p:nvSpPr>
        <p:spPr>
          <a:xfrm rot="16200000" flipH="1" flipV="1">
            <a:off x="4421012" y="2432986"/>
            <a:ext cx="171449" cy="2870203"/>
          </a:xfrm>
          <a:prstGeom prst="leftBrace">
            <a:avLst>
              <a:gd name="adj1" fmla="val 22224"/>
              <a:gd name="adj2" fmla="val 50617"/>
            </a:avLst>
          </a:prstGeom>
          <a:pattFill prst="dotDmnd">
            <a:fgClr>
              <a:schemeClr val="tx1"/>
            </a:fgClr>
            <a:bgClr>
              <a:schemeClr val="bg1"/>
            </a:bgClr>
          </a:pattFill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CO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Rectangle 58"/>
          <p:cNvSpPr/>
          <p:nvPr/>
        </p:nvSpPr>
        <p:spPr>
          <a:xfrm>
            <a:off x="3860099" y="3311980"/>
            <a:ext cx="1265090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Vegetative Stage</a:t>
            </a:r>
          </a:p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Normal Irrigation 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Rectangle 61"/>
          <p:cNvSpPr/>
          <p:nvPr/>
        </p:nvSpPr>
        <p:spPr>
          <a:xfrm rot="16200000">
            <a:off x="2460119" y="5321013"/>
            <a:ext cx="1340421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CO" sz="1100" dirty="0" err="1">
                <a:latin typeface="Arial" panose="020B0604020202020204" pitchFamily="34" charset="0"/>
                <a:cs typeface="Arial" panose="020B0604020202020204" pitchFamily="34" charset="0"/>
              </a:rPr>
              <a:t>Direct</a:t>
            </a:r>
            <a:r>
              <a:rPr lang="es-CO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CO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eding</a:t>
            </a:r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CO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owing</a:t>
            </a:r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es-CO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Right Arrow 62"/>
          <p:cNvSpPr/>
          <p:nvPr/>
        </p:nvSpPr>
        <p:spPr>
          <a:xfrm rot="5400000">
            <a:off x="2944674" y="6087078"/>
            <a:ext cx="174625" cy="111125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Rectangle 65"/>
          <p:cNvSpPr/>
          <p:nvPr/>
        </p:nvSpPr>
        <p:spPr>
          <a:xfrm>
            <a:off x="7004512" y="5932078"/>
            <a:ext cx="114967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CO" sz="1100" dirty="0">
                <a:latin typeface="Arial" panose="020B0604020202020204" pitchFamily="34" charset="0"/>
                <a:cs typeface="Arial" panose="020B0604020202020204" pitchFamily="34" charset="0"/>
              </a:rPr>
              <a:t>Data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ollection</a:t>
            </a:r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s-CO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Left Brace 66"/>
          <p:cNvSpPr/>
          <p:nvPr/>
        </p:nvSpPr>
        <p:spPr>
          <a:xfrm rot="16200000" flipH="1" flipV="1">
            <a:off x="7281818" y="5513508"/>
            <a:ext cx="185827" cy="1462087"/>
          </a:xfrm>
          <a:prstGeom prst="leftBrace">
            <a:avLst>
              <a:gd name="adj1" fmla="val 22224"/>
              <a:gd name="adj2" fmla="val 38736"/>
            </a:avLst>
          </a:prstGeom>
          <a:pattFill prst="narVert">
            <a:fgClr>
              <a:schemeClr val="tx1"/>
            </a:fgClr>
            <a:bgClr>
              <a:schemeClr val="bg1"/>
            </a:bgClr>
          </a:pattFill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CO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Rectangle 67"/>
          <p:cNvSpPr/>
          <p:nvPr/>
        </p:nvSpPr>
        <p:spPr>
          <a:xfrm rot="16200000">
            <a:off x="7951736" y="5515587"/>
            <a:ext cx="101502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Re-</a:t>
            </a:r>
            <a:r>
              <a:rPr lang="es-CO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atering</a:t>
            </a:r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s-CO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Right Arrow 68"/>
          <p:cNvSpPr/>
          <p:nvPr/>
        </p:nvSpPr>
        <p:spPr>
          <a:xfrm rot="5400000">
            <a:off x="8364399" y="6106128"/>
            <a:ext cx="174625" cy="111125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Left Brace 69"/>
          <p:cNvSpPr/>
          <p:nvPr/>
        </p:nvSpPr>
        <p:spPr>
          <a:xfrm rot="16200000" flipH="1" flipV="1">
            <a:off x="4443819" y="4786172"/>
            <a:ext cx="171449" cy="2919841"/>
          </a:xfrm>
          <a:prstGeom prst="leftBrace">
            <a:avLst>
              <a:gd name="adj1" fmla="val 22224"/>
              <a:gd name="adj2" fmla="val 50617"/>
            </a:avLst>
          </a:prstGeom>
          <a:pattFill prst="dotDmnd">
            <a:fgClr>
              <a:schemeClr val="tx1"/>
            </a:fgClr>
            <a:bgClr>
              <a:schemeClr val="bg1"/>
            </a:bgClr>
          </a:pattFill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CO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Rectangle 70"/>
          <p:cNvSpPr/>
          <p:nvPr/>
        </p:nvSpPr>
        <p:spPr>
          <a:xfrm>
            <a:off x="3886662" y="5697128"/>
            <a:ext cx="1265090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Vegetative Stage</a:t>
            </a:r>
          </a:p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Normal Irrigation 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2320127" y="4428258"/>
            <a:ext cx="5183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es-CO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Rectangle 78"/>
          <p:cNvSpPr/>
          <p:nvPr/>
        </p:nvSpPr>
        <p:spPr>
          <a:xfrm rot="16200000">
            <a:off x="8515858" y="1040029"/>
            <a:ext cx="85953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CO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arvesting</a:t>
            </a:r>
            <a:endParaRPr lang="es-CO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Right Arrow 79"/>
          <p:cNvSpPr/>
          <p:nvPr/>
        </p:nvSpPr>
        <p:spPr>
          <a:xfrm rot="5400000">
            <a:off x="8866014" y="1645810"/>
            <a:ext cx="174625" cy="111125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Rectangle 80"/>
          <p:cNvSpPr/>
          <p:nvPr/>
        </p:nvSpPr>
        <p:spPr>
          <a:xfrm rot="16200000">
            <a:off x="8508239" y="3127909"/>
            <a:ext cx="85953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CO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arvesting</a:t>
            </a:r>
            <a:endParaRPr lang="es-CO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Right Arrow 81"/>
          <p:cNvSpPr/>
          <p:nvPr/>
        </p:nvSpPr>
        <p:spPr>
          <a:xfrm rot="5400000">
            <a:off x="8858395" y="3733690"/>
            <a:ext cx="174625" cy="111125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Rectangle 82"/>
          <p:cNvSpPr/>
          <p:nvPr/>
        </p:nvSpPr>
        <p:spPr>
          <a:xfrm rot="16200000">
            <a:off x="8546338" y="5482489"/>
            <a:ext cx="85953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Harvesting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Right Arrow 83"/>
          <p:cNvSpPr/>
          <p:nvPr/>
        </p:nvSpPr>
        <p:spPr>
          <a:xfrm rot="5400000">
            <a:off x="8896494" y="6088270"/>
            <a:ext cx="174625" cy="111125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8290877" y="152400"/>
            <a:ext cx="12662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URINGA</a:t>
            </a:r>
            <a:endParaRPr lang="es-CO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Rectangle 90"/>
          <p:cNvSpPr/>
          <p:nvPr/>
        </p:nvSpPr>
        <p:spPr>
          <a:xfrm rot="16200000">
            <a:off x="6360063" y="890070"/>
            <a:ext cx="1186843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Days to </a:t>
            </a:r>
            <a:r>
              <a:rPr lang="en-US" altLang="en-US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0%  </a:t>
            </a:r>
            <a:r>
              <a:rPr lang="en-US" alt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Flowering</a:t>
            </a:r>
          </a:p>
        </p:txBody>
      </p:sp>
      <p:sp>
        <p:nvSpPr>
          <p:cNvPr id="92" name="Right Arrow 91"/>
          <p:cNvSpPr/>
          <p:nvPr/>
        </p:nvSpPr>
        <p:spPr>
          <a:xfrm rot="5400000">
            <a:off x="6872740" y="1559831"/>
            <a:ext cx="174625" cy="111125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Rectangle 92"/>
          <p:cNvSpPr/>
          <p:nvPr/>
        </p:nvSpPr>
        <p:spPr>
          <a:xfrm rot="16200000">
            <a:off x="6389984" y="3054871"/>
            <a:ext cx="1186843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Days to </a:t>
            </a:r>
            <a:r>
              <a:rPr lang="en-US" altLang="en-US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0%  </a:t>
            </a:r>
            <a:r>
              <a:rPr lang="en-US" alt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Flowering</a:t>
            </a:r>
          </a:p>
        </p:txBody>
      </p:sp>
      <p:sp>
        <p:nvSpPr>
          <p:cNvPr id="94" name="Right Arrow 93"/>
          <p:cNvSpPr/>
          <p:nvPr/>
        </p:nvSpPr>
        <p:spPr>
          <a:xfrm rot="5400000">
            <a:off x="6902661" y="3724632"/>
            <a:ext cx="174625" cy="111125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Rectangle 94"/>
          <p:cNvSpPr/>
          <p:nvPr/>
        </p:nvSpPr>
        <p:spPr>
          <a:xfrm rot="16200000">
            <a:off x="6379594" y="5379015"/>
            <a:ext cx="1186843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Days to </a:t>
            </a:r>
            <a:r>
              <a:rPr lang="en-US" altLang="en-US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0%  </a:t>
            </a:r>
            <a:r>
              <a:rPr lang="en-US" alt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Flowering</a:t>
            </a:r>
          </a:p>
        </p:txBody>
      </p:sp>
      <p:sp>
        <p:nvSpPr>
          <p:cNvPr id="96" name="Right Arrow 95"/>
          <p:cNvSpPr/>
          <p:nvPr/>
        </p:nvSpPr>
        <p:spPr>
          <a:xfrm rot="5400000">
            <a:off x="6892271" y="6048776"/>
            <a:ext cx="174625" cy="111125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8300402" y="2305050"/>
            <a:ext cx="12662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URINGA</a:t>
            </a:r>
            <a:endParaRPr lang="es-CO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8309927" y="4591050"/>
            <a:ext cx="12662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URINGA</a:t>
            </a:r>
            <a:endParaRPr lang="es-CO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2971513" y="238942"/>
            <a:ext cx="1835759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DSE-2012-rainy-Trial 1 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Rectangle 60"/>
          <p:cNvSpPr/>
          <p:nvPr/>
        </p:nvSpPr>
        <p:spPr>
          <a:xfrm>
            <a:off x="2962584" y="2393001"/>
            <a:ext cx="171874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DSE-2012-dry-Trial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Rectangle 63"/>
          <p:cNvSpPr/>
          <p:nvPr/>
        </p:nvSpPr>
        <p:spPr>
          <a:xfrm>
            <a:off x="2971513" y="4676456"/>
            <a:ext cx="175721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DSE-2014-rainy-Trial  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Rectangle 3"/>
          <p:cNvSpPr/>
          <p:nvPr/>
        </p:nvSpPr>
        <p:spPr>
          <a:xfrm rot="16200000">
            <a:off x="5464575" y="865404"/>
            <a:ext cx="146867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rrigation</a:t>
            </a:r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ermination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ight Arrow 19"/>
          <p:cNvSpPr/>
          <p:nvPr/>
        </p:nvSpPr>
        <p:spPr>
          <a:xfrm rot="5400000">
            <a:off x="6115975" y="1678195"/>
            <a:ext cx="174625" cy="111125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Right Arrow 52"/>
          <p:cNvSpPr/>
          <p:nvPr/>
        </p:nvSpPr>
        <p:spPr>
          <a:xfrm rot="5400000">
            <a:off x="6189218" y="3827348"/>
            <a:ext cx="174625" cy="111125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Rectangle 85"/>
          <p:cNvSpPr/>
          <p:nvPr/>
        </p:nvSpPr>
        <p:spPr>
          <a:xfrm rot="16200000">
            <a:off x="5527324" y="3002310"/>
            <a:ext cx="146867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rrigation</a:t>
            </a:r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ermination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Right Arrow 64"/>
          <p:cNvSpPr/>
          <p:nvPr/>
        </p:nvSpPr>
        <p:spPr>
          <a:xfrm rot="5400000">
            <a:off x="6731040" y="6187949"/>
            <a:ext cx="174625" cy="111125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Rectangle 87"/>
          <p:cNvSpPr/>
          <p:nvPr/>
        </p:nvSpPr>
        <p:spPr>
          <a:xfrm rot="16200000">
            <a:off x="6082090" y="5372908"/>
            <a:ext cx="146867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rrigation</a:t>
            </a:r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ermination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Rectangle 5"/>
          <p:cNvSpPr/>
          <p:nvPr/>
        </p:nvSpPr>
        <p:spPr>
          <a:xfrm rot="16200000">
            <a:off x="-2146411" y="2425804"/>
            <a:ext cx="6445227" cy="17081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4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Figure </a:t>
            </a:r>
            <a:r>
              <a:rPr lang="en-US" sz="1400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S2</a:t>
            </a:r>
            <a:r>
              <a:rPr lang="en-US" sz="14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Aquapro soil moisture profile and work schedules of Curinga plots during rainout shelter managed drought stress environment (MDSE) trial, CIAT, Palmira. (a) Moisture profile of </a:t>
            </a:r>
            <a:r>
              <a:rPr lang="en-US" sz="1400" dirty="0">
                <a:latin typeface="Times New Roman" panose="02020603050405020304" pitchFamily="18" charset="0"/>
                <a:ea typeface="MS Mincho" panose="02020609040205080304" pitchFamily="49" charset="-128"/>
              </a:rPr>
              <a:t>2012-rainy-MDSE-Trial-1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sz="1400" dirty="0">
                <a:latin typeface="Times New Roman" panose="02020603050405020304" pitchFamily="18" charset="0"/>
                <a:ea typeface="MS Mincho" panose="02020609040205080304" pitchFamily="49" charset="-128"/>
              </a:rPr>
              <a:t>(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b) Moisture profile of</a:t>
            </a:r>
            <a:r>
              <a:rPr lang="en-US" sz="1400" dirty="0">
                <a:latin typeface="Times New Roman" panose="02020603050405020304" pitchFamily="18" charset="0"/>
                <a:ea typeface="MS Mincho" panose="02020609040205080304" pitchFamily="49" charset="-128"/>
              </a:rPr>
              <a:t> 2012-dry-MDSE-Trial-2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sz="1400" dirty="0">
                <a:latin typeface="Times New Roman" panose="02020603050405020304" pitchFamily="18" charset="0"/>
                <a:ea typeface="MS Mincho" panose="02020609040205080304" pitchFamily="49" charset="-128"/>
              </a:rPr>
              <a:t>(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c) Moisture profile of</a:t>
            </a:r>
            <a:r>
              <a:rPr lang="en-US" sz="1400" dirty="0">
                <a:latin typeface="Times New Roman" panose="02020603050405020304" pitchFamily="18" charset="0"/>
                <a:ea typeface="MS Mincho" panose="02020609040205080304" pitchFamily="49" charset="-128"/>
              </a:rPr>
              <a:t> 2014-rainy-MDSE-Trial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. Line graph</a:t>
            </a:r>
            <a:r>
              <a:rPr lang="en-US" sz="1400" dirty="0">
                <a:latin typeface="Times New Roman" panose="02020603050405020304" pitchFamily="18" charset="0"/>
                <a:ea typeface="MS Mincho" panose="02020609040205080304" pitchFamily="49" charset="-128"/>
              </a:rPr>
              <a:t>s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show the moisture level</a:t>
            </a:r>
            <a:r>
              <a:rPr lang="en-US" sz="1400" dirty="0">
                <a:latin typeface="Times New Roman" panose="02020603050405020304" pitchFamily="18" charset="0"/>
                <a:ea typeface="MS Mincho" panose="02020609040205080304" pitchFamily="49" charset="-128"/>
              </a:rPr>
              <a:t>s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t different depth of the soil. </a:t>
            </a:r>
            <a:endParaRPr lang="en-US" sz="14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937804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3" name="Chart 2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36596197"/>
              </p:ext>
            </p:extLst>
          </p:nvPr>
        </p:nvGraphicFramePr>
        <p:xfrm>
          <a:off x="2327622" y="4519660"/>
          <a:ext cx="8084744" cy="23383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0" name="Chart 1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90540169"/>
              </p:ext>
            </p:extLst>
          </p:nvPr>
        </p:nvGraphicFramePr>
        <p:xfrm>
          <a:off x="2237086" y="2079667"/>
          <a:ext cx="8281054" cy="2537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5" name="Chart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93498790"/>
              </p:ext>
            </p:extLst>
          </p:nvPr>
        </p:nvGraphicFramePr>
        <p:xfrm>
          <a:off x="2202695" y="-16787"/>
          <a:ext cx="8202503" cy="24361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8" name="TextBox 27"/>
          <p:cNvSpPr txBox="1"/>
          <p:nvPr/>
        </p:nvSpPr>
        <p:spPr>
          <a:xfrm>
            <a:off x="2294727" y="34058"/>
            <a:ext cx="5183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es-CO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2313776" y="2215283"/>
            <a:ext cx="5183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lang="es-CO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2322485" y="4418552"/>
            <a:ext cx="51839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1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lang="es-CO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Rectangle 51"/>
          <p:cNvSpPr/>
          <p:nvPr/>
        </p:nvSpPr>
        <p:spPr>
          <a:xfrm rot="16200000">
            <a:off x="2447419" y="5311488"/>
            <a:ext cx="1340421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CO" sz="1100" dirty="0" err="1">
                <a:latin typeface="Arial" panose="020B0604020202020204" pitchFamily="34" charset="0"/>
                <a:cs typeface="Arial" panose="020B0604020202020204" pitchFamily="34" charset="0"/>
              </a:rPr>
              <a:t>Direct</a:t>
            </a:r>
            <a:r>
              <a:rPr lang="es-CO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CO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eding</a:t>
            </a:r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CO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owing</a:t>
            </a:r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es-CO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Right Arrow 52"/>
          <p:cNvSpPr/>
          <p:nvPr/>
        </p:nvSpPr>
        <p:spPr>
          <a:xfrm rot="5400000">
            <a:off x="2931974" y="6077553"/>
            <a:ext cx="174625" cy="111125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Rectangle 54"/>
          <p:cNvSpPr/>
          <p:nvPr/>
        </p:nvSpPr>
        <p:spPr>
          <a:xfrm>
            <a:off x="5829762" y="5878103"/>
            <a:ext cx="114967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CO" sz="1100" dirty="0">
                <a:latin typeface="Arial" panose="020B0604020202020204" pitchFamily="34" charset="0"/>
                <a:cs typeface="Arial" panose="020B0604020202020204" pitchFamily="34" charset="0"/>
              </a:rPr>
              <a:t>Data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ollection</a:t>
            </a:r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s-CO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Left Brace 68"/>
          <p:cNvSpPr/>
          <p:nvPr/>
        </p:nvSpPr>
        <p:spPr>
          <a:xfrm rot="16200000" flipH="1" flipV="1">
            <a:off x="6668247" y="5322215"/>
            <a:ext cx="185827" cy="1749424"/>
          </a:xfrm>
          <a:prstGeom prst="leftBrace">
            <a:avLst>
              <a:gd name="adj1" fmla="val 22224"/>
              <a:gd name="adj2" fmla="val 81748"/>
            </a:avLst>
          </a:prstGeom>
          <a:pattFill prst="narVert">
            <a:fgClr>
              <a:schemeClr val="tx1"/>
            </a:fgClr>
            <a:bgClr>
              <a:schemeClr val="bg1"/>
            </a:bgClr>
          </a:pattFill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CO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Rectangle 69"/>
          <p:cNvSpPr/>
          <p:nvPr/>
        </p:nvSpPr>
        <p:spPr>
          <a:xfrm rot="16200000">
            <a:off x="7251053" y="5523480"/>
            <a:ext cx="101502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Re-</a:t>
            </a:r>
            <a:r>
              <a:rPr lang="es-CO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atering</a:t>
            </a:r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s-CO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Right Arrow 70"/>
          <p:cNvSpPr/>
          <p:nvPr/>
        </p:nvSpPr>
        <p:spPr>
          <a:xfrm rot="5400000">
            <a:off x="7663716" y="6114021"/>
            <a:ext cx="174625" cy="111125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Left Brace 71"/>
          <p:cNvSpPr/>
          <p:nvPr/>
        </p:nvSpPr>
        <p:spPr>
          <a:xfrm rot="16200000" flipH="1" flipV="1">
            <a:off x="4333138" y="4803907"/>
            <a:ext cx="216767" cy="2769204"/>
          </a:xfrm>
          <a:prstGeom prst="leftBrace">
            <a:avLst>
              <a:gd name="adj1" fmla="val 22224"/>
              <a:gd name="adj2" fmla="val 50617"/>
            </a:avLst>
          </a:prstGeom>
          <a:pattFill prst="dotDmnd">
            <a:fgClr>
              <a:schemeClr val="tx1"/>
            </a:fgClr>
            <a:bgClr>
              <a:schemeClr val="bg1"/>
            </a:bgClr>
          </a:pattFill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CO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Rectangle 72"/>
          <p:cNvSpPr/>
          <p:nvPr/>
        </p:nvSpPr>
        <p:spPr>
          <a:xfrm>
            <a:off x="3797762" y="5573303"/>
            <a:ext cx="1265090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Vegetative Stage</a:t>
            </a:r>
          </a:p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Normal Irrigation 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Rectangle 73"/>
          <p:cNvSpPr/>
          <p:nvPr/>
        </p:nvSpPr>
        <p:spPr>
          <a:xfrm rot="16200000">
            <a:off x="8507511" y="5472964"/>
            <a:ext cx="85953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Harvesting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Right Arrow 74"/>
          <p:cNvSpPr/>
          <p:nvPr/>
        </p:nvSpPr>
        <p:spPr>
          <a:xfrm rot="5400000">
            <a:off x="8857667" y="6078745"/>
            <a:ext cx="174625" cy="111125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Rectangle 75"/>
          <p:cNvSpPr/>
          <p:nvPr/>
        </p:nvSpPr>
        <p:spPr>
          <a:xfrm rot="16200000">
            <a:off x="4844331" y="5229057"/>
            <a:ext cx="146867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rrigation</a:t>
            </a:r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ermination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Rectangle 76"/>
          <p:cNvSpPr/>
          <p:nvPr/>
        </p:nvSpPr>
        <p:spPr>
          <a:xfrm rot="16200000">
            <a:off x="6366894" y="5388540"/>
            <a:ext cx="1186843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Days to </a:t>
            </a:r>
            <a:r>
              <a:rPr lang="en-US" altLang="en-US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0%  </a:t>
            </a:r>
            <a:r>
              <a:rPr lang="en-US" alt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Flowering</a:t>
            </a:r>
          </a:p>
        </p:txBody>
      </p:sp>
      <p:sp>
        <p:nvSpPr>
          <p:cNvPr id="78" name="Right Arrow 77"/>
          <p:cNvSpPr/>
          <p:nvPr/>
        </p:nvSpPr>
        <p:spPr>
          <a:xfrm rot="5400000">
            <a:off x="6879571" y="6036076"/>
            <a:ext cx="174625" cy="111125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Right Arrow 53"/>
          <p:cNvSpPr/>
          <p:nvPr/>
        </p:nvSpPr>
        <p:spPr>
          <a:xfrm rot="5400000">
            <a:off x="5485955" y="6054356"/>
            <a:ext cx="174625" cy="111125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Rectangle 78"/>
          <p:cNvSpPr/>
          <p:nvPr/>
        </p:nvSpPr>
        <p:spPr>
          <a:xfrm rot="16200000">
            <a:off x="2456127" y="3108218"/>
            <a:ext cx="1340421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CO" sz="1100" dirty="0" err="1">
                <a:latin typeface="Arial" panose="020B0604020202020204" pitchFamily="34" charset="0"/>
                <a:cs typeface="Arial" panose="020B0604020202020204" pitchFamily="34" charset="0"/>
              </a:rPr>
              <a:t>Direct</a:t>
            </a:r>
            <a:r>
              <a:rPr lang="es-CO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CO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eding</a:t>
            </a:r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CO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owing</a:t>
            </a:r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es-CO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Right Arrow 79"/>
          <p:cNvSpPr/>
          <p:nvPr/>
        </p:nvSpPr>
        <p:spPr>
          <a:xfrm rot="5400000">
            <a:off x="2940682" y="3874283"/>
            <a:ext cx="174625" cy="111125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Rectangle 80"/>
          <p:cNvSpPr/>
          <p:nvPr/>
        </p:nvSpPr>
        <p:spPr>
          <a:xfrm>
            <a:off x="5838470" y="3674833"/>
            <a:ext cx="114967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CO" sz="1100" dirty="0">
                <a:latin typeface="Arial" panose="020B0604020202020204" pitchFamily="34" charset="0"/>
                <a:cs typeface="Arial" panose="020B0604020202020204" pitchFamily="34" charset="0"/>
              </a:rPr>
              <a:t>Data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ollection</a:t>
            </a:r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s-CO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Left Brace 101"/>
          <p:cNvSpPr/>
          <p:nvPr/>
        </p:nvSpPr>
        <p:spPr>
          <a:xfrm rot="16200000" flipH="1" flipV="1">
            <a:off x="6676955" y="3118945"/>
            <a:ext cx="185827" cy="1749424"/>
          </a:xfrm>
          <a:prstGeom prst="leftBrace">
            <a:avLst>
              <a:gd name="adj1" fmla="val 22224"/>
              <a:gd name="adj2" fmla="val 81748"/>
            </a:avLst>
          </a:prstGeom>
          <a:pattFill prst="narVert">
            <a:fgClr>
              <a:schemeClr val="tx1"/>
            </a:fgClr>
            <a:bgClr>
              <a:schemeClr val="bg1"/>
            </a:bgClr>
          </a:pattFill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CO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Rectangle 102"/>
          <p:cNvSpPr/>
          <p:nvPr/>
        </p:nvSpPr>
        <p:spPr>
          <a:xfrm rot="16200000">
            <a:off x="7549321" y="3320210"/>
            <a:ext cx="101502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Re-</a:t>
            </a:r>
            <a:r>
              <a:rPr lang="es-CO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atering</a:t>
            </a:r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s-CO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Right Arrow 103"/>
          <p:cNvSpPr/>
          <p:nvPr/>
        </p:nvSpPr>
        <p:spPr>
          <a:xfrm rot="5400000">
            <a:off x="7961984" y="3910751"/>
            <a:ext cx="174625" cy="111125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Left Brace 104"/>
          <p:cNvSpPr/>
          <p:nvPr/>
        </p:nvSpPr>
        <p:spPr>
          <a:xfrm rot="16200000" flipH="1" flipV="1">
            <a:off x="4341846" y="2600637"/>
            <a:ext cx="216767" cy="2769204"/>
          </a:xfrm>
          <a:prstGeom prst="leftBrace">
            <a:avLst>
              <a:gd name="adj1" fmla="val 22224"/>
              <a:gd name="adj2" fmla="val 50617"/>
            </a:avLst>
          </a:prstGeom>
          <a:pattFill prst="dotDmnd">
            <a:fgClr>
              <a:schemeClr val="tx1"/>
            </a:fgClr>
            <a:bgClr>
              <a:schemeClr val="bg1"/>
            </a:bgClr>
          </a:pattFill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CO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" name="Rectangle 105"/>
          <p:cNvSpPr/>
          <p:nvPr/>
        </p:nvSpPr>
        <p:spPr>
          <a:xfrm>
            <a:off x="3815995" y="3398608"/>
            <a:ext cx="1265090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Vegetative Stage</a:t>
            </a:r>
          </a:p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Normal Irrigation 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Rectangle 106"/>
          <p:cNvSpPr/>
          <p:nvPr/>
        </p:nvSpPr>
        <p:spPr>
          <a:xfrm rot="16200000">
            <a:off x="8531459" y="3269694"/>
            <a:ext cx="85953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Harvesting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Right Arrow 107"/>
          <p:cNvSpPr/>
          <p:nvPr/>
        </p:nvSpPr>
        <p:spPr>
          <a:xfrm rot="5400000">
            <a:off x="8881615" y="3875475"/>
            <a:ext cx="174625" cy="111125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9" name="Rectangle 108"/>
          <p:cNvSpPr/>
          <p:nvPr/>
        </p:nvSpPr>
        <p:spPr>
          <a:xfrm rot="16200000">
            <a:off x="4923384" y="2981827"/>
            <a:ext cx="146867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rrigation</a:t>
            </a:r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ermination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Rectangle 109"/>
          <p:cNvSpPr/>
          <p:nvPr/>
        </p:nvSpPr>
        <p:spPr>
          <a:xfrm rot="16200000">
            <a:off x="6360362" y="3185270"/>
            <a:ext cx="1186843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Days to </a:t>
            </a:r>
            <a:r>
              <a:rPr lang="en-US" altLang="en-US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0%  </a:t>
            </a:r>
            <a:r>
              <a:rPr lang="en-US" alt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Flowering</a:t>
            </a:r>
          </a:p>
        </p:txBody>
      </p:sp>
      <p:sp>
        <p:nvSpPr>
          <p:cNvPr id="111" name="Right Arrow 110"/>
          <p:cNvSpPr/>
          <p:nvPr/>
        </p:nvSpPr>
        <p:spPr>
          <a:xfrm rot="5400000">
            <a:off x="6865419" y="3832806"/>
            <a:ext cx="174625" cy="111125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" name="Right Arrow 111"/>
          <p:cNvSpPr/>
          <p:nvPr/>
        </p:nvSpPr>
        <p:spPr>
          <a:xfrm rot="5400000">
            <a:off x="5573800" y="3815918"/>
            <a:ext cx="174625" cy="111125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4" name="Rectangle 113"/>
          <p:cNvSpPr/>
          <p:nvPr/>
        </p:nvSpPr>
        <p:spPr>
          <a:xfrm rot="16200000">
            <a:off x="2463747" y="938655"/>
            <a:ext cx="1340421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CO" sz="1100" dirty="0" err="1">
                <a:latin typeface="Arial" panose="020B0604020202020204" pitchFamily="34" charset="0"/>
                <a:cs typeface="Arial" panose="020B0604020202020204" pitchFamily="34" charset="0"/>
              </a:rPr>
              <a:t>Direct</a:t>
            </a:r>
            <a:r>
              <a:rPr lang="es-CO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CO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eding</a:t>
            </a:r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CO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owing</a:t>
            </a:r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endParaRPr lang="es-CO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Right Arrow 114"/>
          <p:cNvSpPr/>
          <p:nvPr/>
        </p:nvSpPr>
        <p:spPr>
          <a:xfrm rot="5400000">
            <a:off x="2948302" y="1704720"/>
            <a:ext cx="174625" cy="111125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6" name="Rectangle 115"/>
          <p:cNvSpPr/>
          <p:nvPr/>
        </p:nvSpPr>
        <p:spPr>
          <a:xfrm>
            <a:off x="6699530" y="1474790"/>
            <a:ext cx="114967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CO" sz="1100" dirty="0">
                <a:latin typeface="Arial" panose="020B0604020202020204" pitchFamily="34" charset="0"/>
                <a:cs typeface="Arial" panose="020B0604020202020204" pitchFamily="34" charset="0"/>
              </a:rPr>
              <a:t>Data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ollection</a:t>
            </a:r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s-CO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Left Brace 116"/>
          <p:cNvSpPr/>
          <p:nvPr/>
        </p:nvSpPr>
        <p:spPr>
          <a:xfrm rot="16200000" flipH="1" flipV="1">
            <a:off x="6386809" y="651617"/>
            <a:ext cx="173371" cy="2357412"/>
          </a:xfrm>
          <a:prstGeom prst="leftBrace">
            <a:avLst>
              <a:gd name="adj1" fmla="val 22224"/>
              <a:gd name="adj2" fmla="val 29479"/>
            </a:avLst>
          </a:prstGeom>
          <a:pattFill prst="narVert">
            <a:fgClr>
              <a:schemeClr val="tx1"/>
            </a:fgClr>
            <a:bgClr>
              <a:schemeClr val="bg1"/>
            </a:bgClr>
          </a:pattFill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CO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8" name="Rectangle 117"/>
          <p:cNvSpPr/>
          <p:nvPr/>
        </p:nvSpPr>
        <p:spPr>
          <a:xfrm rot="16200000">
            <a:off x="7648381" y="1150647"/>
            <a:ext cx="101502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Re-</a:t>
            </a:r>
            <a:r>
              <a:rPr lang="es-CO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atering</a:t>
            </a:r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s-CO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Right Arrow 118"/>
          <p:cNvSpPr/>
          <p:nvPr/>
        </p:nvSpPr>
        <p:spPr>
          <a:xfrm rot="5400000">
            <a:off x="8068664" y="1741188"/>
            <a:ext cx="174625" cy="111125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0" name="Left Brace 119"/>
          <p:cNvSpPr/>
          <p:nvPr/>
        </p:nvSpPr>
        <p:spPr>
          <a:xfrm rot="16200000" flipH="1" flipV="1">
            <a:off x="4008782" y="771758"/>
            <a:ext cx="216767" cy="2087837"/>
          </a:xfrm>
          <a:prstGeom prst="leftBrace">
            <a:avLst>
              <a:gd name="adj1" fmla="val 22224"/>
              <a:gd name="adj2" fmla="val 50617"/>
            </a:avLst>
          </a:prstGeom>
          <a:pattFill prst="dotDmnd">
            <a:fgClr>
              <a:schemeClr val="tx1"/>
            </a:fgClr>
            <a:bgClr>
              <a:schemeClr val="bg1"/>
            </a:bgClr>
          </a:pattFill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CO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1" name="Rectangle 120"/>
          <p:cNvSpPr/>
          <p:nvPr/>
        </p:nvSpPr>
        <p:spPr>
          <a:xfrm>
            <a:off x="3580233" y="1261733"/>
            <a:ext cx="1265090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Vegetative Stage</a:t>
            </a:r>
          </a:p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Normal Irrigation 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Rectangle 121"/>
          <p:cNvSpPr/>
          <p:nvPr/>
        </p:nvSpPr>
        <p:spPr>
          <a:xfrm rot="16200000">
            <a:off x="8500979" y="1100131"/>
            <a:ext cx="859531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Harvesting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Right Arrow 122"/>
          <p:cNvSpPr/>
          <p:nvPr/>
        </p:nvSpPr>
        <p:spPr>
          <a:xfrm rot="5400000">
            <a:off x="8851135" y="1705912"/>
            <a:ext cx="174625" cy="111125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4" name="Rectangle 123"/>
          <p:cNvSpPr/>
          <p:nvPr/>
        </p:nvSpPr>
        <p:spPr>
          <a:xfrm rot="16200000">
            <a:off x="4841906" y="820090"/>
            <a:ext cx="146867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rrigation</a:t>
            </a:r>
            <a:r>
              <a:rPr lang="es-CO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ermination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Rectangle 124"/>
          <p:cNvSpPr/>
          <p:nvPr/>
        </p:nvSpPr>
        <p:spPr>
          <a:xfrm rot="16200000">
            <a:off x="5933642" y="969987"/>
            <a:ext cx="1186843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Days to </a:t>
            </a:r>
            <a:r>
              <a:rPr lang="en-US" altLang="en-US" sz="7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rst </a:t>
            </a:r>
            <a:r>
              <a:rPr lang="en-US" alt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Flowering</a:t>
            </a:r>
          </a:p>
        </p:txBody>
      </p:sp>
      <p:sp>
        <p:nvSpPr>
          <p:cNvPr id="126" name="Right Arrow 125"/>
          <p:cNvSpPr/>
          <p:nvPr/>
        </p:nvSpPr>
        <p:spPr>
          <a:xfrm rot="5400000">
            <a:off x="6438699" y="1648003"/>
            <a:ext cx="174625" cy="111125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7" name="Right Arrow 126"/>
          <p:cNvSpPr/>
          <p:nvPr/>
        </p:nvSpPr>
        <p:spPr>
          <a:xfrm rot="5400000">
            <a:off x="5509906" y="1654181"/>
            <a:ext cx="174625" cy="111125"/>
          </a:xfrm>
          <a:prstGeom prst="rightArrow">
            <a:avLst/>
          </a:prstGeom>
          <a:solidFill>
            <a:schemeClr val="bg2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8332279" y="177800"/>
            <a:ext cx="12662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URINGA</a:t>
            </a:r>
            <a:endParaRPr lang="es-CO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8313991" y="2354072"/>
            <a:ext cx="12662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URINGA</a:t>
            </a:r>
            <a:endParaRPr lang="es-CO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8304847" y="4548632"/>
            <a:ext cx="12662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O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URINGA</a:t>
            </a:r>
            <a:endParaRPr lang="es-CO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2907169" y="208928"/>
            <a:ext cx="93006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TE-2012-13</a:t>
            </a:r>
          </a:p>
        </p:txBody>
      </p:sp>
      <p:sp>
        <p:nvSpPr>
          <p:cNvPr id="57" name="Rectangle 56"/>
          <p:cNvSpPr/>
          <p:nvPr/>
        </p:nvSpPr>
        <p:spPr>
          <a:xfrm>
            <a:off x="2895395" y="2416223"/>
            <a:ext cx="93006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E-2013-14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Rectangle 60"/>
          <p:cNvSpPr/>
          <p:nvPr/>
        </p:nvSpPr>
        <p:spPr>
          <a:xfrm>
            <a:off x="2902186" y="4587570"/>
            <a:ext cx="930063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E-2014-15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Rectangle 2"/>
          <p:cNvSpPr/>
          <p:nvPr/>
        </p:nvSpPr>
        <p:spPr>
          <a:xfrm rot="16200000">
            <a:off x="-2117496" y="2510134"/>
            <a:ext cx="6372827" cy="17081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4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Figure </a:t>
            </a:r>
            <a:r>
              <a:rPr lang="en-US" sz="1400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S3</a:t>
            </a:r>
            <a:r>
              <a:rPr lang="en-US" sz="14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. 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Aquapro soil moisture profile and work schedules of Curinga plots during Target environment (TE) trial, CIAT, Santa Rosa upland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rainfed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station. (a) Soil moisture profile of TE-2012-13-Trial (b) Soil moisture profile of TE-2013-14-Trial (c) Soil moisture profile of TE-2014-15-Trial. Time course of the Aquapro soil moisture level at different soil depths (0-80 cm) during cropping period is shown.</a:t>
            </a:r>
            <a:endParaRPr lang="en-US" sz="14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915520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2210722" y="172006"/>
            <a:ext cx="8201037" cy="4780994"/>
            <a:chOff x="2254684" y="743506"/>
            <a:chExt cx="8201037" cy="4780994"/>
          </a:xfrm>
        </p:grpSpPr>
        <p:graphicFrame>
          <p:nvGraphicFramePr>
            <p:cNvPr id="10" name="Chart 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87033181"/>
                </p:ext>
              </p:extLst>
            </p:nvPr>
          </p:nvGraphicFramePr>
          <p:xfrm>
            <a:off x="2378521" y="851022"/>
            <a:ext cx="8077200" cy="246367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11" name="Chart 1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066289337"/>
                </p:ext>
              </p:extLst>
            </p:nvPr>
          </p:nvGraphicFramePr>
          <p:xfrm>
            <a:off x="2369373" y="3165922"/>
            <a:ext cx="8071108" cy="235857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3" name="TextBox 12"/>
            <p:cNvSpPr txBox="1"/>
            <p:nvPr/>
          </p:nvSpPr>
          <p:spPr>
            <a:xfrm>
              <a:off x="2254684" y="743506"/>
              <a:ext cx="51839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O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)</a:t>
              </a:r>
              <a:endParaRPr lang="es-CO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256436" y="3028888"/>
              <a:ext cx="51839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O" sz="11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)</a:t>
              </a:r>
              <a:endParaRPr lang="es-CO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8317366" y="963793"/>
              <a:ext cx="12023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O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ERICA4</a:t>
              </a:r>
              <a:endParaRPr lang="es-CO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Rectangle 40"/>
            <p:cNvSpPr/>
            <p:nvPr/>
          </p:nvSpPr>
          <p:spPr>
            <a:xfrm rot="16200000">
              <a:off x="2476440" y="1682463"/>
              <a:ext cx="1340421" cy="43088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s-CO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Direct</a:t>
              </a:r>
              <a:r>
                <a:rPr lang="es-CO" sz="1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CO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eeding</a:t>
              </a:r>
              <a:r>
                <a:rPr lang="es-CO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s-CO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owing</a:t>
              </a:r>
              <a:r>
                <a:rPr lang="es-CO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 </a:t>
              </a:r>
              <a:endParaRPr lang="es-CO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Right Arrow 48"/>
            <p:cNvSpPr/>
            <p:nvPr/>
          </p:nvSpPr>
          <p:spPr>
            <a:xfrm rot="5400000">
              <a:off x="2960995" y="2448528"/>
              <a:ext cx="174625" cy="111125"/>
            </a:xfrm>
            <a:prstGeom prst="rightArrow">
              <a:avLst/>
            </a:prstGeom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CO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Rectangle 49"/>
            <p:cNvSpPr/>
            <p:nvPr/>
          </p:nvSpPr>
          <p:spPr>
            <a:xfrm>
              <a:off x="6628403" y="2241458"/>
              <a:ext cx="1149674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CO" sz="1100" dirty="0">
                  <a:latin typeface="Arial" panose="020B0604020202020204" pitchFamily="34" charset="0"/>
                  <a:cs typeface="Arial" panose="020B0604020202020204" pitchFamily="34" charset="0"/>
                </a:rPr>
                <a:t>Data </a:t>
              </a:r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llection</a:t>
              </a:r>
              <a:r>
                <a:rPr lang="es-CO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s-CO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Left Brace 50"/>
            <p:cNvSpPr/>
            <p:nvPr/>
          </p:nvSpPr>
          <p:spPr>
            <a:xfrm rot="16200000" flipH="1" flipV="1">
              <a:off x="6875704" y="1559207"/>
              <a:ext cx="185827" cy="2002153"/>
            </a:xfrm>
            <a:prstGeom prst="leftBrace">
              <a:avLst>
                <a:gd name="adj1" fmla="val 22224"/>
                <a:gd name="adj2" fmla="val 31657"/>
              </a:avLst>
            </a:prstGeom>
            <a:pattFill prst="narVert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CO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Rectangle 51"/>
            <p:cNvSpPr/>
            <p:nvPr/>
          </p:nvSpPr>
          <p:spPr>
            <a:xfrm rot="16200000">
              <a:off x="7554394" y="1894455"/>
              <a:ext cx="1015021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CO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-</a:t>
              </a:r>
              <a:r>
                <a:rPr lang="es-CO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Watering</a:t>
              </a:r>
              <a:r>
                <a:rPr lang="es-CO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s-CO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Right Arrow 52"/>
            <p:cNvSpPr/>
            <p:nvPr/>
          </p:nvSpPr>
          <p:spPr>
            <a:xfrm rot="5400000">
              <a:off x="7967057" y="2484996"/>
              <a:ext cx="174625" cy="111125"/>
            </a:xfrm>
            <a:prstGeom prst="rightArrow">
              <a:avLst/>
            </a:prstGeom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CO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Left Brace 53"/>
            <p:cNvSpPr/>
            <p:nvPr/>
          </p:nvSpPr>
          <p:spPr>
            <a:xfrm rot="16200000" flipH="1" flipV="1">
              <a:off x="4399307" y="1137735"/>
              <a:ext cx="216767" cy="2843500"/>
            </a:xfrm>
            <a:prstGeom prst="leftBrace">
              <a:avLst>
                <a:gd name="adj1" fmla="val 22224"/>
                <a:gd name="adj2" fmla="val 50617"/>
              </a:avLst>
            </a:prstGeom>
            <a:pattFill prst="dotDmnd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CO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Rectangle 54"/>
            <p:cNvSpPr/>
            <p:nvPr/>
          </p:nvSpPr>
          <p:spPr>
            <a:xfrm>
              <a:off x="3857263" y="1989998"/>
              <a:ext cx="1265090" cy="43088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egetative Stage</a:t>
              </a:r>
            </a:p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ormal Irrigation 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Rectangle 55"/>
            <p:cNvSpPr/>
            <p:nvPr/>
          </p:nvSpPr>
          <p:spPr>
            <a:xfrm rot="16200000">
              <a:off x="8506052" y="1866799"/>
              <a:ext cx="859531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arvesting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Right Arrow 56"/>
            <p:cNvSpPr/>
            <p:nvPr/>
          </p:nvSpPr>
          <p:spPr>
            <a:xfrm rot="5400000">
              <a:off x="8856208" y="2472580"/>
              <a:ext cx="174625" cy="111125"/>
            </a:xfrm>
            <a:prstGeom prst="rightArrow">
              <a:avLst/>
            </a:prstGeom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CO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Rectangle 57"/>
            <p:cNvSpPr/>
            <p:nvPr/>
          </p:nvSpPr>
          <p:spPr>
            <a:xfrm rot="16200000">
              <a:off x="4810845" y="1572680"/>
              <a:ext cx="1468672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rrigation</a:t>
              </a:r>
              <a:r>
                <a:rPr lang="es-CO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ermination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Rectangle 58"/>
            <p:cNvSpPr/>
            <p:nvPr/>
          </p:nvSpPr>
          <p:spPr>
            <a:xfrm rot="16200000">
              <a:off x="5694875" y="1759515"/>
              <a:ext cx="1186843" cy="20005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Days to </a:t>
              </a:r>
              <a:r>
                <a:rPr lang="en-US" altLang="en-US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%  </a:t>
              </a:r>
              <a:r>
                <a:rPr lang="en-US" alt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Flowering</a:t>
              </a:r>
            </a:p>
          </p:txBody>
        </p:sp>
        <p:sp>
          <p:nvSpPr>
            <p:cNvPr id="60" name="Right Arrow 59"/>
            <p:cNvSpPr/>
            <p:nvPr/>
          </p:nvSpPr>
          <p:spPr>
            <a:xfrm rot="5400000">
              <a:off x="6207552" y="2407051"/>
              <a:ext cx="174625" cy="111125"/>
            </a:xfrm>
            <a:prstGeom prst="rightArrow">
              <a:avLst/>
            </a:prstGeom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CO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Right Arrow 60"/>
            <p:cNvSpPr/>
            <p:nvPr/>
          </p:nvSpPr>
          <p:spPr>
            <a:xfrm rot="5400000">
              <a:off x="5462953" y="2397683"/>
              <a:ext cx="174625" cy="111125"/>
            </a:xfrm>
            <a:prstGeom prst="rightArrow">
              <a:avLst/>
            </a:prstGeom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CO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Rectangle 61"/>
            <p:cNvSpPr/>
            <p:nvPr/>
          </p:nvSpPr>
          <p:spPr>
            <a:xfrm rot="16200000">
              <a:off x="2484060" y="3998943"/>
              <a:ext cx="1340421" cy="43088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s-CO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Direct</a:t>
              </a:r>
              <a:r>
                <a:rPr lang="es-CO" sz="11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CO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eeding</a:t>
              </a:r>
              <a:r>
                <a:rPr lang="es-CO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s-CO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owing</a:t>
              </a:r>
              <a:r>
                <a:rPr lang="es-CO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 </a:t>
              </a:r>
              <a:endParaRPr lang="es-CO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Right Arrow 62"/>
            <p:cNvSpPr/>
            <p:nvPr/>
          </p:nvSpPr>
          <p:spPr>
            <a:xfrm rot="5400000">
              <a:off x="2968615" y="4765008"/>
              <a:ext cx="174625" cy="111125"/>
            </a:xfrm>
            <a:prstGeom prst="rightArrow">
              <a:avLst/>
            </a:prstGeom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CO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Rectangle 63"/>
            <p:cNvSpPr/>
            <p:nvPr/>
          </p:nvSpPr>
          <p:spPr>
            <a:xfrm>
              <a:off x="6636023" y="4557938"/>
              <a:ext cx="1149674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CO" sz="1100" dirty="0">
                  <a:latin typeface="Arial" panose="020B0604020202020204" pitchFamily="34" charset="0"/>
                  <a:cs typeface="Arial" panose="020B0604020202020204" pitchFamily="34" charset="0"/>
                </a:rPr>
                <a:t>Data </a:t>
              </a:r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llection</a:t>
              </a:r>
              <a:r>
                <a:rPr lang="es-CO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s-CO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Left Brace 64"/>
            <p:cNvSpPr/>
            <p:nvPr/>
          </p:nvSpPr>
          <p:spPr>
            <a:xfrm rot="16200000" flipH="1" flipV="1">
              <a:off x="6704888" y="4009670"/>
              <a:ext cx="185827" cy="1749424"/>
            </a:xfrm>
            <a:prstGeom prst="leftBrace">
              <a:avLst>
                <a:gd name="adj1" fmla="val 22224"/>
                <a:gd name="adj2" fmla="val 31657"/>
              </a:avLst>
            </a:prstGeom>
            <a:pattFill prst="narVert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CO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Rectangle 65"/>
            <p:cNvSpPr/>
            <p:nvPr/>
          </p:nvSpPr>
          <p:spPr>
            <a:xfrm rot="16200000">
              <a:off x="7196254" y="4210935"/>
              <a:ext cx="1015021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s-CO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-</a:t>
              </a:r>
              <a:r>
                <a:rPr lang="es-CO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Watering</a:t>
              </a:r>
              <a:r>
                <a:rPr lang="es-CO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s-CO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Right Arrow 66"/>
            <p:cNvSpPr/>
            <p:nvPr/>
          </p:nvSpPr>
          <p:spPr>
            <a:xfrm rot="5400000">
              <a:off x="7608917" y="4801476"/>
              <a:ext cx="174625" cy="111125"/>
            </a:xfrm>
            <a:prstGeom prst="rightArrow">
              <a:avLst/>
            </a:prstGeom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CO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Left Brace 67"/>
            <p:cNvSpPr/>
            <p:nvPr/>
          </p:nvSpPr>
          <p:spPr>
            <a:xfrm rot="16200000" flipH="1" flipV="1">
              <a:off x="4369779" y="3491362"/>
              <a:ext cx="216767" cy="2769204"/>
            </a:xfrm>
            <a:prstGeom prst="leftBrace">
              <a:avLst>
                <a:gd name="adj1" fmla="val 22224"/>
                <a:gd name="adj2" fmla="val 50617"/>
              </a:avLst>
            </a:prstGeom>
            <a:pattFill prst="dotDmnd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CO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Rectangle 68"/>
            <p:cNvSpPr/>
            <p:nvPr/>
          </p:nvSpPr>
          <p:spPr>
            <a:xfrm>
              <a:off x="3845833" y="4329338"/>
              <a:ext cx="1265090" cy="43088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egetative Stage</a:t>
              </a:r>
            </a:p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ormal Irrigation 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Rectangle 69"/>
            <p:cNvSpPr/>
            <p:nvPr/>
          </p:nvSpPr>
          <p:spPr>
            <a:xfrm rot="16200000">
              <a:off x="8513672" y="4183279"/>
              <a:ext cx="859531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arvesting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Right Arrow 70"/>
            <p:cNvSpPr/>
            <p:nvPr/>
          </p:nvSpPr>
          <p:spPr>
            <a:xfrm rot="5400000">
              <a:off x="8863828" y="4789060"/>
              <a:ext cx="174625" cy="111125"/>
            </a:xfrm>
            <a:prstGeom prst="rightArrow">
              <a:avLst/>
            </a:prstGeom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CO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Rectangle 71"/>
            <p:cNvSpPr/>
            <p:nvPr/>
          </p:nvSpPr>
          <p:spPr>
            <a:xfrm rot="16200000">
              <a:off x="4819807" y="3890491"/>
              <a:ext cx="1468672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rrigation</a:t>
              </a:r>
              <a:r>
                <a:rPr lang="es-CO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ermination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Rectangle 72"/>
            <p:cNvSpPr/>
            <p:nvPr/>
          </p:nvSpPr>
          <p:spPr>
            <a:xfrm rot="16200000">
              <a:off x="5702495" y="4075995"/>
              <a:ext cx="1186843" cy="20005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Days to </a:t>
              </a:r>
              <a:r>
                <a:rPr lang="en-US" altLang="en-US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0%  </a:t>
              </a:r>
              <a:r>
                <a:rPr lang="en-US" altLang="en-US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Flowering</a:t>
              </a:r>
            </a:p>
          </p:txBody>
        </p:sp>
        <p:sp>
          <p:nvSpPr>
            <p:cNvPr id="74" name="Right Arrow 73"/>
            <p:cNvSpPr/>
            <p:nvPr/>
          </p:nvSpPr>
          <p:spPr>
            <a:xfrm rot="5400000">
              <a:off x="6215172" y="4723531"/>
              <a:ext cx="174625" cy="111125"/>
            </a:xfrm>
            <a:prstGeom prst="rightArrow">
              <a:avLst/>
            </a:prstGeom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CO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Right Arrow 74"/>
            <p:cNvSpPr/>
            <p:nvPr/>
          </p:nvSpPr>
          <p:spPr>
            <a:xfrm rot="5400000">
              <a:off x="5467267" y="4705489"/>
              <a:ext cx="174625" cy="111125"/>
            </a:xfrm>
            <a:prstGeom prst="rightArrow">
              <a:avLst/>
            </a:prstGeom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CO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8355466" y="3268843"/>
              <a:ext cx="12023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O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ERICA4</a:t>
              </a:r>
              <a:endParaRPr lang="es-CO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" name="Rectangle 1"/>
            <p:cNvSpPr/>
            <p:nvPr/>
          </p:nvSpPr>
          <p:spPr>
            <a:xfrm>
              <a:off x="2931207" y="992669"/>
              <a:ext cx="1273105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TE-2013-14-Trial</a:t>
              </a:r>
            </a:p>
          </p:txBody>
        </p:sp>
        <p:sp>
          <p:nvSpPr>
            <p:cNvPr id="37" name="Rectangle 36"/>
            <p:cNvSpPr/>
            <p:nvPr/>
          </p:nvSpPr>
          <p:spPr>
            <a:xfrm>
              <a:off x="2931207" y="3297496"/>
              <a:ext cx="1273105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E-2014-15-Trial</a:t>
              </a:r>
              <a:endParaRPr 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" name="Rectangle 3"/>
          <p:cNvSpPr/>
          <p:nvPr/>
        </p:nvSpPr>
        <p:spPr>
          <a:xfrm>
            <a:off x="1177495" y="5260698"/>
            <a:ext cx="9729232" cy="10618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4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Figure </a:t>
            </a:r>
            <a:r>
              <a:rPr lang="en-US" sz="1400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S4.</a:t>
            </a:r>
            <a:r>
              <a:rPr lang="en-US" sz="14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Aquapro soil moisture profile and work schedules of NERICA4 plots during Target Environment (TE) trial, CIAT, Santa Rosa upland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rainfed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station. (a) Soil moisture profile of TE-2013-14-Trial. (b) Soil moisture profile of TE-2014-15-Trial. Time course of the Aquapro soil moisture level at different soil depths (0-80 cm) during cropping period is shown.</a:t>
            </a:r>
            <a:endParaRPr lang="en-US" sz="14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321015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00816920"/>
              </p:ext>
            </p:extLst>
          </p:nvPr>
        </p:nvGraphicFramePr>
        <p:xfrm>
          <a:off x="3074804" y="1478008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6" name="直線コネクタ 5"/>
          <p:cNvCxnSpPr/>
          <p:nvPr/>
        </p:nvCxnSpPr>
        <p:spPr>
          <a:xfrm>
            <a:off x="3873500" y="1643141"/>
            <a:ext cx="3054350" cy="0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" name="直線コネクタ 7"/>
          <p:cNvCxnSpPr/>
          <p:nvPr/>
        </p:nvCxnSpPr>
        <p:spPr>
          <a:xfrm>
            <a:off x="6923430" y="1641475"/>
            <a:ext cx="0" cy="1533525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直線コネクタ 15"/>
          <p:cNvCxnSpPr/>
          <p:nvPr/>
        </p:nvCxnSpPr>
        <p:spPr>
          <a:xfrm>
            <a:off x="3949700" y="4233941"/>
            <a:ext cx="2082800" cy="0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直線コネクタ 18"/>
          <p:cNvCxnSpPr/>
          <p:nvPr/>
        </p:nvCxnSpPr>
        <p:spPr>
          <a:xfrm>
            <a:off x="6096000" y="4233941"/>
            <a:ext cx="850900" cy="0"/>
          </a:xfrm>
          <a:prstGeom prst="line">
            <a:avLst/>
          </a:prstGeom>
          <a:ln w="63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テキスト ボックス 20"/>
          <p:cNvSpPr txBox="1"/>
          <p:nvPr/>
        </p:nvSpPr>
        <p:spPr>
          <a:xfrm>
            <a:off x="4495800" y="4229100"/>
            <a:ext cx="6691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 err="1" smtClean="0">
                <a:latin typeface="Arial"/>
                <a:cs typeface="Arial"/>
              </a:rPr>
              <a:t>Curinga</a:t>
            </a:r>
            <a:endParaRPr kumimoji="1" lang="ja-JP" altLang="en-US" sz="1000" b="1" dirty="0">
              <a:latin typeface="Arial"/>
              <a:cs typeface="Arial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6154002" y="4229100"/>
            <a:ext cx="7475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 smtClean="0">
                <a:latin typeface="Arial"/>
                <a:cs typeface="Arial"/>
              </a:rPr>
              <a:t>NERICA4</a:t>
            </a:r>
            <a:endParaRPr kumimoji="1" lang="ja-JP" altLang="en-US" sz="1000" b="1" dirty="0">
              <a:latin typeface="Arial"/>
              <a:cs typeface="Arial"/>
            </a:endParaRPr>
          </a:p>
        </p:txBody>
      </p:sp>
      <p:sp>
        <p:nvSpPr>
          <p:cNvPr id="23" name="Rectangle 3"/>
          <p:cNvSpPr/>
          <p:nvPr/>
        </p:nvSpPr>
        <p:spPr>
          <a:xfrm>
            <a:off x="1177495" y="5260698"/>
            <a:ext cx="9729232" cy="10438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4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Figure </a:t>
            </a:r>
            <a:r>
              <a:rPr lang="en-US" sz="1400" b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S5.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4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Pearson’s correlation coefficient between accumulation level of galactinol and mRNA level of </a:t>
            </a:r>
            <a:r>
              <a:rPr lang="en-US" sz="1400" i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AtGolS2</a:t>
            </a:r>
            <a:r>
              <a:rPr lang="en-US" sz="14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, single plant yield (SPY), and grain yield (GY) in </a:t>
            </a:r>
            <a:r>
              <a:rPr lang="en-US" sz="1400" dirty="0" err="1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Curinga</a:t>
            </a:r>
            <a:r>
              <a:rPr lang="en-US" sz="14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 and NERICA4 evaluated under field. Accumulation level of galactinol and mRNA level of </a:t>
            </a:r>
            <a:r>
              <a:rPr lang="en-US" sz="1400" i="1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AtGolS2</a:t>
            </a:r>
            <a:r>
              <a:rPr lang="en-US" sz="1400" dirty="0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 were indicated in Fig. 1. Single plant yield and grain yield were indicated in Figs. 5 and 6.</a:t>
            </a:r>
            <a:endParaRPr lang="en-US" sz="14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947187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70</TotalTime>
  <Words>667</Words>
  <Application>Microsoft Office PowerPoint</Application>
  <PresentationFormat>Widescreen</PresentationFormat>
  <Paragraphs>133</Paragraphs>
  <Slides>5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2" baseType="lpstr">
      <vt:lpstr>MS Mincho</vt:lpstr>
      <vt:lpstr>ＭＳ Ｐゴシック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cia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alencia Ortiz, Milton Orlando (CIAT)</dc:creator>
  <cp:lastModifiedBy>Selvaraj, Michael (CIAT)</cp:lastModifiedBy>
  <cp:revision>171</cp:revision>
  <cp:lastPrinted>2016-06-17T15:42:23Z</cp:lastPrinted>
  <dcterms:created xsi:type="dcterms:W3CDTF">2016-05-12T20:36:34Z</dcterms:created>
  <dcterms:modified xsi:type="dcterms:W3CDTF">2017-02-09T15:26:37Z</dcterms:modified>
</cp:coreProperties>
</file>